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DDFF"/>
    <a:srgbClr val="4FE6FF"/>
    <a:srgbClr val="003A5D"/>
    <a:srgbClr val="00BF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3"/>
    <p:restoredTop sz="94654"/>
  </p:normalViewPr>
  <p:slideViewPr>
    <p:cSldViewPr snapToGrid="0" snapToObjects="1">
      <p:cViewPr varScale="1">
        <p:scale>
          <a:sx n="78" d="100"/>
          <a:sy n="78" d="100"/>
        </p:scale>
        <p:origin x="58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 showGuides="1">
      <p:cViewPr varScale="1">
        <p:scale>
          <a:sx n="62" d="100"/>
          <a:sy n="62" d="100"/>
        </p:scale>
        <p:origin x="3154" y="7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88FD3E-1513-4922-836E-69C1F2565848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5979F9-6F6C-4B1C-8474-9809D7DAE2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6379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5979F9-6F6C-4B1C-8474-9809D7DAE21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4548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56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486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223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102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977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029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83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792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11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508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805A4-B662-294F-9DA1-5D9B91FD62B8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617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805A4-B662-294F-9DA1-5D9B91FD62B8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40AD1-A2B4-CE4D-9BE1-A480AB0049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519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6AB67B-F644-49E3-B9C9-2951F830C7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4581" y="0"/>
            <a:ext cx="11642838" cy="1137055"/>
          </a:xfrm>
        </p:spPr>
        <p:txBody>
          <a:bodyPr>
            <a:normAutofit/>
          </a:bodyPr>
          <a:lstStyle/>
          <a:p>
            <a:pPr algn="ctr"/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3D Immersive Virtual Reality-Based Clip Sizing for Thoracoscopic</a:t>
            </a:r>
            <a:b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Left Atrial Appendage Closure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54CF4FF-198F-4038-A94A-73E2DD96E73F}"/>
              </a:ext>
            </a:extLst>
          </p:cNvPr>
          <p:cNvGrpSpPr/>
          <p:nvPr/>
        </p:nvGrpSpPr>
        <p:grpSpPr>
          <a:xfrm>
            <a:off x="274581" y="1137055"/>
            <a:ext cx="11642838" cy="4453641"/>
            <a:chOff x="274581" y="1137055"/>
            <a:chExt cx="11642838" cy="4453641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A66F968-4A60-40CC-ABF8-1715250DD3A4}"/>
                </a:ext>
              </a:extLst>
            </p:cNvPr>
            <p:cNvSpPr/>
            <p:nvPr/>
          </p:nvSpPr>
          <p:spPr>
            <a:xfrm>
              <a:off x="274581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UDY POPULATION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tients had thoracoscopic ablation with clipping of the </a:t>
              </a:r>
              <a:b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eft atrial appendage (</a:t>
              </a:r>
              <a:r>
                <a:rPr lang="en-US" sz="20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15)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C2BD41FA-277E-48C9-A86D-24E908BEAB43}"/>
                </a:ext>
              </a:extLst>
            </p:cNvPr>
            <p:cNvSpPr/>
            <p:nvPr/>
          </p:nvSpPr>
          <p:spPr>
            <a:xfrm>
              <a:off x="4155527" y="1137055"/>
              <a:ext cx="3880946" cy="4453641"/>
            </a:xfrm>
            <a:prstGeom prst="rect">
              <a:avLst/>
            </a:prstGeom>
            <a:solidFill>
              <a:srgbClr val="11DD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TERVENTION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mmersive virtual reality measurement of the base of</a:t>
              </a: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he left atrial appendage</a:t>
              </a:r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2BDD0B3E-97C4-4961-85FC-17F984B231B4}"/>
                </a:ext>
              </a:extLst>
            </p:cNvPr>
            <p:cNvSpPr/>
            <p:nvPr/>
          </p:nvSpPr>
          <p:spPr>
            <a:xfrm>
              <a:off x="8036473" y="1137055"/>
              <a:ext cx="3880946" cy="4453641"/>
            </a:xfrm>
            <a:prstGeom prst="rect">
              <a:avLst/>
            </a:prstGeom>
            <a:solidFill>
              <a:srgbClr val="00BFD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pPr algn="ctr"/>
              <a:endPara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UTCOME</a:t>
              </a: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irtual reality measurement of left atrial appendage might prevent oversizing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F1067D66-3B18-4C13-BE99-9FADBCAC927E}"/>
              </a:ext>
            </a:extLst>
          </p:cNvPr>
          <p:cNvGrpSpPr/>
          <p:nvPr/>
        </p:nvGrpSpPr>
        <p:grpSpPr>
          <a:xfrm>
            <a:off x="274581" y="5590696"/>
            <a:ext cx="11642838" cy="1267304"/>
            <a:chOff x="274581" y="5590696"/>
            <a:chExt cx="11642838" cy="1267304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5C1BC0D-3D40-4F7D-9935-BB8BC885EA74}"/>
                </a:ext>
              </a:extLst>
            </p:cNvPr>
            <p:cNvSpPr txBox="1"/>
            <p:nvPr/>
          </p:nvSpPr>
          <p:spPr>
            <a:xfrm>
              <a:off x="3204022" y="6627168"/>
              <a:ext cx="57775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@Innovationsjour | Copyright © The Author(s) 2022. All rights reserved. Published by SAGE Publishing Inc.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0300ED5C-CD19-4926-A571-D5CC9C00EE6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581" y="5590696"/>
              <a:ext cx="11642838" cy="1036472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A0A69DF-628C-48B0-9981-44EBE0D1E2AA}"/>
                </a:ext>
              </a:extLst>
            </p:cNvPr>
            <p:cNvSpPr txBox="1"/>
            <p:nvPr/>
          </p:nvSpPr>
          <p:spPr>
            <a:xfrm>
              <a:off x="4026773" y="6280919"/>
              <a:ext cx="4781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an </a:t>
              </a:r>
              <a:r>
                <a:rPr lang="en-US" sz="14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haagen</a:t>
              </a:r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et al. </a:t>
              </a:r>
              <a:r>
                <a:rPr lang="en-US" sz="14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novations</a:t>
              </a:r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 July/August 2022.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06C9F66C-4E31-E627-9EE2-5EA349226987}"/>
              </a:ext>
            </a:extLst>
          </p:cNvPr>
          <p:cNvGrpSpPr/>
          <p:nvPr/>
        </p:nvGrpSpPr>
        <p:grpSpPr>
          <a:xfrm>
            <a:off x="965474" y="2278891"/>
            <a:ext cx="2499160" cy="2036790"/>
            <a:chOff x="806465" y="1904713"/>
            <a:chExt cx="2636366" cy="2272387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28AD9E24-FF40-5E58-C70E-BA363D4AB672}"/>
                </a:ext>
              </a:extLst>
            </p:cNvPr>
            <p:cNvGrpSpPr/>
            <p:nvPr/>
          </p:nvGrpSpPr>
          <p:grpSpPr>
            <a:xfrm>
              <a:off x="806465" y="1904713"/>
              <a:ext cx="2636366" cy="2272387"/>
              <a:chOff x="1772348" y="1430461"/>
              <a:chExt cx="3096768" cy="2669226"/>
            </a:xfrm>
          </p:grpSpPr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BC659621-362E-297B-68E1-94121895F0BB}"/>
                  </a:ext>
                </a:extLst>
              </p:cNvPr>
              <p:cNvGrpSpPr/>
              <p:nvPr/>
            </p:nvGrpSpPr>
            <p:grpSpPr>
              <a:xfrm>
                <a:off x="1772348" y="1430461"/>
                <a:ext cx="3096768" cy="2669226"/>
                <a:chOff x="1772348" y="1430461"/>
                <a:chExt cx="3096768" cy="2669226"/>
              </a:xfrm>
            </p:grpSpPr>
            <p:sp>
              <p:nvSpPr>
                <p:cNvPr id="22" name="Freeform 63">
                  <a:extLst>
                    <a:ext uri="{FF2B5EF4-FFF2-40B4-BE49-F238E27FC236}">
                      <a16:creationId xmlns:a16="http://schemas.microsoft.com/office/drawing/2014/main" id="{11523118-8984-D21C-798A-85E6B07B10D7}"/>
                    </a:ext>
                  </a:extLst>
                </p:cNvPr>
                <p:cNvSpPr/>
                <p:nvPr/>
              </p:nvSpPr>
              <p:spPr>
                <a:xfrm>
                  <a:off x="2893082" y="1759703"/>
                  <a:ext cx="814433" cy="1177706"/>
                </a:xfrm>
                <a:custGeom>
                  <a:avLst/>
                  <a:gdLst>
                    <a:gd name="connsiteX0" fmla="*/ 203565 w 589390"/>
                    <a:gd name="connsiteY0" fmla="*/ 11634 h 795604"/>
                    <a:gd name="connsiteX1" fmla="*/ 89696 w 589390"/>
                    <a:gd name="connsiteY1" fmla="*/ 80645 h 795604"/>
                    <a:gd name="connsiteX2" fmla="*/ 20685 w 589390"/>
                    <a:gd name="connsiteY2" fmla="*/ 149656 h 795604"/>
                    <a:gd name="connsiteX3" fmla="*/ 13783 w 589390"/>
                    <a:gd name="connsiteY3" fmla="*/ 225569 h 795604"/>
                    <a:gd name="connsiteX4" fmla="*/ 3432 w 589390"/>
                    <a:gd name="connsiteY4" fmla="*/ 380844 h 795604"/>
                    <a:gd name="connsiteX5" fmla="*/ 79344 w 589390"/>
                    <a:gd name="connsiteY5" fmla="*/ 456757 h 795604"/>
                    <a:gd name="connsiteX6" fmla="*/ 224268 w 589390"/>
                    <a:gd name="connsiteY6" fmla="*/ 460207 h 795604"/>
                    <a:gd name="connsiteX7" fmla="*/ 279477 w 589390"/>
                    <a:gd name="connsiteY7" fmla="*/ 422251 h 795604"/>
                    <a:gd name="connsiteX8" fmla="*/ 289829 w 589390"/>
                    <a:gd name="connsiteY8" fmla="*/ 353240 h 795604"/>
                    <a:gd name="connsiteX9" fmla="*/ 131103 w 589390"/>
                    <a:gd name="connsiteY9" fmla="*/ 367042 h 795604"/>
                    <a:gd name="connsiteX10" fmla="*/ 158707 w 589390"/>
                    <a:gd name="connsiteY10" fmla="*/ 187612 h 795604"/>
                    <a:gd name="connsiteX11" fmla="*/ 127652 w 589390"/>
                    <a:gd name="connsiteY11" fmla="*/ 284228 h 795604"/>
                    <a:gd name="connsiteX12" fmla="*/ 138004 w 589390"/>
                    <a:gd name="connsiteY12" fmla="*/ 373943 h 795604"/>
                    <a:gd name="connsiteX13" fmla="*/ 241521 w 589390"/>
                    <a:gd name="connsiteY13" fmla="*/ 356690 h 795604"/>
                    <a:gd name="connsiteX14" fmla="*/ 296730 w 589390"/>
                    <a:gd name="connsiteY14" fmla="*/ 353240 h 795604"/>
                    <a:gd name="connsiteX15" fmla="*/ 296730 w 589390"/>
                    <a:gd name="connsiteY15" fmla="*/ 384295 h 795604"/>
                    <a:gd name="connsiteX16" fmla="*/ 279477 w 589390"/>
                    <a:gd name="connsiteY16" fmla="*/ 418800 h 795604"/>
                    <a:gd name="connsiteX17" fmla="*/ 238070 w 589390"/>
                    <a:gd name="connsiteY17" fmla="*/ 460207 h 795604"/>
                    <a:gd name="connsiteX18" fmla="*/ 138004 w 589390"/>
                    <a:gd name="connsiteY18" fmla="*/ 463658 h 795604"/>
                    <a:gd name="connsiteX19" fmla="*/ 127652 w 589390"/>
                    <a:gd name="connsiteY19" fmla="*/ 501614 h 795604"/>
                    <a:gd name="connsiteX20" fmla="*/ 117300 w 589390"/>
                    <a:gd name="connsiteY20" fmla="*/ 777659 h 795604"/>
                    <a:gd name="connsiteX21" fmla="*/ 458906 w 589390"/>
                    <a:gd name="connsiteY21" fmla="*/ 743154 h 795604"/>
                    <a:gd name="connsiteX22" fmla="*/ 472709 w 589390"/>
                    <a:gd name="connsiteY22" fmla="*/ 536120 h 795604"/>
                    <a:gd name="connsiteX23" fmla="*/ 427851 w 589390"/>
                    <a:gd name="connsiteY23" fmla="*/ 391196 h 795604"/>
                    <a:gd name="connsiteX24" fmla="*/ 420950 w 589390"/>
                    <a:gd name="connsiteY24" fmla="*/ 208316 h 795604"/>
                    <a:gd name="connsiteX25" fmla="*/ 420950 w 589390"/>
                    <a:gd name="connsiteY25" fmla="*/ 149656 h 795604"/>
                    <a:gd name="connsiteX26" fmla="*/ 414049 w 589390"/>
                    <a:gd name="connsiteY26" fmla="*/ 284228 h 795604"/>
                    <a:gd name="connsiteX27" fmla="*/ 424401 w 589390"/>
                    <a:gd name="connsiteY27" fmla="*/ 329086 h 795604"/>
                    <a:gd name="connsiteX28" fmla="*/ 458906 w 589390"/>
                    <a:gd name="connsiteY28" fmla="*/ 367042 h 795604"/>
                    <a:gd name="connsiteX29" fmla="*/ 445104 w 589390"/>
                    <a:gd name="connsiteY29" fmla="*/ 363591 h 795604"/>
                    <a:gd name="connsiteX30" fmla="*/ 448555 w 589390"/>
                    <a:gd name="connsiteY30" fmla="*/ 429152 h 795604"/>
                    <a:gd name="connsiteX31" fmla="*/ 434753 w 589390"/>
                    <a:gd name="connsiteY31" fmla="*/ 470559 h 795604"/>
                    <a:gd name="connsiteX32" fmla="*/ 572775 w 589390"/>
                    <a:gd name="connsiteY32" fmla="*/ 494713 h 795604"/>
                    <a:gd name="connsiteX33" fmla="*/ 583127 w 589390"/>
                    <a:gd name="connsiteY33" fmla="*/ 387745 h 795604"/>
                    <a:gd name="connsiteX34" fmla="*/ 538270 w 589390"/>
                    <a:gd name="connsiteY34" fmla="*/ 280778 h 795604"/>
                    <a:gd name="connsiteX35" fmla="*/ 527918 w 589390"/>
                    <a:gd name="connsiteY35" fmla="*/ 139305 h 795604"/>
                    <a:gd name="connsiteX36" fmla="*/ 452005 w 589390"/>
                    <a:gd name="connsiteY36" fmla="*/ 28886 h 795604"/>
                    <a:gd name="connsiteX37" fmla="*/ 379543 w 589390"/>
                    <a:gd name="connsiteY37" fmla="*/ 1282 h 795604"/>
                    <a:gd name="connsiteX38" fmla="*/ 203565 w 589390"/>
                    <a:gd name="connsiteY38" fmla="*/ 11634 h 795604"/>
                    <a:gd name="connsiteX0" fmla="*/ 203565 w 589390"/>
                    <a:gd name="connsiteY0" fmla="*/ 11634 h 795604"/>
                    <a:gd name="connsiteX1" fmla="*/ 89696 w 589390"/>
                    <a:gd name="connsiteY1" fmla="*/ 80645 h 795604"/>
                    <a:gd name="connsiteX2" fmla="*/ 20685 w 589390"/>
                    <a:gd name="connsiteY2" fmla="*/ 149656 h 795604"/>
                    <a:gd name="connsiteX3" fmla="*/ 13783 w 589390"/>
                    <a:gd name="connsiteY3" fmla="*/ 225569 h 795604"/>
                    <a:gd name="connsiteX4" fmla="*/ 3432 w 589390"/>
                    <a:gd name="connsiteY4" fmla="*/ 380844 h 795604"/>
                    <a:gd name="connsiteX5" fmla="*/ 79344 w 589390"/>
                    <a:gd name="connsiteY5" fmla="*/ 456757 h 795604"/>
                    <a:gd name="connsiteX6" fmla="*/ 224268 w 589390"/>
                    <a:gd name="connsiteY6" fmla="*/ 460207 h 795604"/>
                    <a:gd name="connsiteX7" fmla="*/ 279477 w 589390"/>
                    <a:gd name="connsiteY7" fmla="*/ 422251 h 795604"/>
                    <a:gd name="connsiteX8" fmla="*/ 289829 w 589390"/>
                    <a:gd name="connsiteY8" fmla="*/ 353240 h 795604"/>
                    <a:gd name="connsiteX9" fmla="*/ 131103 w 589390"/>
                    <a:gd name="connsiteY9" fmla="*/ 367042 h 795604"/>
                    <a:gd name="connsiteX10" fmla="*/ 158707 w 589390"/>
                    <a:gd name="connsiteY10" fmla="*/ 187612 h 795604"/>
                    <a:gd name="connsiteX11" fmla="*/ 154714 w 589390"/>
                    <a:gd name="connsiteY11" fmla="*/ 186223 h 795604"/>
                    <a:gd name="connsiteX12" fmla="*/ 127652 w 589390"/>
                    <a:gd name="connsiteY12" fmla="*/ 284228 h 795604"/>
                    <a:gd name="connsiteX13" fmla="*/ 138004 w 589390"/>
                    <a:gd name="connsiteY13" fmla="*/ 373943 h 795604"/>
                    <a:gd name="connsiteX14" fmla="*/ 241521 w 589390"/>
                    <a:gd name="connsiteY14" fmla="*/ 356690 h 795604"/>
                    <a:gd name="connsiteX15" fmla="*/ 296730 w 589390"/>
                    <a:gd name="connsiteY15" fmla="*/ 353240 h 795604"/>
                    <a:gd name="connsiteX16" fmla="*/ 296730 w 589390"/>
                    <a:gd name="connsiteY16" fmla="*/ 384295 h 795604"/>
                    <a:gd name="connsiteX17" fmla="*/ 279477 w 589390"/>
                    <a:gd name="connsiteY17" fmla="*/ 418800 h 795604"/>
                    <a:gd name="connsiteX18" fmla="*/ 238070 w 589390"/>
                    <a:gd name="connsiteY18" fmla="*/ 460207 h 795604"/>
                    <a:gd name="connsiteX19" fmla="*/ 138004 w 589390"/>
                    <a:gd name="connsiteY19" fmla="*/ 463658 h 795604"/>
                    <a:gd name="connsiteX20" fmla="*/ 127652 w 589390"/>
                    <a:gd name="connsiteY20" fmla="*/ 501614 h 795604"/>
                    <a:gd name="connsiteX21" fmla="*/ 117300 w 589390"/>
                    <a:gd name="connsiteY21" fmla="*/ 777659 h 795604"/>
                    <a:gd name="connsiteX22" fmla="*/ 458906 w 589390"/>
                    <a:gd name="connsiteY22" fmla="*/ 743154 h 795604"/>
                    <a:gd name="connsiteX23" fmla="*/ 472709 w 589390"/>
                    <a:gd name="connsiteY23" fmla="*/ 536120 h 795604"/>
                    <a:gd name="connsiteX24" fmla="*/ 427851 w 589390"/>
                    <a:gd name="connsiteY24" fmla="*/ 391196 h 795604"/>
                    <a:gd name="connsiteX25" fmla="*/ 420950 w 589390"/>
                    <a:gd name="connsiteY25" fmla="*/ 208316 h 795604"/>
                    <a:gd name="connsiteX26" fmla="*/ 420950 w 589390"/>
                    <a:gd name="connsiteY26" fmla="*/ 149656 h 795604"/>
                    <a:gd name="connsiteX27" fmla="*/ 414049 w 589390"/>
                    <a:gd name="connsiteY27" fmla="*/ 284228 h 795604"/>
                    <a:gd name="connsiteX28" fmla="*/ 424401 w 589390"/>
                    <a:gd name="connsiteY28" fmla="*/ 329086 h 795604"/>
                    <a:gd name="connsiteX29" fmla="*/ 458906 w 589390"/>
                    <a:gd name="connsiteY29" fmla="*/ 367042 h 795604"/>
                    <a:gd name="connsiteX30" fmla="*/ 445104 w 589390"/>
                    <a:gd name="connsiteY30" fmla="*/ 363591 h 795604"/>
                    <a:gd name="connsiteX31" fmla="*/ 448555 w 589390"/>
                    <a:gd name="connsiteY31" fmla="*/ 429152 h 795604"/>
                    <a:gd name="connsiteX32" fmla="*/ 434753 w 589390"/>
                    <a:gd name="connsiteY32" fmla="*/ 470559 h 795604"/>
                    <a:gd name="connsiteX33" fmla="*/ 572775 w 589390"/>
                    <a:gd name="connsiteY33" fmla="*/ 494713 h 795604"/>
                    <a:gd name="connsiteX34" fmla="*/ 583127 w 589390"/>
                    <a:gd name="connsiteY34" fmla="*/ 387745 h 795604"/>
                    <a:gd name="connsiteX35" fmla="*/ 538270 w 589390"/>
                    <a:gd name="connsiteY35" fmla="*/ 280778 h 795604"/>
                    <a:gd name="connsiteX36" fmla="*/ 527918 w 589390"/>
                    <a:gd name="connsiteY36" fmla="*/ 139305 h 795604"/>
                    <a:gd name="connsiteX37" fmla="*/ 452005 w 589390"/>
                    <a:gd name="connsiteY37" fmla="*/ 28886 h 795604"/>
                    <a:gd name="connsiteX38" fmla="*/ 379543 w 589390"/>
                    <a:gd name="connsiteY38" fmla="*/ 1282 h 795604"/>
                    <a:gd name="connsiteX39" fmla="*/ 203565 w 589390"/>
                    <a:gd name="connsiteY39" fmla="*/ 11634 h 795604"/>
                    <a:gd name="connsiteX0" fmla="*/ 203565 w 589390"/>
                    <a:gd name="connsiteY0" fmla="*/ 11634 h 795604"/>
                    <a:gd name="connsiteX1" fmla="*/ 89696 w 589390"/>
                    <a:gd name="connsiteY1" fmla="*/ 80645 h 795604"/>
                    <a:gd name="connsiteX2" fmla="*/ 20685 w 589390"/>
                    <a:gd name="connsiteY2" fmla="*/ 149656 h 795604"/>
                    <a:gd name="connsiteX3" fmla="*/ 13783 w 589390"/>
                    <a:gd name="connsiteY3" fmla="*/ 225569 h 795604"/>
                    <a:gd name="connsiteX4" fmla="*/ 3432 w 589390"/>
                    <a:gd name="connsiteY4" fmla="*/ 380844 h 795604"/>
                    <a:gd name="connsiteX5" fmla="*/ 79344 w 589390"/>
                    <a:gd name="connsiteY5" fmla="*/ 456757 h 795604"/>
                    <a:gd name="connsiteX6" fmla="*/ 224268 w 589390"/>
                    <a:gd name="connsiteY6" fmla="*/ 460207 h 795604"/>
                    <a:gd name="connsiteX7" fmla="*/ 279477 w 589390"/>
                    <a:gd name="connsiteY7" fmla="*/ 422251 h 795604"/>
                    <a:gd name="connsiteX8" fmla="*/ 289829 w 589390"/>
                    <a:gd name="connsiteY8" fmla="*/ 353240 h 795604"/>
                    <a:gd name="connsiteX9" fmla="*/ 131103 w 589390"/>
                    <a:gd name="connsiteY9" fmla="*/ 367042 h 795604"/>
                    <a:gd name="connsiteX10" fmla="*/ 158707 w 589390"/>
                    <a:gd name="connsiteY10" fmla="*/ 187612 h 795604"/>
                    <a:gd name="connsiteX11" fmla="*/ 138630 w 589390"/>
                    <a:gd name="connsiteY11" fmla="*/ 218139 h 795604"/>
                    <a:gd name="connsiteX12" fmla="*/ 127652 w 589390"/>
                    <a:gd name="connsiteY12" fmla="*/ 284228 h 795604"/>
                    <a:gd name="connsiteX13" fmla="*/ 138004 w 589390"/>
                    <a:gd name="connsiteY13" fmla="*/ 373943 h 795604"/>
                    <a:gd name="connsiteX14" fmla="*/ 241521 w 589390"/>
                    <a:gd name="connsiteY14" fmla="*/ 356690 h 795604"/>
                    <a:gd name="connsiteX15" fmla="*/ 296730 w 589390"/>
                    <a:gd name="connsiteY15" fmla="*/ 353240 h 795604"/>
                    <a:gd name="connsiteX16" fmla="*/ 296730 w 589390"/>
                    <a:gd name="connsiteY16" fmla="*/ 384295 h 795604"/>
                    <a:gd name="connsiteX17" fmla="*/ 279477 w 589390"/>
                    <a:gd name="connsiteY17" fmla="*/ 418800 h 795604"/>
                    <a:gd name="connsiteX18" fmla="*/ 238070 w 589390"/>
                    <a:gd name="connsiteY18" fmla="*/ 460207 h 795604"/>
                    <a:gd name="connsiteX19" fmla="*/ 138004 w 589390"/>
                    <a:gd name="connsiteY19" fmla="*/ 463658 h 795604"/>
                    <a:gd name="connsiteX20" fmla="*/ 127652 w 589390"/>
                    <a:gd name="connsiteY20" fmla="*/ 501614 h 795604"/>
                    <a:gd name="connsiteX21" fmla="*/ 117300 w 589390"/>
                    <a:gd name="connsiteY21" fmla="*/ 777659 h 795604"/>
                    <a:gd name="connsiteX22" fmla="*/ 458906 w 589390"/>
                    <a:gd name="connsiteY22" fmla="*/ 743154 h 795604"/>
                    <a:gd name="connsiteX23" fmla="*/ 472709 w 589390"/>
                    <a:gd name="connsiteY23" fmla="*/ 536120 h 795604"/>
                    <a:gd name="connsiteX24" fmla="*/ 427851 w 589390"/>
                    <a:gd name="connsiteY24" fmla="*/ 391196 h 795604"/>
                    <a:gd name="connsiteX25" fmla="*/ 420950 w 589390"/>
                    <a:gd name="connsiteY25" fmla="*/ 208316 h 795604"/>
                    <a:gd name="connsiteX26" fmla="*/ 420950 w 589390"/>
                    <a:gd name="connsiteY26" fmla="*/ 149656 h 795604"/>
                    <a:gd name="connsiteX27" fmla="*/ 414049 w 589390"/>
                    <a:gd name="connsiteY27" fmla="*/ 284228 h 795604"/>
                    <a:gd name="connsiteX28" fmla="*/ 424401 w 589390"/>
                    <a:gd name="connsiteY28" fmla="*/ 329086 h 795604"/>
                    <a:gd name="connsiteX29" fmla="*/ 458906 w 589390"/>
                    <a:gd name="connsiteY29" fmla="*/ 367042 h 795604"/>
                    <a:gd name="connsiteX30" fmla="*/ 445104 w 589390"/>
                    <a:gd name="connsiteY30" fmla="*/ 363591 h 795604"/>
                    <a:gd name="connsiteX31" fmla="*/ 448555 w 589390"/>
                    <a:gd name="connsiteY31" fmla="*/ 429152 h 795604"/>
                    <a:gd name="connsiteX32" fmla="*/ 434753 w 589390"/>
                    <a:gd name="connsiteY32" fmla="*/ 470559 h 795604"/>
                    <a:gd name="connsiteX33" fmla="*/ 572775 w 589390"/>
                    <a:gd name="connsiteY33" fmla="*/ 494713 h 795604"/>
                    <a:gd name="connsiteX34" fmla="*/ 583127 w 589390"/>
                    <a:gd name="connsiteY34" fmla="*/ 387745 h 795604"/>
                    <a:gd name="connsiteX35" fmla="*/ 538270 w 589390"/>
                    <a:gd name="connsiteY35" fmla="*/ 280778 h 795604"/>
                    <a:gd name="connsiteX36" fmla="*/ 527918 w 589390"/>
                    <a:gd name="connsiteY36" fmla="*/ 139305 h 795604"/>
                    <a:gd name="connsiteX37" fmla="*/ 452005 w 589390"/>
                    <a:gd name="connsiteY37" fmla="*/ 28886 h 795604"/>
                    <a:gd name="connsiteX38" fmla="*/ 379543 w 589390"/>
                    <a:gd name="connsiteY38" fmla="*/ 1282 h 795604"/>
                    <a:gd name="connsiteX39" fmla="*/ 203565 w 589390"/>
                    <a:gd name="connsiteY39" fmla="*/ 11634 h 795604"/>
                    <a:gd name="connsiteX0" fmla="*/ 203565 w 589390"/>
                    <a:gd name="connsiteY0" fmla="*/ 11634 h 795604"/>
                    <a:gd name="connsiteX1" fmla="*/ 89696 w 589390"/>
                    <a:gd name="connsiteY1" fmla="*/ 80645 h 795604"/>
                    <a:gd name="connsiteX2" fmla="*/ 20685 w 589390"/>
                    <a:gd name="connsiteY2" fmla="*/ 149656 h 795604"/>
                    <a:gd name="connsiteX3" fmla="*/ 13783 w 589390"/>
                    <a:gd name="connsiteY3" fmla="*/ 225569 h 795604"/>
                    <a:gd name="connsiteX4" fmla="*/ 3432 w 589390"/>
                    <a:gd name="connsiteY4" fmla="*/ 380844 h 795604"/>
                    <a:gd name="connsiteX5" fmla="*/ 79344 w 589390"/>
                    <a:gd name="connsiteY5" fmla="*/ 456757 h 795604"/>
                    <a:gd name="connsiteX6" fmla="*/ 224268 w 589390"/>
                    <a:gd name="connsiteY6" fmla="*/ 460207 h 795604"/>
                    <a:gd name="connsiteX7" fmla="*/ 279477 w 589390"/>
                    <a:gd name="connsiteY7" fmla="*/ 422251 h 795604"/>
                    <a:gd name="connsiteX8" fmla="*/ 289829 w 589390"/>
                    <a:gd name="connsiteY8" fmla="*/ 353240 h 795604"/>
                    <a:gd name="connsiteX9" fmla="*/ 131103 w 589390"/>
                    <a:gd name="connsiteY9" fmla="*/ 367042 h 795604"/>
                    <a:gd name="connsiteX10" fmla="*/ 158707 w 589390"/>
                    <a:gd name="connsiteY10" fmla="*/ 181229 h 795604"/>
                    <a:gd name="connsiteX11" fmla="*/ 138630 w 589390"/>
                    <a:gd name="connsiteY11" fmla="*/ 218139 h 795604"/>
                    <a:gd name="connsiteX12" fmla="*/ 127652 w 589390"/>
                    <a:gd name="connsiteY12" fmla="*/ 284228 h 795604"/>
                    <a:gd name="connsiteX13" fmla="*/ 138004 w 589390"/>
                    <a:gd name="connsiteY13" fmla="*/ 373943 h 795604"/>
                    <a:gd name="connsiteX14" fmla="*/ 241521 w 589390"/>
                    <a:gd name="connsiteY14" fmla="*/ 356690 h 795604"/>
                    <a:gd name="connsiteX15" fmla="*/ 296730 w 589390"/>
                    <a:gd name="connsiteY15" fmla="*/ 353240 h 795604"/>
                    <a:gd name="connsiteX16" fmla="*/ 296730 w 589390"/>
                    <a:gd name="connsiteY16" fmla="*/ 384295 h 795604"/>
                    <a:gd name="connsiteX17" fmla="*/ 279477 w 589390"/>
                    <a:gd name="connsiteY17" fmla="*/ 418800 h 795604"/>
                    <a:gd name="connsiteX18" fmla="*/ 238070 w 589390"/>
                    <a:gd name="connsiteY18" fmla="*/ 460207 h 795604"/>
                    <a:gd name="connsiteX19" fmla="*/ 138004 w 589390"/>
                    <a:gd name="connsiteY19" fmla="*/ 463658 h 795604"/>
                    <a:gd name="connsiteX20" fmla="*/ 127652 w 589390"/>
                    <a:gd name="connsiteY20" fmla="*/ 501614 h 795604"/>
                    <a:gd name="connsiteX21" fmla="*/ 117300 w 589390"/>
                    <a:gd name="connsiteY21" fmla="*/ 777659 h 795604"/>
                    <a:gd name="connsiteX22" fmla="*/ 458906 w 589390"/>
                    <a:gd name="connsiteY22" fmla="*/ 743154 h 795604"/>
                    <a:gd name="connsiteX23" fmla="*/ 472709 w 589390"/>
                    <a:gd name="connsiteY23" fmla="*/ 536120 h 795604"/>
                    <a:gd name="connsiteX24" fmla="*/ 427851 w 589390"/>
                    <a:gd name="connsiteY24" fmla="*/ 391196 h 795604"/>
                    <a:gd name="connsiteX25" fmla="*/ 420950 w 589390"/>
                    <a:gd name="connsiteY25" fmla="*/ 208316 h 795604"/>
                    <a:gd name="connsiteX26" fmla="*/ 420950 w 589390"/>
                    <a:gd name="connsiteY26" fmla="*/ 149656 h 795604"/>
                    <a:gd name="connsiteX27" fmla="*/ 414049 w 589390"/>
                    <a:gd name="connsiteY27" fmla="*/ 284228 h 795604"/>
                    <a:gd name="connsiteX28" fmla="*/ 424401 w 589390"/>
                    <a:gd name="connsiteY28" fmla="*/ 329086 h 795604"/>
                    <a:gd name="connsiteX29" fmla="*/ 458906 w 589390"/>
                    <a:gd name="connsiteY29" fmla="*/ 367042 h 795604"/>
                    <a:gd name="connsiteX30" fmla="*/ 445104 w 589390"/>
                    <a:gd name="connsiteY30" fmla="*/ 363591 h 795604"/>
                    <a:gd name="connsiteX31" fmla="*/ 448555 w 589390"/>
                    <a:gd name="connsiteY31" fmla="*/ 429152 h 795604"/>
                    <a:gd name="connsiteX32" fmla="*/ 434753 w 589390"/>
                    <a:gd name="connsiteY32" fmla="*/ 470559 h 795604"/>
                    <a:gd name="connsiteX33" fmla="*/ 572775 w 589390"/>
                    <a:gd name="connsiteY33" fmla="*/ 494713 h 795604"/>
                    <a:gd name="connsiteX34" fmla="*/ 583127 w 589390"/>
                    <a:gd name="connsiteY34" fmla="*/ 387745 h 795604"/>
                    <a:gd name="connsiteX35" fmla="*/ 538270 w 589390"/>
                    <a:gd name="connsiteY35" fmla="*/ 280778 h 795604"/>
                    <a:gd name="connsiteX36" fmla="*/ 527918 w 589390"/>
                    <a:gd name="connsiteY36" fmla="*/ 139305 h 795604"/>
                    <a:gd name="connsiteX37" fmla="*/ 452005 w 589390"/>
                    <a:gd name="connsiteY37" fmla="*/ 28886 h 795604"/>
                    <a:gd name="connsiteX38" fmla="*/ 379543 w 589390"/>
                    <a:gd name="connsiteY38" fmla="*/ 1282 h 795604"/>
                    <a:gd name="connsiteX39" fmla="*/ 203565 w 589390"/>
                    <a:gd name="connsiteY39" fmla="*/ 11634 h 795604"/>
                    <a:gd name="connsiteX0" fmla="*/ 203565 w 589390"/>
                    <a:gd name="connsiteY0" fmla="*/ 11634 h 795604"/>
                    <a:gd name="connsiteX1" fmla="*/ 89696 w 589390"/>
                    <a:gd name="connsiteY1" fmla="*/ 80645 h 795604"/>
                    <a:gd name="connsiteX2" fmla="*/ 20685 w 589390"/>
                    <a:gd name="connsiteY2" fmla="*/ 149656 h 795604"/>
                    <a:gd name="connsiteX3" fmla="*/ 13783 w 589390"/>
                    <a:gd name="connsiteY3" fmla="*/ 225569 h 795604"/>
                    <a:gd name="connsiteX4" fmla="*/ 3432 w 589390"/>
                    <a:gd name="connsiteY4" fmla="*/ 380844 h 795604"/>
                    <a:gd name="connsiteX5" fmla="*/ 79344 w 589390"/>
                    <a:gd name="connsiteY5" fmla="*/ 456757 h 795604"/>
                    <a:gd name="connsiteX6" fmla="*/ 224268 w 589390"/>
                    <a:gd name="connsiteY6" fmla="*/ 460207 h 795604"/>
                    <a:gd name="connsiteX7" fmla="*/ 279477 w 589390"/>
                    <a:gd name="connsiteY7" fmla="*/ 422251 h 795604"/>
                    <a:gd name="connsiteX8" fmla="*/ 289829 w 589390"/>
                    <a:gd name="connsiteY8" fmla="*/ 353240 h 795604"/>
                    <a:gd name="connsiteX9" fmla="*/ 131103 w 589390"/>
                    <a:gd name="connsiteY9" fmla="*/ 367042 h 795604"/>
                    <a:gd name="connsiteX10" fmla="*/ 158707 w 589390"/>
                    <a:gd name="connsiteY10" fmla="*/ 181229 h 795604"/>
                    <a:gd name="connsiteX11" fmla="*/ 159310 w 589390"/>
                    <a:gd name="connsiteY11" fmla="*/ 177713 h 795604"/>
                    <a:gd name="connsiteX12" fmla="*/ 138630 w 589390"/>
                    <a:gd name="connsiteY12" fmla="*/ 218139 h 795604"/>
                    <a:gd name="connsiteX13" fmla="*/ 127652 w 589390"/>
                    <a:gd name="connsiteY13" fmla="*/ 284228 h 795604"/>
                    <a:gd name="connsiteX14" fmla="*/ 138004 w 589390"/>
                    <a:gd name="connsiteY14" fmla="*/ 373943 h 795604"/>
                    <a:gd name="connsiteX15" fmla="*/ 241521 w 589390"/>
                    <a:gd name="connsiteY15" fmla="*/ 356690 h 795604"/>
                    <a:gd name="connsiteX16" fmla="*/ 296730 w 589390"/>
                    <a:gd name="connsiteY16" fmla="*/ 353240 h 795604"/>
                    <a:gd name="connsiteX17" fmla="*/ 296730 w 589390"/>
                    <a:gd name="connsiteY17" fmla="*/ 384295 h 795604"/>
                    <a:gd name="connsiteX18" fmla="*/ 279477 w 589390"/>
                    <a:gd name="connsiteY18" fmla="*/ 418800 h 795604"/>
                    <a:gd name="connsiteX19" fmla="*/ 238070 w 589390"/>
                    <a:gd name="connsiteY19" fmla="*/ 460207 h 795604"/>
                    <a:gd name="connsiteX20" fmla="*/ 138004 w 589390"/>
                    <a:gd name="connsiteY20" fmla="*/ 463658 h 795604"/>
                    <a:gd name="connsiteX21" fmla="*/ 127652 w 589390"/>
                    <a:gd name="connsiteY21" fmla="*/ 501614 h 795604"/>
                    <a:gd name="connsiteX22" fmla="*/ 117300 w 589390"/>
                    <a:gd name="connsiteY22" fmla="*/ 777659 h 795604"/>
                    <a:gd name="connsiteX23" fmla="*/ 458906 w 589390"/>
                    <a:gd name="connsiteY23" fmla="*/ 743154 h 795604"/>
                    <a:gd name="connsiteX24" fmla="*/ 472709 w 589390"/>
                    <a:gd name="connsiteY24" fmla="*/ 536120 h 795604"/>
                    <a:gd name="connsiteX25" fmla="*/ 427851 w 589390"/>
                    <a:gd name="connsiteY25" fmla="*/ 391196 h 795604"/>
                    <a:gd name="connsiteX26" fmla="*/ 420950 w 589390"/>
                    <a:gd name="connsiteY26" fmla="*/ 208316 h 795604"/>
                    <a:gd name="connsiteX27" fmla="*/ 420950 w 589390"/>
                    <a:gd name="connsiteY27" fmla="*/ 149656 h 795604"/>
                    <a:gd name="connsiteX28" fmla="*/ 414049 w 589390"/>
                    <a:gd name="connsiteY28" fmla="*/ 284228 h 795604"/>
                    <a:gd name="connsiteX29" fmla="*/ 424401 w 589390"/>
                    <a:gd name="connsiteY29" fmla="*/ 329086 h 795604"/>
                    <a:gd name="connsiteX30" fmla="*/ 458906 w 589390"/>
                    <a:gd name="connsiteY30" fmla="*/ 367042 h 795604"/>
                    <a:gd name="connsiteX31" fmla="*/ 445104 w 589390"/>
                    <a:gd name="connsiteY31" fmla="*/ 363591 h 795604"/>
                    <a:gd name="connsiteX32" fmla="*/ 448555 w 589390"/>
                    <a:gd name="connsiteY32" fmla="*/ 429152 h 795604"/>
                    <a:gd name="connsiteX33" fmla="*/ 434753 w 589390"/>
                    <a:gd name="connsiteY33" fmla="*/ 470559 h 795604"/>
                    <a:gd name="connsiteX34" fmla="*/ 572775 w 589390"/>
                    <a:gd name="connsiteY34" fmla="*/ 494713 h 795604"/>
                    <a:gd name="connsiteX35" fmla="*/ 583127 w 589390"/>
                    <a:gd name="connsiteY35" fmla="*/ 387745 h 795604"/>
                    <a:gd name="connsiteX36" fmla="*/ 538270 w 589390"/>
                    <a:gd name="connsiteY36" fmla="*/ 280778 h 795604"/>
                    <a:gd name="connsiteX37" fmla="*/ 527918 w 589390"/>
                    <a:gd name="connsiteY37" fmla="*/ 139305 h 795604"/>
                    <a:gd name="connsiteX38" fmla="*/ 452005 w 589390"/>
                    <a:gd name="connsiteY38" fmla="*/ 28886 h 795604"/>
                    <a:gd name="connsiteX39" fmla="*/ 379543 w 589390"/>
                    <a:gd name="connsiteY39" fmla="*/ 1282 h 795604"/>
                    <a:gd name="connsiteX40" fmla="*/ 203565 w 589390"/>
                    <a:gd name="connsiteY40" fmla="*/ 11634 h 795604"/>
                    <a:gd name="connsiteX0" fmla="*/ 203565 w 589390"/>
                    <a:gd name="connsiteY0" fmla="*/ 14094 h 798064"/>
                    <a:gd name="connsiteX1" fmla="*/ 89696 w 589390"/>
                    <a:gd name="connsiteY1" fmla="*/ 83105 h 798064"/>
                    <a:gd name="connsiteX2" fmla="*/ 20685 w 589390"/>
                    <a:gd name="connsiteY2" fmla="*/ 152116 h 798064"/>
                    <a:gd name="connsiteX3" fmla="*/ 13783 w 589390"/>
                    <a:gd name="connsiteY3" fmla="*/ 228029 h 798064"/>
                    <a:gd name="connsiteX4" fmla="*/ 3432 w 589390"/>
                    <a:gd name="connsiteY4" fmla="*/ 383304 h 798064"/>
                    <a:gd name="connsiteX5" fmla="*/ 79344 w 589390"/>
                    <a:gd name="connsiteY5" fmla="*/ 459217 h 798064"/>
                    <a:gd name="connsiteX6" fmla="*/ 224268 w 589390"/>
                    <a:gd name="connsiteY6" fmla="*/ 462667 h 798064"/>
                    <a:gd name="connsiteX7" fmla="*/ 279477 w 589390"/>
                    <a:gd name="connsiteY7" fmla="*/ 424711 h 798064"/>
                    <a:gd name="connsiteX8" fmla="*/ 289829 w 589390"/>
                    <a:gd name="connsiteY8" fmla="*/ 355700 h 798064"/>
                    <a:gd name="connsiteX9" fmla="*/ 131103 w 589390"/>
                    <a:gd name="connsiteY9" fmla="*/ 369502 h 798064"/>
                    <a:gd name="connsiteX10" fmla="*/ 158707 w 589390"/>
                    <a:gd name="connsiteY10" fmla="*/ 183689 h 798064"/>
                    <a:gd name="connsiteX11" fmla="*/ 159310 w 589390"/>
                    <a:gd name="connsiteY11" fmla="*/ 180173 h 798064"/>
                    <a:gd name="connsiteX12" fmla="*/ 138630 w 589390"/>
                    <a:gd name="connsiteY12" fmla="*/ 220599 h 798064"/>
                    <a:gd name="connsiteX13" fmla="*/ 127652 w 589390"/>
                    <a:gd name="connsiteY13" fmla="*/ 286688 h 798064"/>
                    <a:gd name="connsiteX14" fmla="*/ 138004 w 589390"/>
                    <a:gd name="connsiteY14" fmla="*/ 376403 h 798064"/>
                    <a:gd name="connsiteX15" fmla="*/ 241521 w 589390"/>
                    <a:gd name="connsiteY15" fmla="*/ 359150 h 798064"/>
                    <a:gd name="connsiteX16" fmla="*/ 296730 w 589390"/>
                    <a:gd name="connsiteY16" fmla="*/ 355700 h 798064"/>
                    <a:gd name="connsiteX17" fmla="*/ 296730 w 589390"/>
                    <a:gd name="connsiteY17" fmla="*/ 386755 h 798064"/>
                    <a:gd name="connsiteX18" fmla="*/ 279477 w 589390"/>
                    <a:gd name="connsiteY18" fmla="*/ 421260 h 798064"/>
                    <a:gd name="connsiteX19" fmla="*/ 238070 w 589390"/>
                    <a:gd name="connsiteY19" fmla="*/ 462667 h 798064"/>
                    <a:gd name="connsiteX20" fmla="*/ 138004 w 589390"/>
                    <a:gd name="connsiteY20" fmla="*/ 466118 h 798064"/>
                    <a:gd name="connsiteX21" fmla="*/ 127652 w 589390"/>
                    <a:gd name="connsiteY21" fmla="*/ 504074 h 798064"/>
                    <a:gd name="connsiteX22" fmla="*/ 117300 w 589390"/>
                    <a:gd name="connsiteY22" fmla="*/ 780119 h 798064"/>
                    <a:gd name="connsiteX23" fmla="*/ 458906 w 589390"/>
                    <a:gd name="connsiteY23" fmla="*/ 745614 h 798064"/>
                    <a:gd name="connsiteX24" fmla="*/ 472709 w 589390"/>
                    <a:gd name="connsiteY24" fmla="*/ 538580 h 798064"/>
                    <a:gd name="connsiteX25" fmla="*/ 427851 w 589390"/>
                    <a:gd name="connsiteY25" fmla="*/ 393656 h 798064"/>
                    <a:gd name="connsiteX26" fmla="*/ 420950 w 589390"/>
                    <a:gd name="connsiteY26" fmla="*/ 210776 h 798064"/>
                    <a:gd name="connsiteX27" fmla="*/ 420950 w 589390"/>
                    <a:gd name="connsiteY27" fmla="*/ 152116 h 798064"/>
                    <a:gd name="connsiteX28" fmla="*/ 414049 w 589390"/>
                    <a:gd name="connsiteY28" fmla="*/ 286688 h 798064"/>
                    <a:gd name="connsiteX29" fmla="*/ 424401 w 589390"/>
                    <a:gd name="connsiteY29" fmla="*/ 331546 h 798064"/>
                    <a:gd name="connsiteX30" fmla="*/ 458906 w 589390"/>
                    <a:gd name="connsiteY30" fmla="*/ 369502 h 798064"/>
                    <a:gd name="connsiteX31" fmla="*/ 445104 w 589390"/>
                    <a:gd name="connsiteY31" fmla="*/ 366051 h 798064"/>
                    <a:gd name="connsiteX32" fmla="*/ 448555 w 589390"/>
                    <a:gd name="connsiteY32" fmla="*/ 431612 h 798064"/>
                    <a:gd name="connsiteX33" fmla="*/ 434753 w 589390"/>
                    <a:gd name="connsiteY33" fmla="*/ 473019 h 798064"/>
                    <a:gd name="connsiteX34" fmla="*/ 572775 w 589390"/>
                    <a:gd name="connsiteY34" fmla="*/ 497173 h 798064"/>
                    <a:gd name="connsiteX35" fmla="*/ 583127 w 589390"/>
                    <a:gd name="connsiteY35" fmla="*/ 390205 h 798064"/>
                    <a:gd name="connsiteX36" fmla="*/ 538270 w 589390"/>
                    <a:gd name="connsiteY36" fmla="*/ 283238 h 798064"/>
                    <a:gd name="connsiteX37" fmla="*/ 527918 w 589390"/>
                    <a:gd name="connsiteY37" fmla="*/ 141765 h 798064"/>
                    <a:gd name="connsiteX38" fmla="*/ 488768 w 589390"/>
                    <a:gd name="connsiteY38" fmla="*/ 61134 h 798064"/>
                    <a:gd name="connsiteX39" fmla="*/ 379543 w 589390"/>
                    <a:gd name="connsiteY39" fmla="*/ 3742 h 798064"/>
                    <a:gd name="connsiteX40" fmla="*/ 203565 w 589390"/>
                    <a:gd name="connsiteY40" fmla="*/ 14094 h 798064"/>
                    <a:gd name="connsiteX0" fmla="*/ 203565 w 589390"/>
                    <a:gd name="connsiteY0" fmla="*/ 15669 h 799639"/>
                    <a:gd name="connsiteX1" fmla="*/ 89696 w 589390"/>
                    <a:gd name="connsiteY1" fmla="*/ 84680 h 799639"/>
                    <a:gd name="connsiteX2" fmla="*/ 20685 w 589390"/>
                    <a:gd name="connsiteY2" fmla="*/ 153691 h 799639"/>
                    <a:gd name="connsiteX3" fmla="*/ 13783 w 589390"/>
                    <a:gd name="connsiteY3" fmla="*/ 229604 h 799639"/>
                    <a:gd name="connsiteX4" fmla="*/ 3432 w 589390"/>
                    <a:gd name="connsiteY4" fmla="*/ 384879 h 799639"/>
                    <a:gd name="connsiteX5" fmla="*/ 79344 w 589390"/>
                    <a:gd name="connsiteY5" fmla="*/ 460792 h 799639"/>
                    <a:gd name="connsiteX6" fmla="*/ 224268 w 589390"/>
                    <a:gd name="connsiteY6" fmla="*/ 464242 h 799639"/>
                    <a:gd name="connsiteX7" fmla="*/ 279477 w 589390"/>
                    <a:gd name="connsiteY7" fmla="*/ 426286 h 799639"/>
                    <a:gd name="connsiteX8" fmla="*/ 289829 w 589390"/>
                    <a:gd name="connsiteY8" fmla="*/ 357275 h 799639"/>
                    <a:gd name="connsiteX9" fmla="*/ 131103 w 589390"/>
                    <a:gd name="connsiteY9" fmla="*/ 371077 h 799639"/>
                    <a:gd name="connsiteX10" fmla="*/ 158707 w 589390"/>
                    <a:gd name="connsiteY10" fmla="*/ 185264 h 799639"/>
                    <a:gd name="connsiteX11" fmla="*/ 159310 w 589390"/>
                    <a:gd name="connsiteY11" fmla="*/ 181748 h 799639"/>
                    <a:gd name="connsiteX12" fmla="*/ 138630 w 589390"/>
                    <a:gd name="connsiteY12" fmla="*/ 222174 h 799639"/>
                    <a:gd name="connsiteX13" fmla="*/ 127652 w 589390"/>
                    <a:gd name="connsiteY13" fmla="*/ 288263 h 799639"/>
                    <a:gd name="connsiteX14" fmla="*/ 138004 w 589390"/>
                    <a:gd name="connsiteY14" fmla="*/ 377978 h 799639"/>
                    <a:gd name="connsiteX15" fmla="*/ 241521 w 589390"/>
                    <a:gd name="connsiteY15" fmla="*/ 360725 h 799639"/>
                    <a:gd name="connsiteX16" fmla="*/ 296730 w 589390"/>
                    <a:gd name="connsiteY16" fmla="*/ 357275 h 799639"/>
                    <a:gd name="connsiteX17" fmla="*/ 296730 w 589390"/>
                    <a:gd name="connsiteY17" fmla="*/ 388330 h 799639"/>
                    <a:gd name="connsiteX18" fmla="*/ 279477 w 589390"/>
                    <a:gd name="connsiteY18" fmla="*/ 422835 h 799639"/>
                    <a:gd name="connsiteX19" fmla="*/ 238070 w 589390"/>
                    <a:gd name="connsiteY19" fmla="*/ 464242 h 799639"/>
                    <a:gd name="connsiteX20" fmla="*/ 138004 w 589390"/>
                    <a:gd name="connsiteY20" fmla="*/ 467693 h 799639"/>
                    <a:gd name="connsiteX21" fmla="*/ 127652 w 589390"/>
                    <a:gd name="connsiteY21" fmla="*/ 505649 h 799639"/>
                    <a:gd name="connsiteX22" fmla="*/ 117300 w 589390"/>
                    <a:gd name="connsiteY22" fmla="*/ 781694 h 799639"/>
                    <a:gd name="connsiteX23" fmla="*/ 458906 w 589390"/>
                    <a:gd name="connsiteY23" fmla="*/ 747189 h 799639"/>
                    <a:gd name="connsiteX24" fmla="*/ 472709 w 589390"/>
                    <a:gd name="connsiteY24" fmla="*/ 540155 h 799639"/>
                    <a:gd name="connsiteX25" fmla="*/ 427851 w 589390"/>
                    <a:gd name="connsiteY25" fmla="*/ 395231 h 799639"/>
                    <a:gd name="connsiteX26" fmla="*/ 420950 w 589390"/>
                    <a:gd name="connsiteY26" fmla="*/ 212351 h 799639"/>
                    <a:gd name="connsiteX27" fmla="*/ 420950 w 589390"/>
                    <a:gd name="connsiteY27" fmla="*/ 153691 h 799639"/>
                    <a:gd name="connsiteX28" fmla="*/ 414049 w 589390"/>
                    <a:gd name="connsiteY28" fmla="*/ 288263 h 799639"/>
                    <a:gd name="connsiteX29" fmla="*/ 424401 w 589390"/>
                    <a:gd name="connsiteY29" fmla="*/ 333121 h 799639"/>
                    <a:gd name="connsiteX30" fmla="*/ 458906 w 589390"/>
                    <a:gd name="connsiteY30" fmla="*/ 371077 h 799639"/>
                    <a:gd name="connsiteX31" fmla="*/ 445104 w 589390"/>
                    <a:gd name="connsiteY31" fmla="*/ 367626 h 799639"/>
                    <a:gd name="connsiteX32" fmla="*/ 448555 w 589390"/>
                    <a:gd name="connsiteY32" fmla="*/ 433187 h 799639"/>
                    <a:gd name="connsiteX33" fmla="*/ 434753 w 589390"/>
                    <a:gd name="connsiteY33" fmla="*/ 474594 h 799639"/>
                    <a:gd name="connsiteX34" fmla="*/ 572775 w 589390"/>
                    <a:gd name="connsiteY34" fmla="*/ 498748 h 799639"/>
                    <a:gd name="connsiteX35" fmla="*/ 583127 w 589390"/>
                    <a:gd name="connsiteY35" fmla="*/ 391780 h 799639"/>
                    <a:gd name="connsiteX36" fmla="*/ 538270 w 589390"/>
                    <a:gd name="connsiteY36" fmla="*/ 284813 h 799639"/>
                    <a:gd name="connsiteX37" fmla="*/ 527918 w 589390"/>
                    <a:gd name="connsiteY37" fmla="*/ 143340 h 799639"/>
                    <a:gd name="connsiteX38" fmla="*/ 495661 w 589390"/>
                    <a:gd name="connsiteY38" fmla="*/ 83987 h 799639"/>
                    <a:gd name="connsiteX39" fmla="*/ 379543 w 589390"/>
                    <a:gd name="connsiteY39" fmla="*/ 5317 h 799639"/>
                    <a:gd name="connsiteX40" fmla="*/ 203565 w 589390"/>
                    <a:gd name="connsiteY40" fmla="*/ 15669 h 799639"/>
                    <a:gd name="connsiteX0" fmla="*/ 203565 w 589390"/>
                    <a:gd name="connsiteY0" fmla="*/ 6325 h 790295"/>
                    <a:gd name="connsiteX1" fmla="*/ 89696 w 589390"/>
                    <a:gd name="connsiteY1" fmla="*/ 75336 h 790295"/>
                    <a:gd name="connsiteX2" fmla="*/ 20685 w 589390"/>
                    <a:gd name="connsiteY2" fmla="*/ 144347 h 790295"/>
                    <a:gd name="connsiteX3" fmla="*/ 13783 w 589390"/>
                    <a:gd name="connsiteY3" fmla="*/ 220260 h 790295"/>
                    <a:gd name="connsiteX4" fmla="*/ 3432 w 589390"/>
                    <a:gd name="connsiteY4" fmla="*/ 375535 h 790295"/>
                    <a:gd name="connsiteX5" fmla="*/ 79344 w 589390"/>
                    <a:gd name="connsiteY5" fmla="*/ 451448 h 790295"/>
                    <a:gd name="connsiteX6" fmla="*/ 224268 w 589390"/>
                    <a:gd name="connsiteY6" fmla="*/ 454898 h 790295"/>
                    <a:gd name="connsiteX7" fmla="*/ 279477 w 589390"/>
                    <a:gd name="connsiteY7" fmla="*/ 416942 h 790295"/>
                    <a:gd name="connsiteX8" fmla="*/ 289829 w 589390"/>
                    <a:gd name="connsiteY8" fmla="*/ 347931 h 790295"/>
                    <a:gd name="connsiteX9" fmla="*/ 131103 w 589390"/>
                    <a:gd name="connsiteY9" fmla="*/ 361733 h 790295"/>
                    <a:gd name="connsiteX10" fmla="*/ 158707 w 589390"/>
                    <a:gd name="connsiteY10" fmla="*/ 175920 h 790295"/>
                    <a:gd name="connsiteX11" fmla="*/ 159310 w 589390"/>
                    <a:gd name="connsiteY11" fmla="*/ 172404 h 790295"/>
                    <a:gd name="connsiteX12" fmla="*/ 138630 w 589390"/>
                    <a:gd name="connsiteY12" fmla="*/ 212830 h 790295"/>
                    <a:gd name="connsiteX13" fmla="*/ 127652 w 589390"/>
                    <a:gd name="connsiteY13" fmla="*/ 278919 h 790295"/>
                    <a:gd name="connsiteX14" fmla="*/ 138004 w 589390"/>
                    <a:gd name="connsiteY14" fmla="*/ 368634 h 790295"/>
                    <a:gd name="connsiteX15" fmla="*/ 241521 w 589390"/>
                    <a:gd name="connsiteY15" fmla="*/ 351381 h 790295"/>
                    <a:gd name="connsiteX16" fmla="*/ 296730 w 589390"/>
                    <a:gd name="connsiteY16" fmla="*/ 347931 h 790295"/>
                    <a:gd name="connsiteX17" fmla="*/ 296730 w 589390"/>
                    <a:gd name="connsiteY17" fmla="*/ 378986 h 790295"/>
                    <a:gd name="connsiteX18" fmla="*/ 279477 w 589390"/>
                    <a:gd name="connsiteY18" fmla="*/ 413491 h 790295"/>
                    <a:gd name="connsiteX19" fmla="*/ 238070 w 589390"/>
                    <a:gd name="connsiteY19" fmla="*/ 454898 h 790295"/>
                    <a:gd name="connsiteX20" fmla="*/ 138004 w 589390"/>
                    <a:gd name="connsiteY20" fmla="*/ 458349 h 790295"/>
                    <a:gd name="connsiteX21" fmla="*/ 127652 w 589390"/>
                    <a:gd name="connsiteY21" fmla="*/ 496305 h 790295"/>
                    <a:gd name="connsiteX22" fmla="*/ 117300 w 589390"/>
                    <a:gd name="connsiteY22" fmla="*/ 772350 h 790295"/>
                    <a:gd name="connsiteX23" fmla="*/ 458906 w 589390"/>
                    <a:gd name="connsiteY23" fmla="*/ 737845 h 790295"/>
                    <a:gd name="connsiteX24" fmla="*/ 472709 w 589390"/>
                    <a:gd name="connsiteY24" fmla="*/ 530811 h 790295"/>
                    <a:gd name="connsiteX25" fmla="*/ 427851 w 589390"/>
                    <a:gd name="connsiteY25" fmla="*/ 385887 h 790295"/>
                    <a:gd name="connsiteX26" fmla="*/ 420950 w 589390"/>
                    <a:gd name="connsiteY26" fmla="*/ 203007 h 790295"/>
                    <a:gd name="connsiteX27" fmla="*/ 420950 w 589390"/>
                    <a:gd name="connsiteY27" fmla="*/ 144347 h 790295"/>
                    <a:gd name="connsiteX28" fmla="*/ 414049 w 589390"/>
                    <a:gd name="connsiteY28" fmla="*/ 278919 h 790295"/>
                    <a:gd name="connsiteX29" fmla="*/ 424401 w 589390"/>
                    <a:gd name="connsiteY29" fmla="*/ 323777 h 790295"/>
                    <a:gd name="connsiteX30" fmla="*/ 458906 w 589390"/>
                    <a:gd name="connsiteY30" fmla="*/ 361733 h 790295"/>
                    <a:gd name="connsiteX31" fmla="*/ 445104 w 589390"/>
                    <a:gd name="connsiteY31" fmla="*/ 358282 h 790295"/>
                    <a:gd name="connsiteX32" fmla="*/ 448555 w 589390"/>
                    <a:gd name="connsiteY32" fmla="*/ 423843 h 790295"/>
                    <a:gd name="connsiteX33" fmla="*/ 434753 w 589390"/>
                    <a:gd name="connsiteY33" fmla="*/ 465250 h 790295"/>
                    <a:gd name="connsiteX34" fmla="*/ 572775 w 589390"/>
                    <a:gd name="connsiteY34" fmla="*/ 489404 h 790295"/>
                    <a:gd name="connsiteX35" fmla="*/ 583127 w 589390"/>
                    <a:gd name="connsiteY35" fmla="*/ 382436 h 790295"/>
                    <a:gd name="connsiteX36" fmla="*/ 538270 w 589390"/>
                    <a:gd name="connsiteY36" fmla="*/ 275469 h 790295"/>
                    <a:gd name="connsiteX37" fmla="*/ 527918 w 589390"/>
                    <a:gd name="connsiteY37" fmla="*/ 133996 h 790295"/>
                    <a:gd name="connsiteX38" fmla="*/ 495661 w 589390"/>
                    <a:gd name="connsiteY38" fmla="*/ 74643 h 790295"/>
                    <a:gd name="connsiteX39" fmla="*/ 349673 w 589390"/>
                    <a:gd name="connsiteY39" fmla="*/ 10867 h 790295"/>
                    <a:gd name="connsiteX40" fmla="*/ 203565 w 589390"/>
                    <a:gd name="connsiteY40" fmla="*/ 6325 h 790295"/>
                    <a:gd name="connsiteX0" fmla="*/ 203565 w 589390"/>
                    <a:gd name="connsiteY0" fmla="*/ 5276 h 789246"/>
                    <a:gd name="connsiteX1" fmla="*/ 89696 w 589390"/>
                    <a:gd name="connsiteY1" fmla="*/ 74287 h 789246"/>
                    <a:gd name="connsiteX2" fmla="*/ 20685 w 589390"/>
                    <a:gd name="connsiteY2" fmla="*/ 143298 h 789246"/>
                    <a:gd name="connsiteX3" fmla="*/ 13783 w 589390"/>
                    <a:gd name="connsiteY3" fmla="*/ 219211 h 789246"/>
                    <a:gd name="connsiteX4" fmla="*/ 3432 w 589390"/>
                    <a:gd name="connsiteY4" fmla="*/ 374486 h 789246"/>
                    <a:gd name="connsiteX5" fmla="*/ 79344 w 589390"/>
                    <a:gd name="connsiteY5" fmla="*/ 450399 h 789246"/>
                    <a:gd name="connsiteX6" fmla="*/ 224268 w 589390"/>
                    <a:gd name="connsiteY6" fmla="*/ 453849 h 789246"/>
                    <a:gd name="connsiteX7" fmla="*/ 279477 w 589390"/>
                    <a:gd name="connsiteY7" fmla="*/ 415893 h 789246"/>
                    <a:gd name="connsiteX8" fmla="*/ 289829 w 589390"/>
                    <a:gd name="connsiteY8" fmla="*/ 346882 h 789246"/>
                    <a:gd name="connsiteX9" fmla="*/ 131103 w 589390"/>
                    <a:gd name="connsiteY9" fmla="*/ 360684 h 789246"/>
                    <a:gd name="connsiteX10" fmla="*/ 158707 w 589390"/>
                    <a:gd name="connsiteY10" fmla="*/ 174871 h 789246"/>
                    <a:gd name="connsiteX11" fmla="*/ 159310 w 589390"/>
                    <a:gd name="connsiteY11" fmla="*/ 171355 h 789246"/>
                    <a:gd name="connsiteX12" fmla="*/ 138630 w 589390"/>
                    <a:gd name="connsiteY12" fmla="*/ 211781 h 789246"/>
                    <a:gd name="connsiteX13" fmla="*/ 127652 w 589390"/>
                    <a:gd name="connsiteY13" fmla="*/ 277870 h 789246"/>
                    <a:gd name="connsiteX14" fmla="*/ 138004 w 589390"/>
                    <a:gd name="connsiteY14" fmla="*/ 367585 h 789246"/>
                    <a:gd name="connsiteX15" fmla="*/ 241521 w 589390"/>
                    <a:gd name="connsiteY15" fmla="*/ 350332 h 789246"/>
                    <a:gd name="connsiteX16" fmla="*/ 296730 w 589390"/>
                    <a:gd name="connsiteY16" fmla="*/ 346882 h 789246"/>
                    <a:gd name="connsiteX17" fmla="*/ 296730 w 589390"/>
                    <a:gd name="connsiteY17" fmla="*/ 377937 h 789246"/>
                    <a:gd name="connsiteX18" fmla="*/ 279477 w 589390"/>
                    <a:gd name="connsiteY18" fmla="*/ 412442 h 789246"/>
                    <a:gd name="connsiteX19" fmla="*/ 238070 w 589390"/>
                    <a:gd name="connsiteY19" fmla="*/ 453849 h 789246"/>
                    <a:gd name="connsiteX20" fmla="*/ 138004 w 589390"/>
                    <a:gd name="connsiteY20" fmla="*/ 457300 h 789246"/>
                    <a:gd name="connsiteX21" fmla="*/ 127652 w 589390"/>
                    <a:gd name="connsiteY21" fmla="*/ 495256 h 789246"/>
                    <a:gd name="connsiteX22" fmla="*/ 117300 w 589390"/>
                    <a:gd name="connsiteY22" fmla="*/ 771301 h 789246"/>
                    <a:gd name="connsiteX23" fmla="*/ 458906 w 589390"/>
                    <a:gd name="connsiteY23" fmla="*/ 736796 h 789246"/>
                    <a:gd name="connsiteX24" fmla="*/ 472709 w 589390"/>
                    <a:gd name="connsiteY24" fmla="*/ 529762 h 789246"/>
                    <a:gd name="connsiteX25" fmla="*/ 427851 w 589390"/>
                    <a:gd name="connsiteY25" fmla="*/ 384838 h 789246"/>
                    <a:gd name="connsiteX26" fmla="*/ 420950 w 589390"/>
                    <a:gd name="connsiteY26" fmla="*/ 201958 h 789246"/>
                    <a:gd name="connsiteX27" fmla="*/ 420950 w 589390"/>
                    <a:gd name="connsiteY27" fmla="*/ 143298 h 789246"/>
                    <a:gd name="connsiteX28" fmla="*/ 414049 w 589390"/>
                    <a:gd name="connsiteY28" fmla="*/ 277870 h 789246"/>
                    <a:gd name="connsiteX29" fmla="*/ 424401 w 589390"/>
                    <a:gd name="connsiteY29" fmla="*/ 322728 h 789246"/>
                    <a:gd name="connsiteX30" fmla="*/ 458906 w 589390"/>
                    <a:gd name="connsiteY30" fmla="*/ 360684 h 789246"/>
                    <a:gd name="connsiteX31" fmla="*/ 445104 w 589390"/>
                    <a:gd name="connsiteY31" fmla="*/ 357233 h 789246"/>
                    <a:gd name="connsiteX32" fmla="*/ 448555 w 589390"/>
                    <a:gd name="connsiteY32" fmla="*/ 422794 h 789246"/>
                    <a:gd name="connsiteX33" fmla="*/ 434753 w 589390"/>
                    <a:gd name="connsiteY33" fmla="*/ 464201 h 789246"/>
                    <a:gd name="connsiteX34" fmla="*/ 572775 w 589390"/>
                    <a:gd name="connsiteY34" fmla="*/ 488355 h 789246"/>
                    <a:gd name="connsiteX35" fmla="*/ 583127 w 589390"/>
                    <a:gd name="connsiteY35" fmla="*/ 381387 h 789246"/>
                    <a:gd name="connsiteX36" fmla="*/ 538270 w 589390"/>
                    <a:gd name="connsiteY36" fmla="*/ 274420 h 789246"/>
                    <a:gd name="connsiteX37" fmla="*/ 527918 w 589390"/>
                    <a:gd name="connsiteY37" fmla="*/ 132947 h 789246"/>
                    <a:gd name="connsiteX38" fmla="*/ 474982 w 589390"/>
                    <a:gd name="connsiteY38" fmla="*/ 50189 h 789246"/>
                    <a:gd name="connsiteX39" fmla="*/ 349673 w 589390"/>
                    <a:gd name="connsiteY39" fmla="*/ 9818 h 789246"/>
                    <a:gd name="connsiteX40" fmla="*/ 203565 w 589390"/>
                    <a:gd name="connsiteY40" fmla="*/ 5276 h 789246"/>
                    <a:gd name="connsiteX0" fmla="*/ 203565 w 589390"/>
                    <a:gd name="connsiteY0" fmla="*/ 5276 h 789246"/>
                    <a:gd name="connsiteX1" fmla="*/ 89696 w 589390"/>
                    <a:gd name="connsiteY1" fmla="*/ 74287 h 789246"/>
                    <a:gd name="connsiteX2" fmla="*/ 20685 w 589390"/>
                    <a:gd name="connsiteY2" fmla="*/ 143298 h 789246"/>
                    <a:gd name="connsiteX3" fmla="*/ 13783 w 589390"/>
                    <a:gd name="connsiteY3" fmla="*/ 219211 h 789246"/>
                    <a:gd name="connsiteX4" fmla="*/ 3432 w 589390"/>
                    <a:gd name="connsiteY4" fmla="*/ 374486 h 789246"/>
                    <a:gd name="connsiteX5" fmla="*/ 79344 w 589390"/>
                    <a:gd name="connsiteY5" fmla="*/ 450399 h 789246"/>
                    <a:gd name="connsiteX6" fmla="*/ 224268 w 589390"/>
                    <a:gd name="connsiteY6" fmla="*/ 453849 h 789246"/>
                    <a:gd name="connsiteX7" fmla="*/ 279477 w 589390"/>
                    <a:gd name="connsiteY7" fmla="*/ 415893 h 789246"/>
                    <a:gd name="connsiteX8" fmla="*/ 289829 w 589390"/>
                    <a:gd name="connsiteY8" fmla="*/ 346882 h 789246"/>
                    <a:gd name="connsiteX9" fmla="*/ 131103 w 589390"/>
                    <a:gd name="connsiteY9" fmla="*/ 360684 h 789246"/>
                    <a:gd name="connsiteX10" fmla="*/ 158707 w 589390"/>
                    <a:gd name="connsiteY10" fmla="*/ 174871 h 789246"/>
                    <a:gd name="connsiteX11" fmla="*/ 159310 w 589390"/>
                    <a:gd name="connsiteY11" fmla="*/ 171355 h 789246"/>
                    <a:gd name="connsiteX12" fmla="*/ 138630 w 589390"/>
                    <a:gd name="connsiteY12" fmla="*/ 211781 h 789246"/>
                    <a:gd name="connsiteX13" fmla="*/ 127652 w 589390"/>
                    <a:gd name="connsiteY13" fmla="*/ 277870 h 789246"/>
                    <a:gd name="connsiteX14" fmla="*/ 138004 w 589390"/>
                    <a:gd name="connsiteY14" fmla="*/ 367585 h 789246"/>
                    <a:gd name="connsiteX15" fmla="*/ 241521 w 589390"/>
                    <a:gd name="connsiteY15" fmla="*/ 350332 h 789246"/>
                    <a:gd name="connsiteX16" fmla="*/ 296730 w 589390"/>
                    <a:gd name="connsiteY16" fmla="*/ 346882 h 789246"/>
                    <a:gd name="connsiteX17" fmla="*/ 296730 w 589390"/>
                    <a:gd name="connsiteY17" fmla="*/ 377937 h 789246"/>
                    <a:gd name="connsiteX18" fmla="*/ 279477 w 589390"/>
                    <a:gd name="connsiteY18" fmla="*/ 412442 h 789246"/>
                    <a:gd name="connsiteX19" fmla="*/ 238070 w 589390"/>
                    <a:gd name="connsiteY19" fmla="*/ 453849 h 789246"/>
                    <a:gd name="connsiteX20" fmla="*/ 138004 w 589390"/>
                    <a:gd name="connsiteY20" fmla="*/ 457300 h 789246"/>
                    <a:gd name="connsiteX21" fmla="*/ 127652 w 589390"/>
                    <a:gd name="connsiteY21" fmla="*/ 495256 h 789246"/>
                    <a:gd name="connsiteX22" fmla="*/ 117300 w 589390"/>
                    <a:gd name="connsiteY22" fmla="*/ 771301 h 789246"/>
                    <a:gd name="connsiteX23" fmla="*/ 458906 w 589390"/>
                    <a:gd name="connsiteY23" fmla="*/ 736796 h 789246"/>
                    <a:gd name="connsiteX24" fmla="*/ 472709 w 589390"/>
                    <a:gd name="connsiteY24" fmla="*/ 529762 h 789246"/>
                    <a:gd name="connsiteX25" fmla="*/ 427851 w 589390"/>
                    <a:gd name="connsiteY25" fmla="*/ 384838 h 789246"/>
                    <a:gd name="connsiteX26" fmla="*/ 420950 w 589390"/>
                    <a:gd name="connsiteY26" fmla="*/ 201958 h 789246"/>
                    <a:gd name="connsiteX27" fmla="*/ 420950 w 589390"/>
                    <a:gd name="connsiteY27" fmla="*/ 143298 h 789246"/>
                    <a:gd name="connsiteX28" fmla="*/ 414049 w 589390"/>
                    <a:gd name="connsiteY28" fmla="*/ 277870 h 789246"/>
                    <a:gd name="connsiteX29" fmla="*/ 424401 w 589390"/>
                    <a:gd name="connsiteY29" fmla="*/ 322728 h 789246"/>
                    <a:gd name="connsiteX30" fmla="*/ 458906 w 589390"/>
                    <a:gd name="connsiteY30" fmla="*/ 360684 h 789246"/>
                    <a:gd name="connsiteX31" fmla="*/ 445104 w 589390"/>
                    <a:gd name="connsiteY31" fmla="*/ 357233 h 789246"/>
                    <a:gd name="connsiteX32" fmla="*/ 448555 w 589390"/>
                    <a:gd name="connsiteY32" fmla="*/ 422794 h 789246"/>
                    <a:gd name="connsiteX33" fmla="*/ 434753 w 589390"/>
                    <a:gd name="connsiteY33" fmla="*/ 464201 h 789246"/>
                    <a:gd name="connsiteX34" fmla="*/ 572775 w 589390"/>
                    <a:gd name="connsiteY34" fmla="*/ 488355 h 789246"/>
                    <a:gd name="connsiteX35" fmla="*/ 583127 w 589390"/>
                    <a:gd name="connsiteY35" fmla="*/ 381387 h 789246"/>
                    <a:gd name="connsiteX36" fmla="*/ 538270 w 589390"/>
                    <a:gd name="connsiteY36" fmla="*/ 274420 h 789246"/>
                    <a:gd name="connsiteX37" fmla="*/ 521025 w 589390"/>
                    <a:gd name="connsiteY37" fmla="*/ 137202 h 789246"/>
                    <a:gd name="connsiteX38" fmla="*/ 474982 w 589390"/>
                    <a:gd name="connsiteY38" fmla="*/ 50189 h 789246"/>
                    <a:gd name="connsiteX39" fmla="*/ 349673 w 589390"/>
                    <a:gd name="connsiteY39" fmla="*/ 9818 h 789246"/>
                    <a:gd name="connsiteX40" fmla="*/ 203565 w 589390"/>
                    <a:gd name="connsiteY40" fmla="*/ 5276 h 789246"/>
                    <a:gd name="connsiteX0" fmla="*/ 203565 w 589390"/>
                    <a:gd name="connsiteY0" fmla="*/ 5276 h 789246"/>
                    <a:gd name="connsiteX1" fmla="*/ 89696 w 589390"/>
                    <a:gd name="connsiteY1" fmla="*/ 74287 h 789246"/>
                    <a:gd name="connsiteX2" fmla="*/ 20685 w 589390"/>
                    <a:gd name="connsiteY2" fmla="*/ 143298 h 789246"/>
                    <a:gd name="connsiteX3" fmla="*/ 13783 w 589390"/>
                    <a:gd name="connsiteY3" fmla="*/ 219211 h 789246"/>
                    <a:gd name="connsiteX4" fmla="*/ 3432 w 589390"/>
                    <a:gd name="connsiteY4" fmla="*/ 374486 h 789246"/>
                    <a:gd name="connsiteX5" fmla="*/ 79344 w 589390"/>
                    <a:gd name="connsiteY5" fmla="*/ 450399 h 789246"/>
                    <a:gd name="connsiteX6" fmla="*/ 224268 w 589390"/>
                    <a:gd name="connsiteY6" fmla="*/ 453849 h 789246"/>
                    <a:gd name="connsiteX7" fmla="*/ 279477 w 589390"/>
                    <a:gd name="connsiteY7" fmla="*/ 415893 h 789246"/>
                    <a:gd name="connsiteX8" fmla="*/ 289829 w 589390"/>
                    <a:gd name="connsiteY8" fmla="*/ 346882 h 789246"/>
                    <a:gd name="connsiteX9" fmla="*/ 131103 w 589390"/>
                    <a:gd name="connsiteY9" fmla="*/ 360684 h 789246"/>
                    <a:gd name="connsiteX10" fmla="*/ 158707 w 589390"/>
                    <a:gd name="connsiteY10" fmla="*/ 174871 h 789246"/>
                    <a:gd name="connsiteX11" fmla="*/ 159310 w 589390"/>
                    <a:gd name="connsiteY11" fmla="*/ 171355 h 789246"/>
                    <a:gd name="connsiteX12" fmla="*/ 138630 w 589390"/>
                    <a:gd name="connsiteY12" fmla="*/ 211781 h 789246"/>
                    <a:gd name="connsiteX13" fmla="*/ 127652 w 589390"/>
                    <a:gd name="connsiteY13" fmla="*/ 277870 h 789246"/>
                    <a:gd name="connsiteX14" fmla="*/ 138004 w 589390"/>
                    <a:gd name="connsiteY14" fmla="*/ 367585 h 789246"/>
                    <a:gd name="connsiteX15" fmla="*/ 241521 w 589390"/>
                    <a:gd name="connsiteY15" fmla="*/ 350332 h 789246"/>
                    <a:gd name="connsiteX16" fmla="*/ 296730 w 589390"/>
                    <a:gd name="connsiteY16" fmla="*/ 346882 h 789246"/>
                    <a:gd name="connsiteX17" fmla="*/ 296730 w 589390"/>
                    <a:gd name="connsiteY17" fmla="*/ 377937 h 789246"/>
                    <a:gd name="connsiteX18" fmla="*/ 279477 w 589390"/>
                    <a:gd name="connsiteY18" fmla="*/ 412442 h 789246"/>
                    <a:gd name="connsiteX19" fmla="*/ 238070 w 589390"/>
                    <a:gd name="connsiteY19" fmla="*/ 453849 h 789246"/>
                    <a:gd name="connsiteX20" fmla="*/ 138004 w 589390"/>
                    <a:gd name="connsiteY20" fmla="*/ 457300 h 789246"/>
                    <a:gd name="connsiteX21" fmla="*/ 127652 w 589390"/>
                    <a:gd name="connsiteY21" fmla="*/ 495256 h 789246"/>
                    <a:gd name="connsiteX22" fmla="*/ 117300 w 589390"/>
                    <a:gd name="connsiteY22" fmla="*/ 771301 h 789246"/>
                    <a:gd name="connsiteX23" fmla="*/ 458906 w 589390"/>
                    <a:gd name="connsiteY23" fmla="*/ 736796 h 789246"/>
                    <a:gd name="connsiteX24" fmla="*/ 472709 w 589390"/>
                    <a:gd name="connsiteY24" fmla="*/ 529762 h 789246"/>
                    <a:gd name="connsiteX25" fmla="*/ 427851 w 589390"/>
                    <a:gd name="connsiteY25" fmla="*/ 384838 h 789246"/>
                    <a:gd name="connsiteX26" fmla="*/ 432439 w 589390"/>
                    <a:gd name="connsiteY26" fmla="*/ 208341 h 789246"/>
                    <a:gd name="connsiteX27" fmla="*/ 420950 w 589390"/>
                    <a:gd name="connsiteY27" fmla="*/ 143298 h 789246"/>
                    <a:gd name="connsiteX28" fmla="*/ 414049 w 589390"/>
                    <a:gd name="connsiteY28" fmla="*/ 277870 h 789246"/>
                    <a:gd name="connsiteX29" fmla="*/ 424401 w 589390"/>
                    <a:gd name="connsiteY29" fmla="*/ 322728 h 789246"/>
                    <a:gd name="connsiteX30" fmla="*/ 458906 w 589390"/>
                    <a:gd name="connsiteY30" fmla="*/ 360684 h 789246"/>
                    <a:gd name="connsiteX31" fmla="*/ 445104 w 589390"/>
                    <a:gd name="connsiteY31" fmla="*/ 357233 h 789246"/>
                    <a:gd name="connsiteX32" fmla="*/ 448555 w 589390"/>
                    <a:gd name="connsiteY32" fmla="*/ 422794 h 789246"/>
                    <a:gd name="connsiteX33" fmla="*/ 434753 w 589390"/>
                    <a:gd name="connsiteY33" fmla="*/ 464201 h 789246"/>
                    <a:gd name="connsiteX34" fmla="*/ 572775 w 589390"/>
                    <a:gd name="connsiteY34" fmla="*/ 488355 h 789246"/>
                    <a:gd name="connsiteX35" fmla="*/ 583127 w 589390"/>
                    <a:gd name="connsiteY35" fmla="*/ 381387 h 789246"/>
                    <a:gd name="connsiteX36" fmla="*/ 538270 w 589390"/>
                    <a:gd name="connsiteY36" fmla="*/ 274420 h 789246"/>
                    <a:gd name="connsiteX37" fmla="*/ 521025 w 589390"/>
                    <a:gd name="connsiteY37" fmla="*/ 137202 h 789246"/>
                    <a:gd name="connsiteX38" fmla="*/ 474982 w 589390"/>
                    <a:gd name="connsiteY38" fmla="*/ 50189 h 789246"/>
                    <a:gd name="connsiteX39" fmla="*/ 349673 w 589390"/>
                    <a:gd name="connsiteY39" fmla="*/ 9818 h 789246"/>
                    <a:gd name="connsiteX40" fmla="*/ 203565 w 589390"/>
                    <a:gd name="connsiteY40" fmla="*/ 5276 h 789246"/>
                    <a:gd name="connsiteX0" fmla="*/ 203565 w 589390"/>
                    <a:gd name="connsiteY0" fmla="*/ 5276 h 789246"/>
                    <a:gd name="connsiteX1" fmla="*/ 89696 w 589390"/>
                    <a:gd name="connsiteY1" fmla="*/ 74287 h 789246"/>
                    <a:gd name="connsiteX2" fmla="*/ 20685 w 589390"/>
                    <a:gd name="connsiteY2" fmla="*/ 143298 h 789246"/>
                    <a:gd name="connsiteX3" fmla="*/ 13783 w 589390"/>
                    <a:gd name="connsiteY3" fmla="*/ 219211 h 789246"/>
                    <a:gd name="connsiteX4" fmla="*/ 3432 w 589390"/>
                    <a:gd name="connsiteY4" fmla="*/ 374486 h 789246"/>
                    <a:gd name="connsiteX5" fmla="*/ 79344 w 589390"/>
                    <a:gd name="connsiteY5" fmla="*/ 450399 h 789246"/>
                    <a:gd name="connsiteX6" fmla="*/ 224268 w 589390"/>
                    <a:gd name="connsiteY6" fmla="*/ 453849 h 789246"/>
                    <a:gd name="connsiteX7" fmla="*/ 279477 w 589390"/>
                    <a:gd name="connsiteY7" fmla="*/ 415893 h 789246"/>
                    <a:gd name="connsiteX8" fmla="*/ 289829 w 589390"/>
                    <a:gd name="connsiteY8" fmla="*/ 346882 h 789246"/>
                    <a:gd name="connsiteX9" fmla="*/ 131103 w 589390"/>
                    <a:gd name="connsiteY9" fmla="*/ 360684 h 789246"/>
                    <a:gd name="connsiteX10" fmla="*/ 158707 w 589390"/>
                    <a:gd name="connsiteY10" fmla="*/ 174871 h 789246"/>
                    <a:gd name="connsiteX11" fmla="*/ 159310 w 589390"/>
                    <a:gd name="connsiteY11" fmla="*/ 171355 h 789246"/>
                    <a:gd name="connsiteX12" fmla="*/ 138630 w 589390"/>
                    <a:gd name="connsiteY12" fmla="*/ 211781 h 789246"/>
                    <a:gd name="connsiteX13" fmla="*/ 127652 w 589390"/>
                    <a:gd name="connsiteY13" fmla="*/ 277870 h 789246"/>
                    <a:gd name="connsiteX14" fmla="*/ 138004 w 589390"/>
                    <a:gd name="connsiteY14" fmla="*/ 367585 h 789246"/>
                    <a:gd name="connsiteX15" fmla="*/ 241521 w 589390"/>
                    <a:gd name="connsiteY15" fmla="*/ 350332 h 789246"/>
                    <a:gd name="connsiteX16" fmla="*/ 296730 w 589390"/>
                    <a:gd name="connsiteY16" fmla="*/ 346882 h 789246"/>
                    <a:gd name="connsiteX17" fmla="*/ 296730 w 589390"/>
                    <a:gd name="connsiteY17" fmla="*/ 377937 h 789246"/>
                    <a:gd name="connsiteX18" fmla="*/ 279477 w 589390"/>
                    <a:gd name="connsiteY18" fmla="*/ 412442 h 789246"/>
                    <a:gd name="connsiteX19" fmla="*/ 238070 w 589390"/>
                    <a:gd name="connsiteY19" fmla="*/ 453849 h 789246"/>
                    <a:gd name="connsiteX20" fmla="*/ 138004 w 589390"/>
                    <a:gd name="connsiteY20" fmla="*/ 457300 h 789246"/>
                    <a:gd name="connsiteX21" fmla="*/ 127652 w 589390"/>
                    <a:gd name="connsiteY21" fmla="*/ 495256 h 789246"/>
                    <a:gd name="connsiteX22" fmla="*/ 117300 w 589390"/>
                    <a:gd name="connsiteY22" fmla="*/ 771301 h 789246"/>
                    <a:gd name="connsiteX23" fmla="*/ 458906 w 589390"/>
                    <a:gd name="connsiteY23" fmla="*/ 736796 h 789246"/>
                    <a:gd name="connsiteX24" fmla="*/ 472709 w 589390"/>
                    <a:gd name="connsiteY24" fmla="*/ 529762 h 789246"/>
                    <a:gd name="connsiteX25" fmla="*/ 427851 w 589390"/>
                    <a:gd name="connsiteY25" fmla="*/ 384838 h 789246"/>
                    <a:gd name="connsiteX26" fmla="*/ 432439 w 589390"/>
                    <a:gd name="connsiteY26" fmla="*/ 208341 h 789246"/>
                    <a:gd name="connsiteX27" fmla="*/ 420950 w 589390"/>
                    <a:gd name="connsiteY27" fmla="*/ 143298 h 789246"/>
                    <a:gd name="connsiteX28" fmla="*/ 414049 w 589390"/>
                    <a:gd name="connsiteY28" fmla="*/ 277870 h 789246"/>
                    <a:gd name="connsiteX29" fmla="*/ 435889 w 589390"/>
                    <a:gd name="connsiteY29" fmla="*/ 320600 h 789246"/>
                    <a:gd name="connsiteX30" fmla="*/ 458906 w 589390"/>
                    <a:gd name="connsiteY30" fmla="*/ 360684 h 789246"/>
                    <a:gd name="connsiteX31" fmla="*/ 445104 w 589390"/>
                    <a:gd name="connsiteY31" fmla="*/ 357233 h 789246"/>
                    <a:gd name="connsiteX32" fmla="*/ 448555 w 589390"/>
                    <a:gd name="connsiteY32" fmla="*/ 422794 h 789246"/>
                    <a:gd name="connsiteX33" fmla="*/ 434753 w 589390"/>
                    <a:gd name="connsiteY33" fmla="*/ 464201 h 789246"/>
                    <a:gd name="connsiteX34" fmla="*/ 572775 w 589390"/>
                    <a:gd name="connsiteY34" fmla="*/ 488355 h 789246"/>
                    <a:gd name="connsiteX35" fmla="*/ 583127 w 589390"/>
                    <a:gd name="connsiteY35" fmla="*/ 381387 h 789246"/>
                    <a:gd name="connsiteX36" fmla="*/ 538270 w 589390"/>
                    <a:gd name="connsiteY36" fmla="*/ 274420 h 789246"/>
                    <a:gd name="connsiteX37" fmla="*/ 521025 w 589390"/>
                    <a:gd name="connsiteY37" fmla="*/ 137202 h 789246"/>
                    <a:gd name="connsiteX38" fmla="*/ 474982 w 589390"/>
                    <a:gd name="connsiteY38" fmla="*/ 50189 h 789246"/>
                    <a:gd name="connsiteX39" fmla="*/ 349673 w 589390"/>
                    <a:gd name="connsiteY39" fmla="*/ 9818 h 789246"/>
                    <a:gd name="connsiteX40" fmla="*/ 203565 w 589390"/>
                    <a:gd name="connsiteY40" fmla="*/ 5276 h 789246"/>
                    <a:gd name="connsiteX0" fmla="*/ 203565 w 589390"/>
                    <a:gd name="connsiteY0" fmla="*/ 5276 h 789246"/>
                    <a:gd name="connsiteX1" fmla="*/ 89696 w 589390"/>
                    <a:gd name="connsiteY1" fmla="*/ 74287 h 789246"/>
                    <a:gd name="connsiteX2" fmla="*/ 20685 w 589390"/>
                    <a:gd name="connsiteY2" fmla="*/ 143298 h 789246"/>
                    <a:gd name="connsiteX3" fmla="*/ 13783 w 589390"/>
                    <a:gd name="connsiteY3" fmla="*/ 219211 h 789246"/>
                    <a:gd name="connsiteX4" fmla="*/ 3432 w 589390"/>
                    <a:gd name="connsiteY4" fmla="*/ 374486 h 789246"/>
                    <a:gd name="connsiteX5" fmla="*/ 79344 w 589390"/>
                    <a:gd name="connsiteY5" fmla="*/ 450399 h 789246"/>
                    <a:gd name="connsiteX6" fmla="*/ 224268 w 589390"/>
                    <a:gd name="connsiteY6" fmla="*/ 453849 h 789246"/>
                    <a:gd name="connsiteX7" fmla="*/ 279477 w 589390"/>
                    <a:gd name="connsiteY7" fmla="*/ 415893 h 789246"/>
                    <a:gd name="connsiteX8" fmla="*/ 289829 w 589390"/>
                    <a:gd name="connsiteY8" fmla="*/ 346882 h 789246"/>
                    <a:gd name="connsiteX9" fmla="*/ 131103 w 589390"/>
                    <a:gd name="connsiteY9" fmla="*/ 360684 h 789246"/>
                    <a:gd name="connsiteX10" fmla="*/ 158707 w 589390"/>
                    <a:gd name="connsiteY10" fmla="*/ 174871 h 789246"/>
                    <a:gd name="connsiteX11" fmla="*/ 159310 w 589390"/>
                    <a:gd name="connsiteY11" fmla="*/ 171355 h 789246"/>
                    <a:gd name="connsiteX12" fmla="*/ 138630 w 589390"/>
                    <a:gd name="connsiteY12" fmla="*/ 211781 h 789246"/>
                    <a:gd name="connsiteX13" fmla="*/ 127652 w 589390"/>
                    <a:gd name="connsiteY13" fmla="*/ 277870 h 789246"/>
                    <a:gd name="connsiteX14" fmla="*/ 138004 w 589390"/>
                    <a:gd name="connsiteY14" fmla="*/ 367585 h 789246"/>
                    <a:gd name="connsiteX15" fmla="*/ 241521 w 589390"/>
                    <a:gd name="connsiteY15" fmla="*/ 350332 h 789246"/>
                    <a:gd name="connsiteX16" fmla="*/ 296730 w 589390"/>
                    <a:gd name="connsiteY16" fmla="*/ 346882 h 789246"/>
                    <a:gd name="connsiteX17" fmla="*/ 296730 w 589390"/>
                    <a:gd name="connsiteY17" fmla="*/ 377937 h 789246"/>
                    <a:gd name="connsiteX18" fmla="*/ 279477 w 589390"/>
                    <a:gd name="connsiteY18" fmla="*/ 412442 h 789246"/>
                    <a:gd name="connsiteX19" fmla="*/ 238070 w 589390"/>
                    <a:gd name="connsiteY19" fmla="*/ 453849 h 789246"/>
                    <a:gd name="connsiteX20" fmla="*/ 138004 w 589390"/>
                    <a:gd name="connsiteY20" fmla="*/ 457300 h 789246"/>
                    <a:gd name="connsiteX21" fmla="*/ 127652 w 589390"/>
                    <a:gd name="connsiteY21" fmla="*/ 495256 h 789246"/>
                    <a:gd name="connsiteX22" fmla="*/ 117300 w 589390"/>
                    <a:gd name="connsiteY22" fmla="*/ 771301 h 789246"/>
                    <a:gd name="connsiteX23" fmla="*/ 458906 w 589390"/>
                    <a:gd name="connsiteY23" fmla="*/ 736796 h 789246"/>
                    <a:gd name="connsiteX24" fmla="*/ 472709 w 589390"/>
                    <a:gd name="connsiteY24" fmla="*/ 529762 h 789246"/>
                    <a:gd name="connsiteX25" fmla="*/ 427851 w 589390"/>
                    <a:gd name="connsiteY25" fmla="*/ 384838 h 789246"/>
                    <a:gd name="connsiteX26" fmla="*/ 420950 w 589390"/>
                    <a:gd name="connsiteY26" fmla="*/ 212597 h 789246"/>
                    <a:gd name="connsiteX27" fmla="*/ 420950 w 589390"/>
                    <a:gd name="connsiteY27" fmla="*/ 143298 h 789246"/>
                    <a:gd name="connsiteX28" fmla="*/ 414049 w 589390"/>
                    <a:gd name="connsiteY28" fmla="*/ 277870 h 789246"/>
                    <a:gd name="connsiteX29" fmla="*/ 435889 w 589390"/>
                    <a:gd name="connsiteY29" fmla="*/ 320600 h 789246"/>
                    <a:gd name="connsiteX30" fmla="*/ 458906 w 589390"/>
                    <a:gd name="connsiteY30" fmla="*/ 360684 h 789246"/>
                    <a:gd name="connsiteX31" fmla="*/ 445104 w 589390"/>
                    <a:gd name="connsiteY31" fmla="*/ 357233 h 789246"/>
                    <a:gd name="connsiteX32" fmla="*/ 448555 w 589390"/>
                    <a:gd name="connsiteY32" fmla="*/ 422794 h 789246"/>
                    <a:gd name="connsiteX33" fmla="*/ 434753 w 589390"/>
                    <a:gd name="connsiteY33" fmla="*/ 464201 h 789246"/>
                    <a:gd name="connsiteX34" fmla="*/ 572775 w 589390"/>
                    <a:gd name="connsiteY34" fmla="*/ 488355 h 789246"/>
                    <a:gd name="connsiteX35" fmla="*/ 583127 w 589390"/>
                    <a:gd name="connsiteY35" fmla="*/ 381387 h 789246"/>
                    <a:gd name="connsiteX36" fmla="*/ 538270 w 589390"/>
                    <a:gd name="connsiteY36" fmla="*/ 274420 h 789246"/>
                    <a:gd name="connsiteX37" fmla="*/ 521025 w 589390"/>
                    <a:gd name="connsiteY37" fmla="*/ 137202 h 789246"/>
                    <a:gd name="connsiteX38" fmla="*/ 474982 w 589390"/>
                    <a:gd name="connsiteY38" fmla="*/ 50189 h 789246"/>
                    <a:gd name="connsiteX39" fmla="*/ 349673 w 589390"/>
                    <a:gd name="connsiteY39" fmla="*/ 9818 h 789246"/>
                    <a:gd name="connsiteX40" fmla="*/ 203565 w 589390"/>
                    <a:gd name="connsiteY40" fmla="*/ 5276 h 789246"/>
                    <a:gd name="connsiteX0" fmla="*/ 203565 w 589390"/>
                    <a:gd name="connsiteY0" fmla="*/ 5276 h 789246"/>
                    <a:gd name="connsiteX1" fmla="*/ 89696 w 589390"/>
                    <a:gd name="connsiteY1" fmla="*/ 74287 h 789246"/>
                    <a:gd name="connsiteX2" fmla="*/ 20685 w 589390"/>
                    <a:gd name="connsiteY2" fmla="*/ 143298 h 789246"/>
                    <a:gd name="connsiteX3" fmla="*/ 13783 w 589390"/>
                    <a:gd name="connsiteY3" fmla="*/ 219211 h 789246"/>
                    <a:gd name="connsiteX4" fmla="*/ 3432 w 589390"/>
                    <a:gd name="connsiteY4" fmla="*/ 374486 h 789246"/>
                    <a:gd name="connsiteX5" fmla="*/ 79344 w 589390"/>
                    <a:gd name="connsiteY5" fmla="*/ 450399 h 789246"/>
                    <a:gd name="connsiteX6" fmla="*/ 224268 w 589390"/>
                    <a:gd name="connsiteY6" fmla="*/ 453849 h 789246"/>
                    <a:gd name="connsiteX7" fmla="*/ 279477 w 589390"/>
                    <a:gd name="connsiteY7" fmla="*/ 415893 h 789246"/>
                    <a:gd name="connsiteX8" fmla="*/ 289829 w 589390"/>
                    <a:gd name="connsiteY8" fmla="*/ 346882 h 789246"/>
                    <a:gd name="connsiteX9" fmla="*/ 131103 w 589390"/>
                    <a:gd name="connsiteY9" fmla="*/ 360684 h 789246"/>
                    <a:gd name="connsiteX10" fmla="*/ 158707 w 589390"/>
                    <a:gd name="connsiteY10" fmla="*/ 174871 h 789246"/>
                    <a:gd name="connsiteX11" fmla="*/ 159310 w 589390"/>
                    <a:gd name="connsiteY11" fmla="*/ 171355 h 789246"/>
                    <a:gd name="connsiteX12" fmla="*/ 138630 w 589390"/>
                    <a:gd name="connsiteY12" fmla="*/ 211781 h 789246"/>
                    <a:gd name="connsiteX13" fmla="*/ 127652 w 589390"/>
                    <a:gd name="connsiteY13" fmla="*/ 277870 h 789246"/>
                    <a:gd name="connsiteX14" fmla="*/ 138004 w 589390"/>
                    <a:gd name="connsiteY14" fmla="*/ 367585 h 789246"/>
                    <a:gd name="connsiteX15" fmla="*/ 241521 w 589390"/>
                    <a:gd name="connsiteY15" fmla="*/ 350332 h 789246"/>
                    <a:gd name="connsiteX16" fmla="*/ 296730 w 589390"/>
                    <a:gd name="connsiteY16" fmla="*/ 346882 h 789246"/>
                    <a:gd name="connsiteX17" fmla="*/ 296730 w 589390"/>
                    <a:gd name="connsiteY17" fmla="*/ 377937 h 789246"/>
                    <a:gd name="connsiteX18" fmla="*/ 279477 w 589390"/>
                    <a:gd name="connsiteY18" fmla="*/ 412442 h 789246"/>
                    <a:gd name="connsiteX19" fmla="*/ 238070 w 589390"/>
                    <a:gd name="connsiteY19" fmla="*/ 453849 h 789246"/>
                    <a:gd name="connsiteX20" fmla="*/ 138004 w 589390"/>
                    <a:gd name="connsiteY20" fmla="*/ 457300 h 789246"/>
                    <a:gd name="connsiteX21" fmla="*/ 127652 w 589390"/>
                    <a:gd name="connsiteY21" fmla="*/ 495256 h 789246"/>
                    <a:gd name="connsiteX22" fmla="*/ 117300 w 589390"/>
                    <a:gd name="connsiteY22" fmla="*/ 771301 h 789246"/>
                    <a:gd name="connsiteX23" fmla="*/ 458906 w 589390"/>
                    <a:gd name="connsiteY23" fmla="*/ 736796 h 789246"/>
                    <a:gd name="connsiteX24" fmla="*/ 472709 w 589390"/>
                    <a:gd name="connsiteY24" fmla="*/ 529762 h 789246"/>
                    <a:gd name="connsiteX25" fmla="*/ 427851 w 589390"/>
                    <a:gd name="connsiteY25" fmla="*/ 384838 h 789246"/>
                    <a:gd name="connsiteX26" fmla="*/ 420950 w 589390"/>
                    <a:gd name="connsiteY26" fmla="*/ 212597 h 789246"/>
                    <a:gd name="connsiteX27" fmla="*/ 420950 w 589390"/>
                    <a:gd name="connsiteY27" fmla="*/ 143298 h 789246"/>
                    <a:gd name="connsiteX28" fmla="*/ 414049 w 589390"/>
                    <a:gd name="connsiteY28" fmla="*/ 277870 h 789246"/>
                    <a:gd name="connsiteX29" fmla="*/ 451973 w 589390"/>
                    <a:gd name="connsiteY29" fmla="*/ 309962 h 789246"/>
                    <a:gd name="connsiteX30" fmla="*/ 458906 w 589390"/>
                    <a:gd name="connsiteY30" fmla="*/ 360684 h 789246"/>
                    <a:gd name="connsiteX31" fmla="*/ 445104 w 589390"/>
                    <a:gd name="connsiteY31" fmla="*/ 357233 h 789246"/>
                    <a:gd name="connsiteX32" fmla="*/ 448555 w 589390"/>
                    <a:gd name="connsiteY32" fmla="*/ 422794 h 789246"/>
                    <a:gd name="connsiteX33" fmla="*/ 434753 w 589390"/>
                    <a:gd name="connsiteY33" fmla="*/ 464201 h 789246"/>
                    <a:gd name="connsiteX34" fmla="*/ 572775 w 589390"/>
                    <a:gd name="connsiteY34" fmla="*/ 488355 h 789246"/>
                    <a:gd name="connsiteX35" fmla="*/ 583127 w 589390"/>
                    <a:gd name="connsiteY35" fmla="*/ 381387 h 789246"/>
                    <a:gd name="connsiteX36" fmla="*/ 538270 w 589390"/>
                    <a:gd name="connsiteY36" fmla="*/ 274420 h 789246"/>
                    <a:gd name="connsiteX37" fmla="*/ 521025 w 589390"/>
                    <a:gd name="connsiteY37" fmla="*/ 137202 h 789246"/>
                    <a:gd name="connsiteX38" fmla="*/ 474982 w 589390"/>
                    <a:gd name="connsiteY38" fmla="*/ 50189 h 789246"/>
                    <a:gd name="connsiteX39" fmla="*/ 349673 w 589390"/>
                    <a:gd name="connsiteY39" fmla="*/ 9818 h 789246"/>
                    <a:gd name="connsiteX40" fmla="*/ 203565 w 589390"/>
                    <a:gd name="connsiteY40" fmla="*/ 5276 h 789246"/>
                    <a:gd name="connsiteX0" fmla="*/ 203565 w 589390"/>
                    <a:gd name="connsiteY0" fmla="*/ 5276 h 789246"/>
                    <a:gd name="connsiteX1" fmla="*/ 89696 w 589390"/>
                    <a:gd name="connsiteY1" fmla="*/ 74287 h 789246"/>
                    <a:gd name="connsiteX2" fmla="*/ 20685 w 589390"/>
                    <a:gd name="connsiteY2" fmla="*/ 143298 h 789246"/>
                    <a:gd name="connsiteX3" fmla="*/ 13783 w 589390"/>
                    <a:gd name="connsiteY3" fmla="*/ 219211 h 789246"/>
                    <a:gd name="connsiteX4" fmla="*/ 3432 w 589390"/>
                    <a:gd name="connsiteY4" fmla="*/ 374486 h 789246"/>
                    <a:gd name="connsiteX5" fmla="*/ 79344 w 589390"/>
                    <a:gd name="connsiteY5" fmla="*/ 450399 h 789246"/>
                    <a:gd name="connsiteX6" fmla="*/ 224268 w 589390"/>
                    <a:gd name="connsiteY6" fmla="*/ 453849 h 789246"/>
                    <a:gd name="connsiteX7" fmla="*/ 279477 w 589390"/>
                    <a:gd name="connsiteY7" fmla="*/ 415893 h 789246"/>
                    <a:gd name="connsiteX8" fmla="*/ 289829 w 589390"/>
                    <a:gd name="connsiteY8" fmla="*/ 346882 h 789246"/>
                    <a:gd name="connsiteX9" fmla="*/ 131103 w 589390"/>
                    <a:gd name="connsiteY9" fmla="*/ 360684 h 789246"/>
                    <a:gd name="connsiteX10" fmla="*/ 158707 w 589390"/>
                    <a:gd name="connsiteY10" fmla="*/ 174871 h 789246"/>
                    <a:gd name="connsiteX11" fmla="*/ 159310 w 589390"/>
                    <a:gd name="connsiteY11" fmla="*/ 171355 h 789246"/>
                    <a:gd name="connsiteX12" fmla="*/ 138630 w 589390"/>
                    <a:gd name="connsiteY12" fmla="*/ 211781 h 789246"/>
                    <a:gd name="connsiteX13" fmla="*/ 127652 w 589390"/>
                    <a:gd name="connsiteY13" fmla="*/ 277870 h 789246"/>
                    <a:gd name="connsiteX14" fmla="*/ 138004 w 589390"/>
                    <a:gd name="connsiteY14" fmla="*/ 367585 h 789246"/>
                    <a:gd name="connsiteX15" fmla="*/ 241521 w 589390"/>
                    <a:gd name="connsiteY15" fmla="*/ 350332 h 789246"/>
                    <a:gd name="connsiteX16" fmla="*/ 296730 w 589390"/>
                    <a:gd name="connsiteY16" fmla="*/ 346882 h 789246"/>
                    <a:gd name="connsiteX17" fmla="*/ 296730 w 589390"/>
                    <a:gd name="connsiteY17" fmla="*/ 377937 h 789246"/>
                    <a:gd name="connsiteX18" fmla="*/ 279477 w 589390"/>
                    <a:gd name="connsiteY18" fmla="*/ 412442 h 789246"/>
                    <a:gd name="connsiteX19" fmla="*/ 238070 w 589390"/>
                    <a:gd name="connsiteY19" fmla="*/ 453849 h 789246"/>
                    <a:gd name="connsiteX20" fmla="*/ 138004 w 589390"/>
                    <a:gd name="connsiteY20" fmla="*/ 457300 h 789246"/>
                    <a:gd name="connsiteX21" fmla="*/ 127652 w 589390"/>
                    <a:gd name="connsiteY21" fmla="*/ 495256 h 789246"/>
                    <a:gd name="connsiteX22" fmla="*/ 117300 w 589390"/>
                    <a:gd name="connsiteY22" fmla="*/ 771301 h 789246"/>
                    <a:gd name="connsiteX23" fmla="*/ 458906 w 589390"/>
                    <a:gd name="connsiteY23" fmla="*/ 736796 h 789246"/>
                    <a:gd name="connsiteX24" fmla="*/ 472709 w 589390"/>
                    <a:gd name="connsiteY24" fmla="*/ 529762 h 789246"/>
                    <a:gd name="connsiteX25" fmla="*/ 427851 w 589390"/>
                    <a:gd name="connsiteY25" fmla="*/ 384838 h 789246"/>
                    <a:gd name="connsiteX26" fmla="*/ 420950 w 589390"/>
                    <a:gd name="connsiteY26" fmla="*/ 212597 h 789246"/>
                    <a:gd name="connsiteX27" fmla="*/ 420950 w 589390"/>
                    <a:gd name="connsiteY27" fmla="*/ 143298 h 789246"/>
                    <a:gd name="connsiteX28" fmla="*/ 430133 w 589390"/>
                    <a:gd name="connsiteY28" fmla="*/ 279998 h 789246"/>
                    <a:gd name="connsiteX29" fmla="*/ 451973 w 589390"/>
                    <a:gd name="connsiteY29" fmla="*/ 309962 h 789246"/>
                    <a:gd name="connsiteX30" fmla="*/ 458906 w 589390"/>
                    <a:gd name="connsiteY30" fmla="*/ 360684 h 789246"/>
                    <a:gd name="connsiteX31" fmla="*/ 445104 w 589390"/>
                    <a:gd name="connsiteY31" fmla="*/ 357233 h 789246"/>
                    <a:gd name="connsiteX32" fmla="*/ 448555 w 589390"/>
                    <a:gd name="connsiteY32" fmla="*/ 422794 h 789246"/>
                    <a:gd name="connsiteX33" fmla="*/ 434753 w 589390"/>
                    <a:gd name="connsiteY33" fmla="*/ 464201 h 789246"/>
                    <a:gd name="connsiteX34" fmla="*/ 572775 w 589390"/>
                    <a:gd name="connsiteY34" fmla="*/ 488355 h 789246"/>
                    <a:gd name="connsiteX35" fmla="*/ 583127 w 589390"/>
                    <a:gd name="connsiteY35" fmla="*/ 381387 h 789246"/>
                    <a:gd name="connsiteX36" fmla="*/ 538270 w 589390"/>
                    <a:gd name="connsiteY36" fmla="*/ 274420 h 789246"/>
                    <a:gd name="connsiteX37" fmla="*/ 521025 w 589390"/>
                    <a:gd name="connsiteY37" fmla="*/ 137202 h 789246"/>
                    <a:gd name="connsiteX38" fmla="*/ 474982 w 589390"/>
                    <a:gd name="connsiteY38" fmla="*/ 50189 h 789246"/>
                    <a:gd name="connsiteX39" fmla="*/ 349673 w 589390"/>
                    <a:gd name="connsiteY39" fmla="*/ 9818 h 789246"/>
                    <a:gd name="connsiteX40" fmla="*/ 203565 w 589390"/>
                    <a:gd name="connsiteY40" fmla="*/ 5276 h 78924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</a:cxnLst>
                  <a:rect l="l" t="t" r="r" b="b"/>
                  <a:pathLst>
                    <a:path w="589390" h="789246">
                      <a:moveTo>
                        <a:pt x="203565" y="5276"/>
                      </a:moveTo>
                      <a:cubicBezTo>
                        <a:pt x="160236" y="16021"/>
                        <a:pt x="120176" y="51283"/>
                        <a:pt x="89696" y="74287"/>
                      </a:cubicBezTo>
                      <a:cubicBezTo>
                        <a:pt x="59216" y="97291"/>
                        <a:pt x="33337" y="119144"/>
                        <a:pt x="20685" y="143298"/>
                      </a:cubicBezTo>
                      <a:cubicBezTo>
                        <a:pt x="8033" y="167452"/>
                        <a:pt x="16659" y="180680"/>
                        <a:pt x="13783" y="219211"/>
                      </a:cubicBezTo>
                      <a:cubicBezTo>
                        <a:pt x="10907" y="257742"/>
                        <a:pt x="-7495" y="335955"/>
                        <a:pt x="3432" y="374486"/>
                      </a:cubicBezTo>
                      <a:cubicBezTo>
                        <a:pt x="14359" y="413017"/>
                        <a:pt x="42538" y="437172"/>
                        <a:pt x="79344" y="450399"/>
                      </a:cubicBezTo>
                      <a:cubicBezTo>
                        <a:pt x="116150" y="463626"/>
                        <a:pt x="190912" y="459600"/>
                        <a:pt x="224268" y="453849"/>
                      </a:cubicBezTo>
                      <a:cubicBezTo>
                        <a:pt x="257624" y="448098"/>
                        <a:pt x="268550" y="433721"/>
                        <a:pt x="279477" y="415893"/>
                      </a:cubicBezTo>
                      <a:cubicBezTo>
                        <a:pt x="290404" y="398065"/>
                        <a:pt x="314558" y="356083"/>
                        <a:pt x="289829" y="346882"/>
                      </a:cubicBezTo>
                      <a:cubicBezTo>
                        <a:pt x="265100" y="337681"/>
                        <a:pt x="152957" y="389352"/>
                        <a:pt x="131103" y="360684"/>
                      </a:cubicBezTo>
                      <a:cubicBezTo>
                        <a:pt x="109249" y="332016"/>
                        <a:pt x="154006" y="206426"/>
                        <a:pt x="158707" y="174871"/>
                      </a:cubicBezTo>
                      <a:cubicBezTo>
                        <a:pt x="163408" y="143316"/>
                        <a:pt x="162656" y="165203"/>
                        <a:pt x="159310" y="171355"/>
                      </a:cubicBezTo>
                      <a:cubicBezTo>
                        <a:pt x="155964" y="177507"/>
                        <a:pt x="143906" y="194029"/>
                        <a:pt x="138630" y="211781"/>
                      </a:cubicBezTo>
                      <a:cubicBezTo>
                        <a:pt x="133354" y="229533"/>
                        <a:pt x="127756" y="251903"/>
                        <a:pt x="127652" y="277870"/>
                      </a:cubicBezTo>
                      <a:cubicBezTo>
                        <a:pt x="127548" y="303837"/>
                        <a:pt x="119026" y="355508"/>
                        <a:pt x="138004" y="367585"/>
                      </a:cubicBezTo>
                      <a:cubicBezTo>
                        <a:pt x="156982" y="379662"/>
                        <a:pt x="215067" y="353783"/>
                        <a:pt x="241521" y="350332"/>
                      </a:cubicBezTo>
                      <a:cubicBezTo>
                        <a:pt x="267975" y="346882"/>
                        <a:pt x="287529" y="342281"/>
                        <a:pt x="296730" y="346882"/>
                      </a:cubicBezTo>
                      <a:cubicBezTo>
                        <a:pt x="305931" y="351483"/>
                        <a:pt x="299606" y="367010"/>
                        <a:pt x="296730" y="377937"/>
                      </a:cubicBezTo>
                      <a:cubicBezTo>
                        <a:pt x="293855" y="388864"/>
                        <a:pt x="289254" y="399790"/>
                        <a:pt x="279477" y="412442"/>
                      </a:cubicBezTo>
                      <a:cubicBezTo>
                        <a:pt x="269700" y="425094"/>
                        <a:pt x="261649" y="446373"/>
                        <a:pt x="238070" y="453849"/>
                      </a:cubicBezTo>
                      <a:cubicBezTo>
                        <a:pt x="214491" y="461325"/>
                        <a:pt x="156407" y="450399"/>
                        <a:pt x="138004" y="457300"/>
                      </a:cubicBezTo>
                      <a:cubicBezTo>
                        <a:pt x="119601" y="464201"/>
                        <a:pt x="131103" y="442923"/>
                        <a:pt x="127652" y="495256"/>
                      </a:cubicBezTo>
                      <a:cubicBezTo>
                        <a:pt x="124201" y="547589"/>
                        <a:pt x="62091" y="731044"/>
                        <a:pt x="117300" y="771301"/>
                      </a:cubicBezTo>
                      <a:cubicBezTo>
                        <a:pt x="172509" y="811558"/>
                        <a:pt x="399671" y="777053"/>
                        <a:pt x="458906" y="736796"/>
                      </a:cubicBezTo>
                      <a:cubicBezTo>
                        <a:pt x="518141" y="696539"/>
                        <a:pt x="477885" y="588422"/>
                        <a:pt x="472709" y="529762"/>
                      </a:cubicBezTo>
                      <a:cubicBezTo>
                        <a:pt x="467533" y="471102"/>
                        <a:pt x="436478" y="437699"/>
                        <a:pt x="427851" y="384838"/>
                      </a:cubicBezTo>
                      <a:cubicBezTo>
                        <a:pt x="419225" y="331977"/>
                        <a:pt x="422100" y="252854"/>
                        <a:pt x="420950" y="212597"/>
                      </a:cubicBezTo>
                      <a:cubicBezTo>
                        <a:pt x="419800" y="172340"/>
                        <a:pt x="419420" y="132065"/>
                        <a:pt x="420950" y="143298"/>
                      </a:cubicBezTo>
                      <a:cubicBezTo>
                        <a:pt x="422481" y="154532"/>
                        <a:pt x="424963" y="252221"/>
                        <a:pt x="430133" y="279998"/>
                      </a:cubicBezTo>
                      <a:cubicBezTo>
                        <a:pt x="435303" y="307775"/>
                        <a:pt x="447178" y="296514"/>
                        <a:pt x="451973" y="309962"/>
                      </a:cubicBezTo>
                      <a:cubicBezTo>
                        <a:pt x="456768" y="323410"/>
                        <a:pt x="460051" y="352806"/>
                        <a:pt x="458906" y="360684"/>
                      </a:cubicBezTo>
                      <a:cubicBezTo>
                        <a:pt x="457761" y="368563"/>
                        <a:pt x="446829" y="346881"/>
                        <a:pt x="445104" y="357233"/>
                      </a:cubicBezTo>
                      <a:cubicBezTo>
                        <a:pt x="443379" y="367585"/>
                        <a:pt x="450280" y="404966"/>
                        <a:pt x="448555" y="422794"/>
                      </a:cubicBezTo>
                      <a:cubicBezTo>
                        <a:pt x="446830" y="440622"/>
                        <a:pt x="414050" y="453274"/>
                        <a:pt x="434753" y="464201"/>
                      </a:cubicBezTo>
                      <a:cubicBezTo>
                        <a:pt x="455456" y="475128"/>
                        <a:pt x="548046" y="502157"/>
                        <a:pt x="572775" y="488355"/>
                      </a:cubicBezTo>
                      <a:cubicBezTo>
                        <a:pt x="597504" y="474553"/>
                        <a:pt x="588878" y="417043"/>
                        <a:pt x="583127" y="381387"/>
                      </a:cubicBezTo>
                      <a:cubicBezTo>
                        <a:pt x="577376" y="345731"/>
                        <a:pt x="548620" y="315117"/>
                        <a:pt x="538270" y="274420"/>
                      </a:cubicBezTo>
                      <a:cubicBezTo>
                        <a:pt x="527920" y="233723"/>
                        <a:pt x="531573" y="174574"/>
                        <a:pt x="521025" y="137202"/>
                      </a:cubicBezTo>
                      <a:cubicBezTo>
                        <a:pt x="510477" y="99830"/>
                        <a:pt x="499711" y="73193"/>
                        <a:pt x="474982" y="50189"/>
                      </a:cubicBezTo>
                      <a:cubicBezTo>
                        <a:pt x="450253" y="27185"/>
                        <a:pt x="394909" y="17304"/>
                        <a:pt x="349673" y="9818"/>
                      </a:cubicBezTo>
                      <a:cubicBezTo>
                        <a:pt x="304437" y="2332"/>
                        <a:pt x="246894" y="-5469"/>
                        <a:pt x="203565" y="5276"/>
                      </a:cubicBezTo>
                      <a:close/>
                    </a:path>
                  </a:pathLst>
                </a:custGeom>
                <a:solidFill>
                  <a:srgbClr val="174684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23" name="Oval 22">
                  <a:extLst>
                    <a:ext uri="{FF2B5EF4-FFF2-40B4-BE49-F238E27FC236}">
                      <a16:creationId xmlns:a16="http://schemas.microsoft.com/office/drawing/2014/main" id="{3BC962BE-5D19-F42E-5F1B-1816C91E4507}"/>
                    </a:ext>
                  </a:extLst>
                </p:cNvPr>
                <p:cNvSpPr/>
                <p:nvPr/>
              </p:nvSpPr>
              <p:spPr>
                <a:xfrm>
                  <a:off x="3056824" y="3073108"/>
                  <a:ext cx="1111384" cy="853733"/>
                </a:xfrm>
                <a:prstGeom prst="ellipse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24" name="Freeform 65">
                  <a:extLst>
                    <a:ext uri="{FF2B5EF4-FFF2-40B4-BE49-F238E27FC236}">
                      <a16:creationId xmlns:a16="http://schemas.microsoft.com/office/drawing/2014/main" id="{FFDF16C4-B40D-090E-B789-1738AE6E8CC9}"/>
                    </a:ext>
                  </a:extLst>
                </p:cNvPr>
                <p:cNvSpPr/>
                <p:nvPr/>
              </p:nvSpPr>
              <p:spPr>
                <a:xfrm rot="1220764">
                  <a:off x="3292699" y="3152170"/>
                  <a:ext cx="477204" cy="544954"/>
                </a:xfrm>
                <a:custGeom>
                  <a:avLst/>
                  <a:gdLst>
                    <a:gd name="connsiteX0" fmla="*/ 166254 w 169869"/>
                    <a:gd name="connsiteY0" fmla="*/ 173483 h 173483"/>
                    <a:gd name="connsiteX1" fmla="*/ 0 w 169869"/>
                    <a:gd name="connsiteY1" fmla="*/ 101198 h 173483"/>
                    <a:gd name="connsiteX2" fmla="*/ 169869 w 169869"/>
                    <a:gd name="connsiteY2" fmla="*/ 0 h 173483"/>
                    <a:gd name="connsiteX3" fmla="*/ 166254 w 169869"/>
                    <a:gd name="connsiteY3" fmla="*/ 173483 h 173483"/>
                    <a:gd name="connsiteX0" fmla="*/ 204252 w 207867"/>
                    <a:gd name="connsiteY0" fmla="*/ 173483 h 173483"/>
                    <a:gd name="connsiteX1" fmla="*/ 0 w 207867"/>
                    <a:gd name="connsiteY1" fmla="*/ 134983 h 173483"/>
                    <a:gd name="connsiteX2" fmla="*/ 207867 w 207867"/>
                    <a:gd name="connsiteY2" fmla="*/ 0 h 173483"/>
                    <a:gd name="connsiteX3" fmla="*/ 204252 w 207867"/>
                    <a:gd name="connsiteY3" fmla="*/ 173483 h 173483"/>
                    <a:gd name="connsiteX0" fmla="*/ 341929 w 341929"/>
                    <a:gd name="connsiteY0" fmla="*/ 421278 h 421278"/>
                    <a:gd name="connsiteX1" fmla="*/ 0 w 341929"/>
                    <a:gd name="connsiteY1" fmla="*/ 134983 h 421278"/>
                    <a:gd name="connsiteX2" fmla="*/ 207867 w 341929"/>
                    <a:gd name="connsiteY2" fmla="*/ 0 h 421278"/>
                    <a:gd name="connsiteX3" fmla="*/ 341929 w 341929"/>
                    <a:gd name="connsiteY3" fmla="*/ 421278 h 421278"/>
                    <a:gd name="connsiteX0" fmla="*/ 454656 w 454656"/>
                    <a:gd name="connsiteY0" fmla="*/ 421278 h 421278"/>
                    <a:gd name="connsiteX1" fmla="*/ 0 w 454656"/>
                    <a:gd name="connsiteY1" fmla="*/ 207445 h 421278"/>
                    <a:gd name="connsiteX2" fmla="*/ 320594 w 454656"/>
                    <a:gd name="connsiteY2" fmla="*/ 0 h 421278"/>
                    <a:gd name="connsiteX3" fmla="*/ 454656 w 454656"/>
                    <a:gd name="connsiteY3" fmla="*/ 421278 h 421278"/>
                    <a:gd name="connsiteX0" fmla="*/ 591688 w 591688"/>
                    <a:gd name="connsiteY0" fmla="*/ 421278 h 421278"/>
                    <a:gd name="connsiteX1" fmla="*/ 0 w 591688"/>
                    <a:gd name="connsiteY1" fmla="*/ 377873 h 421278"/>
                    <a:gd name="connsiteX2" fmla="*/ 457626 w 591688"/>
                    <a:gd name="connsiteY2" fmla="*/ 0 h 421278"/>
                    <a:gd name="connsiteX3" fmla="*/ 591688 w 591688"/>
                    <a:gd name="connsiteY3" fmla="*/ 421278 h 421278"/>
                    <a:gd name="connsiteX0" fmla="*/ 443551 w 443551"/>
                    <a:gd name="connsiteY0" fmla="*/ 421278 h 421278"/>
                    <a:gd name="connsiteX1" fmla="*/ 0 w 443551"/>
                    <a:gd name="connsiteY1" fmla="*/ 283180 h 421278"/>
                    <a:gd name="connsiteX2" fmla="*/ 309489 w 443551"/>
                    <a:gd name="connsiteY2" fmla="*/ 0 h 421278"/>
                    <a:gd name="connsiteX3" fmla="*/ 443551 w 443551"/>
                    <a:gd name="connsiteY3" fmla="*/ 421278 h 42127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43551" h="421278">
                      <a:moveTo>
                        <a:pt x="443551" y="421278"/>
                      </a:moveTo>
                      <a:lnTo>
                        <a:pt x="0" y="283180"/>
                      </a:lnTo>
                      <a:lnTo>
                        <a:pt x="309489" y="0"/>
                      </a:lnTo>
                      <a:lnTo>
                        <a:pt x="443551" y="421278"/>
                      </a:lnTo>
                      <a:close/>
                    </a:path>
                  </a:pathLst>
                </a:custGeom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25" name="Freeform 66">
                  <a:extLst>
                    <a:ext uri="{FF2B5EF4-FFF2-40B4-BE49-F238E27FC236}">
                      <a16:creationId xmlns:a16="http://schemas.microsoft.com/office/drawing/2014/main" id="{06C52752-4C11-59A2-9B86-1A0FB616C47E}"/>
                    </a:ext>
                  </a:extLst>
                </p:cNvPr>
                <p:cNvSpPr/>
                <p:nvPr/>
              </p:nvSpPr>
              <p:spPr>
                <a:xfrm>
                  <a:off x="3650454" y="3090236"/>
                  <a:ext cx="276190" cy="670708"/>
                </a:xfrm>
                <a:custGeom>
                  <a:avLst/>
                  <a:gdLst>
                    <a:gd name="connsiteX0" fmla="*/ 249382 w 249382"/>
                    <a:gd name="connsiteY0" fmla="*/ 0 h 327314"/>
                    <a:gd name="connsiteX1" fmla="*/ 244186 w 249382"/>
                    <a:gd name="connsiteY1" fmla="*/ 181841 h 327314"/>
                    <a:gd name="connsiteX2" fmla="*/ 0 w 249382"/>
                    <a:gd name="connsiteY2" fmla="*/ 327314 h 327314"/>
                    <a:gd name="connsiteX3" fmla="*/ 0 w 249382"/>
                    <a:gd name="connsiteY3" fmla="*/ 150668 h 327314"/>
                    <a:gd name="connsiteX4" fmla="*/ 249382 w 249382"/>
                    <a:gd name="connsiteY4" fmla="*/ 0 h 327314"/>
                    <a:gd name="connsiteX0" fmla="*/ 249382 w 321910"/>
                    <a:gd name="connsiteY0" fmla="*/ 0 h 483138"/>
                    <a:gd name="connsiteX1" fmla="*/ 321910 w 321910"/>
                    <a:gd name="connsiteY1" fmla="*/ 483138 h 483138"/>
                    <a:gd name="connsiteX2" fmla="*/ 0 w 321910"/>
                    <a:gd name="connsiteY2" fmla="*/ 327314 h 483138"/>
                    <a:gd name="connsiteX3" fmla="*/ 0 w 321910"/>
                    <a:gd name="connsiteY3" fmla="*/ 150668 h 483138"/>
                    <a:gd name="connsiteX4" fmla="*/ 249382 w 321910"/>
                    <a:gd name="connsiteY4" fmla="*/ 0 h 483138"/>
                    <a:gd name="connsiteX0" fmla="*/ 249382 w 321910"/>
                    <a:gd name="connsiteY0" fmla="*/ 0 h 665132"/>
                    <a:gd name="connsiteX1" fmla="*/ 321910 w 321910"/>
                    <a:gd name="connsiteY1" fmla="*/ 483138 h 665132"/>
                    <a:gd name="connsiteX2" fmla="*/ 73152 w 321910"/>
                    <a:gd name="connsiteY2" fmla="*/ 665132 h 665132"/>
                    <a:gd name="connsiteX3" fmla="*/ 0 w 321910"/>
                    <a:gd name="connsiteY3" fmla="*/ 150668 h 665132"/>
                    <a:gd name="connsiteX4" fmla="*/ 249382 w 321910"/>
                    <a:gd name="connsiteY4" fmla="*/ 0 h 665132"/>
                    <a:gd name="connsiteX0" fmla="*/ 249382 w 321910"/>
                    <a:gd name="connsiteY0" fmla="*/ 0 h 669697"/>
                    <a:gd name="connsiteX1" fmla="*/ 321910 w 321910"/>
                    <a:gd name="connsiteY1" fmla="*/ 483138 h 669697"/>
                    <a:gd name="connsiteX2" fmla="*/ 18288 w 321910"/>
                    <a:gd name="connsiteY2" fmla="*/ 669697 h 669697"/>
                    <a:gd name="connsiteX3" fmla="*/ 0 w 321910"/>
                    <a:gd name="connsiteY3" fmla="*/ 150668 h 669697"/>
                    <a:gd name="connsiteX4" fmla="*/ 249382 w 321910"/>
                    <a:gd name="connsiteY4" fmla="*/ 0 h 669697"/>
                    <a:gd name="connsiteX0" fmla="*/ 249382 w 257902"/>
                    <a:gd name="connsiteY0" fmla="*/ 0 h 669697"/>
                    <a:gd name="connsiteX1" fmla="*/ 257902 w 257902"/>
                    <a:gd name="connsiteY1" fmla="*/ 487703 h 669697"/>
                    <a:gd name="connsiteX2" fmla="*/ 18288 w 257902"/>
                    <a:gd name="connsiteY2" fmla="*/ 669697 h 669697"/>
                    <a:gd name="connsiteX3" fmla="*/ 0 w 257902"/>
                    <a:gd name="connsiteY3" fmla="*/ 150668 h 669697"/>
                    <a:gd name="connsiteX4" fmla="*/ 249382 w 257902"/>
                    <a:gd name="connsiteY4" fmla="*/ 0 h 669697"/>
                    <a:gd name="connsiteX0" fmla="*/ 249382 w 276190"/>
                    <a:gd name="connsiteY0" fmla="*/ 0 h 669697"/>
                    <a:gd name="connsiteX1" fmla="*/ 276190 w 276190"/>
                    <a:gd name="connsiteY1" fmla="*/ 483138 h 669697"/>
                    <a:gd name="connsiteX2" fmla="*/ 18288 w 276190"/>
                    <a:gd name="connsiteY2" fmla="*/ 669697 h 669697"/>
                    <a:gd name="connsiteX3" fmla="*/ 0 w 276190"/>
                    <a:gd name="connsiteY3" fmla="*/ 150668 h 669697"/>
                    <a:gd name="connsiteX4" fmla="*/ 249382 w 276190"/>
                    <a:gd name="connsiteY4" fmla="*/ 0 h 66969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76190" h="669697">
                      <a:moveTo>
                        <a:pt x="249382" y="0"/>
                      </a:moveTo>
                      <a:lnTo>
                        <a:pt x="276190" y="483138"/>
                      </a:lnTo>
                      <a:lnTo>
                        <a:pt x="18288" y="669697"/>
                      </a:lnTo>
                      <a:lnTo>
                        <a:pt x="0" y="150668"/>
                      </a:lnTo>
                      <a:lnTo>
                        <a:pt x="249382" y="0"/>
                      </a:lnTo>
                      <a:close/>
                    </a:path>
                  </a:pathLst>
                </a:cu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27" name="Freeform 67">
                  <a:extLst>
                    <a:ext uri="{FF2B5EF4-FFF2-40B4-BE49-F238E27FC236}">
                      <a16:creationId xmlns:a16="http://schemas.microsoft.com/office/drawing/2014/main" id="{25FEAC4E-9D89-624F-ED39-1BE05DB1B6E1}"/>
                    </a:ext>
                  </a:extLst>
                </p:cNvPr>
                <p:cNvSpPr/>
                <p:nvPr/>
              </p:nvSpPr>
              <p:spPr>
                <a:xfrm>
                  <a:off x="1779178" y="1957029"/>
                  <a:ext cx="3089938" cy="1832661"/>
                </a:xfrm>
                <a:custGeom>
                  <a:avLst/>
                  <a:gdLst>
                    <a:gd name="connsiteX0" fmla="*/ 0 w 3090042"/>
                    <a:gd name="connsiteY0" fmla="*/ 1395248 h 1797269"/>
                    <a:gd name="connsiteX1" fmla="*/ 646386 w 3090042"/>
                    <a:gd name="connsiteY1" fmla="*/ 1797269 h 1797269"/>
                    <a:gd name="connsiteX2" fmla="*/ 3090042 w 3090042"/>
                    <a:gd name="connsiteY2" fmla="*/ 409903 h 1797269"/>
                    <a:gd name="connsiteX3" fmla="*/ 2349062 w 3090042"/>
                    <a:gd name="connsiteY3" fmla="*/ 0 h 1797269"/>
                    <a:gd name="connsiteX4" fmla="*/ 0 w 3090042"/>
                    <a:gd name="connsiteY4" fmla="*/ 1395248 h 17972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3090042" h="1797269">
                      <a:moveTo>
                        <a:pt x="0" y="1395248"/>
                      </a:moveTo>
                      <a:lnTo>
                        <a:pt x="646386" y="1797269"/>
                      </a:lnTo>
                      <a:lnTo>
                        <a:pt x="3090042" y="409903"/>
                      </a:lnTo>
                      <a:lnTo>
                        <a:pt x="2349062" y="0"/>
                      </a:lnTo>
                      <a:lnTo>
                        <a:pt x="0" y="1395248"/>
                      </a:lnTo>
                      <a:close/>
                    </a:path>
                  </a:pathLst>
                </a:cu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3">
                    <a:shade val="50000"/>
                  </a:schemeClr>
                </a:lnRef>
                <a:fillRef idx="1">
                  <a:schemeClr val="accent3"/>
                </a:fillRef>
                <a:effectRef idx="0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28" name="Freeform 68">
                  <a:extLst>
                    <a:ext uri="{FF2B5EF4-FFF2-40B4-BE49-F238E27FC236}">
                      <a16:creationId xmlns:a16="http://schemas.microsoft.com/office/drawing/2014/main" id="{52F52EC0-3336-4F32-EE34-B5FC6268AA01}"/>
                    </a:ext>
                  </a:extLst>
                </p:cNvPr>
                <p:cNvSpPr/>
                <p:nvPr/>
              </p:nvSpPr>
              <p:spPr>
                <a:xfrm>
                  <a:off x="1772348" y="2381199"/>
                  <a:ext cx="3096768" cy="1548384"/>
                </a:xfrm>
                <a:custGeom>
                  <a:avLst/>
                  <a:gdLst>
                    <a:gd name="connsiteX0" fmla="*/ 6096 w 3096768"/>
                    <a:gd name="connsiteY0" fmla="*/ 999744 h 1548384"/>
                    <a:gd name="connsiteX1" fmla="*/ 0 w 3096768"/>
                    <a:gd name="connsiteY1" fmla="*/ 1127760 h 1548384"/>
                    <a:gd name="connsiteX2" fmla="*/ 664464 w 3096768"/>
                    <a:gd name="connsiteY2" fmla="*/ 1548384 h 1548384"/>
                    <a:gd name="connsiteX3" fmla="*/ 670560 w 3096768"/>
                    <a:gd name="connsiteY3" fmla="*/ 1389888 h 1548384"/>
                    <a:gd name="connsiteX4" fmla="*/ 3096768 w 3096768"/>
                    <a:gd name="connsiteY4" fmla="*/ 0 h 1548384"/>
                    <a:gd name="connsiteX5" fmla="*/ 3090672 w 3096768"/>
                    <a:gd name="connsiteY5" fmla="*/ 158496 h 1548384"/>
                    <a:gd name="connsiteX6" fmla="*/ 670560 w 3096768"/>
                    <a:gd name="connsiteY6" fmla="*/ 1548384 h 154838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3096768" h="1548384">
                      <a:moveTo>
                        <a:pt x="6096" y="999744"/>
                      </a:moveTo>
                      <a:lnTo>
                        <a:pt x="0" y="1127760"/>
                      </a:lnTo>
                      <a:lnTo>
                        <a:pt x="664464" y="1548384"/>
                      </a:lnTo>
                      <a:lnTo>
                        <a:pt x="670560" y="1389888"/>
                      </a:lnTo>
                      <a:lnTo>
                        <a:pt x="3096768" y="0"/>
                      </a:lnTo>
                      <a:lnTo>
                        <a:pt x="3090672" y="158496"/>
                      </a:lnTo>
                      <a:lnTo>
                        <a:pt x="670560" y="1548384"/>
                      </a:lnTo>
                    </a:path>
                  </a:pathLst>
                </a:custGeom>
                <a:solidFill>
                  <a:schemeClr val="bg2">
                    <a:lumMod val="9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29" name="Freeform 69">
                  <a:extLst>
                    <a:ext uri="{FF2B5EF4-FFF2-40B4-BE49-F238E27FC236}">
                      <a16:creationId xmlns:a16="http://schemas.microsoft.com/office/drawing/2014/main" id="{603F5A5E-7422-AC51-D0F3-69DC97419D52}"/>
                    </a:ext>
                  </a:extLst>
                </p:cNvPr>
                <p:cNvSpPr/>
                <p:nvPr/>
              </p:nvSpPr>
              <p:spPr>
                <a:xfrm>
                  <a:off x="3893642" y="2140886"/>
                  <a:ext cx="366088" cy="314514"/>
                </a:xfrm>
                <a:custGeom>
                  <a:avLst/>
                  <a:gdLst>
                    <a:gd name="connsiteX0" fmla="*/ 704 w 366088"/>
                    <a:gd name="connsiteY0" fmla="*/ 244810 h 314514"/>
                    <a:gd name="connsiteX1" fmla="*/ 33032 w 366088"/>
                    <a:gd name="connsiteY1" fmla="*/ 203247 h 314514"/>
                    <a:gd name="connsiteX2" fmla="*/ 14559 w 366088"/>
                    <a:gd name="connsiteY2" fmla="*/ 110883 h 314514"/>
                    <a:gd name="connsiteX3" fmla="*/ 46886 w 366088"/>
                    <a:gd name="connsiteY3" fmla="*/ 73938 h 314514"/>
                    <a:gd name="connsiteX4" fmla="*/ 37650 w 366088"/>
                    <a:gd name="connsiteY4" fmla="*/ 50847 h 314514"/>
                    <a:gd name="connsiteX5" fmla="*/ 111541 w 366088"/>
                    <a:gd name="connsiteY5" fmla="*/ 36992 h 314514"/>
                    <a:gd name="connsiteX6" fmla="*/ 185432 w 366088"/>
                    <a:gd name="connsiteY6" fmla="*/ 47 h 314514"/>
                    <a:gd name="connsiteX7" fmla="*/ 305504 w 366088"/>
                    <a:gd name="connsiteY7" fmla="*/ 32374 h 314514"/>
                    <a:gd name="connsiteX8" fmla="*/ 365541 w 366088"/>
                    <a:gd name="connsiteY8" fmla="*/ 147829 h 314514"/>
                    <a:gd name="connsiteX9" fmla="*/ 273177 w 366088"/>
                    <a:gd name="connsiteY9" fmla="*/ 244810 h 314514"/>
                    <a:gd name="connsiteX10" fmla="*/ 226995 w 366088"/>
                    <a:gd name="connsiteY10" fmla="*/ 290992 h 314514"/>
                    <a:gd name="connsiteX11" fmla="*/ 143868 w 366088"/>
                    <a:gd name="connsiteY11" fmla="*/ 290992 h 314514"/>
                    <a:gd name="connsiteX12" fmla="*/ 69977 w 366088"/>
                    <a:gd name="connsiteY12" fmla="*/ 314083 h 314514"/>
                    <a:gd name="connsiteX13" fmla="*/ 704 w 366088"/>
                    <a:gd name="connsiteY13" fmla="*/ 244810 h 31451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</a:cxnLst>
                  <a:rect l="l" t="t" r="r" b="b"/>
                  <a:pathLst>
                    <a:path w="366088" h="314514">
                      <a:moveTo>
                        <a:pt x="704" y="244810"/>
                      </a:moveTo>
                      <a:cubicBezTo>
                        <a:pt x="-5453" y="226337"/>
                        <a:pt x="30723" y="225568"/>
                        <a:pt x="33032" y="203247"/>
                      </a:cubicBezTo>
                      <a:cubicBezTo>
                        <a:pt x="35341" y="180926"/>
                        <a:pt x="12250" y="132434"/>
                        <a:pt x="14559" y="110883"/>
                      </a:cubicBezTo>
                      <a:cubicBezTo>
                        <a:pt x="16868" y="89331"/>
                        <a:pt x="46886" y="73938"/>
                        <a:pt x="46886" y="73938"/>
                      </a:cubicBezTo>
                      <a:cubicBezTo>
                        <a:pt x="50735" y="63932"/>
                        <a:pt x="26874" y="57005"/>
                        <a:pt x="37650" y="50847"/>
                      </a:cubicBezTo>
                      <a:cubicBezTo>
                        <a:pt x="48426" y="44689"/>
                        <a:pt x="86911" y="45459"/>
                        <a:pt x="111541" y="36992"/>
                      </a:cubicBezTo>
                      <a:cubicBezTo>
                        <a:pt x="136171" y="28525"/>
                        <a:pt x="153105" y="817"/>
                        <a:pt x="185432" y="47"/>
                      </a:cubicBezTo>
                      <a:cubicBezTo>
                        <a:pt x="217759" y="-723"/>
                        <a:pt x="275486" y="7744"/>
                        <a:pt x="305504" y="32374"/>
                      </a:cubicBezTo>
                      <a:cubicBezTo>
                        <a:pt x="335522" y="57004"/>
                        <a:pt x="370929" y="112423"/>
                        <a:pt x="365541" y="147829"/>
                      </a:cubicBezTo>
                      <a:cubicBezTo>
                        <a:pt x="360153" y="183235"/>
                        <a:pt x="296268" y="220950"/>
                        <a:pt x="273177" y="244810"/>
                      </a:cubicBezTo>
                      <a:cubicBezTo>
                        <a:pt x="250086" y="268670"/>
                        <a:pt x="248546" y="283295"/>
                        <a:pt x="226995" y="290992"/>
                      </a:cubicBezTo>
                      <a:cubicBezTo>
                        <a:pt x="205444" y="298689"/>
                        <a:pt x="170038" y="287144"/>
                        <a:pt x="143868" y="290992"/>
                      </a:cubicBezTo>
                      <a:cubicBezTo>
                        <a:pt x="117698" y="294840"/>
                        <a:pt x="89989" y="317932"/>
                        <a:pt x="69977" y="314083"/>
                      </a:cubicBezTo>
                      <a:cubicBezTo>
                        <a:pt x="49965" y="310235"/>
                        <a:pt x="6861" y="263283"/>
                        <a:pt x="704" y="244810"/>
                      </a:cubicBezTo>
                      <a:close/>
                    </a:path>
                  </a:pathLst>
                </a:custGeom>
                <a:solidFill>
                  <a:srgbClr val="F1C1B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30" name="Freeform 70">
                  <a:extLst>
                    <a:ext uri="{FF2B5EF4-FFF2-40B4-BE49-F238E27FC236}">
                      <a16:creationId xmlns:a16="http://schemas.microsoft.com/office/drawing/2014/main" id="{EC975B53-73D7-072F-F36A-25A4AF42407B}"/>
                    </a:ext>
                  </a:extLst>
                </p:cNvPr>
                <p:cNvSpPr/>
                <p:nvPr/>
              </p:nvSpPr>
              <p:spPr>
                <a:xfrm>
                  <a:off x="2385728" y="2353609"/>
                  <a:ext cx="1690958" cy="1064434"/>
                </a:xfrm>
                <a:custGeom>
                  <a:avLst/>
                  <a:gdLst>
                    <a:gd name="connsiteX0" fmla="*/ 1656919 w 1690958"/>
                    <a:gd name="connsiteY0" fmla="*/ 108213 h 1064434"/>
                    <a:gd name="connsiteX1" fmla="*/ 1686608 w 1690958"/>
                    <a:gd name="connsiteY1" fmla="*/ 209153 h 1064434"/>
                    <a:gd name="connsiteX2" fmla="*/ 1573792 w 1690958"/>
                    <a:gd name="connsiteY2" fmla="*/ 411034 h 1064434"/>
                    <a:gd name="connsiteX3" fmla="*/ 1342223 w 1690958"/>
                    <a:gd name="connsiteY3" fmla="*/ 529787 h 1064434"/>
                    <a:gd name="connsiteX4" fmla="*/ 1075028 w 1690958"/>
                    <a:gd name="connsiteY4" fmla="*/ 630727 h 1064434"/>
                    <a:gd name="connsiteX5" fmla="*/ 950337 w 1690958"/>
                    <a:gd name="connsiteY5" fmla="*/ 660416 h 1064434"/>
                    <a:gd name="connsiteX6" fmla="*/ 997839 w 1690958"/>
                    <a:gd name="connsiteY6" fmla="*/ 583226 h 1064434"/>
                    <a:gd name="connsiteX7" fmla="*/ 1075028 w 1690958"/>
                    <a:gd name="connsiteY7" fmla="*/ 601039 h 1064434"/>
                    <a:gd name="connsiteX8" fmla="*/ 1045340 w 1690958"/>
                    <a:gd name="connsiteY8" fmla="*/ 541662 h 1064434"/>
                    <a:gd name="connsiteX9" fmla="*/ 1122530 w 1690958"/>
                    <a:gd name="connsiteY9" fmla="*/ 553538 h 1064434"/>
                    <a:gd name="connsiteX10" fmla="*/ 1146280 w 1690958"/>
                    <a:gd name="connsiteY10" fmla="*/ 500099 h 1064434"/>
                    <a:gd name="connsiteX11" fmla="*/ 1354098 w 1690958"/>
                    <a:gd name="connsiteY11" fmla="*/ 399158 h 1064434"/>
                    <a:gd name="connsiteX12" fmla="*/ 1437226 w 1690958"/>
                    <a:gd name="connsiteY12" fmla="*/ 357595 h 1064434"/>
                    <a:gd name="connsiteX13" fmla="*/ 1520353 w 1690958"/>
                    <a:gd name="connsiteY13" fmla="*/ 215091 h 1064434"/>
                    <a:gd name="connsiteX14" fmla="*/ 1431288 w 1690958"/>
                    <a:gd name="connsiteY14" fmla="*/ 339782 h 1064434"/>
                    <a:gd name="connsiteX15" fmla="*/ 1276909 w 1690958"/>
                    <a:gd name="connsiteY15" fmla="*/ 434784 h 1064434"/>
                    <a:gd name="connsiteX16" fmla="*/ 1164093 w 1690958"/>
                    <a:gd name="connsiteY16" fmla="*/ 470410 h 1064434"/>
                    <a:gd name="connsiteX17" fmla="*/ 968150 w 1690958"/>
                    <a:gd name="connsiteY17" fmla="*/ 565413 h 1064434"/>
                    <a:gd name="connsiteX18" fmla="*/ 795958 w 1690958"/>
                    <a:gd name="connsiteY18" fmla="*/ 725730 h 1064434"/>
                    <a:gd name="connsiteX19" fmla="*/ 546576 w 1690958"/>
                    <a:gd name="connsiteY19" fmla="*/ 945423 h 1064434"/>
                    <a:gd name="connsiteX20" fmla="*/ 255631 w 1690958"/>
                    <a:gd name="connsiteY20" fmla="*/ 1064177 h 1064434"/>
                    <a:gd name="connsiteX21" fmla="*/ 311 w 1690958"/>
                    <a:gd name="connsiteY21" fmla="*/ 915735 h 1064434"/>
                    <a:gd name="connsiteX22" fmla="*/ 214067 w 1690958"/>
                    <a:gd name="connsiteY22" fmla="*/ 618852 h 1064434"/>
                    <a:gd name="connsiteX23" fmla="*/ 665330 w 1690958"/>
                    <a:gd name="connsiteY23" fmla="*/ 422909 h 1064434"/>
                    <a:gd name="connsiteX24" fmla="*/ 974088 w 1690958"/>
                    <a:gd name="connsiteY24" fmla="*/ 244779 h 1064434"/>
                    <a:gd name="connsiteX25" fmla="*/ 1086904 w 1690958"/>
                    <a:gd name="connsiteY25" fmla="*/ 155714 h 1064434"/>
                    <a:gd name="connsiteX26" fmla="*/ 1265034 w 1690958"/>
                    <a:gd name="connsiteY26" fmla="*/ 78525 h 1064434"/>
                    <a:gd name="connsiteX27" fmla="*/ 1187844 w 1690958"/>
                    <a:gd name="connsiteY27" fmla="*/ 96338 h 1064434"/>
                    <a:gd name="connsiteX28" fmla="*/ 1057215 w 1690958"/>
                    <a:gd name="connsiteY28" fmla="*/ 155714 h 1064434"/>
                    <a:gd name="connsiteX29" fmla="*/ 962213 w 1690958"/>
                    <a:gd name="connsiteY29" fmla="*/ 250717 h 1064434"/>
                    <a:gd name="connsiteX30" fmla="*/ 831584 w 1690958"/>
                    <a:gd name="connsiteY30" fmla="*/ 304156 h 1064434"/>
                    <a:gd name="connsiteX31" fmla="*/ 807834 w 1690958"/>
                    <a:gd name="connsiteY31" fmla="*/ 339782 h 1064434"/>
                    <a:gd name="connsiteX32" fmla="*/ 778145 w 1690958"/>
                    <a:gd name="connsiteY32" fmla="*/ 310093 h 1064434"/>
                    <a:gd name="connsiteX33" fmla="*/ 754395 w 1690958"/>
                    <a:gd name="connsiteY33" fmla="*/ 369470 h 1064434"/>
                    <a:gd name="connsiteX34" fmla="*/ 635641 w 1690958"/>
                    <a:gd name="connsiteY34" fmla="*/ 411034 h 1064434"/>
                    <a:gd name="connsiteX35" fmla="*/ 736582 w 1690958"/>
                    <a:gd name="connsiteY35" fmla="*/ 268530 h 1064434"/>
                    <a:gd name="connsiteX36" fmla="*/ 861273 w 1690958"/>
                    <a:gd name="connsiteY36" fmla="*/ 226966 h 1064434"/>
                    <a:gd name="connsiteX37" fmla="*/ 1009714 w 1690958"/>
                    <a:gd name="connsiteY37" fmla="*/ 131964 h 1064434"/>
                    <a:gd name="connsiteX38" fmla="*/ 1187844 w 1690958"/>
                    <a:gd name="connsiteY38" fmla="*/ 42899 h 1064434"/>
                    <a:gd name="connsiteX39" fmla="*/ 1300660 w 1690958"/>
                    <a:gd name="connsiteY39" fmla="*/ 1335 h 1064434"/>
                    <a:gd name="connsiteX40" fmla="*/ 1425350 w 1690958"/>
                    <a:gd name="connsiteY40" fmla="*/ 13210 h 1064434"/>
                    <a:gd name="connsiteX41" fmla="*/ 1502540 w 1690958"/>
                    <a:gd name="connsiteY41" fmla="*/ 42899 h 1064434"/>
                    <a:gd name="connsiteX42" fmla="*/ 1656919 w 1690958"/>
                    <a:gd name="connsiteY42" fmla="*/ 108213 h 106443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</a:cxnLst>
                  <a:rect l="l" t="t" r="r" b="b"/>
                  <a:pathLst>
                    <a:path w="1690958" h="1064434">
                      <a:moveTo>
                        <a:pt x="1656919" y="108213"/>
                      </a:moveTo>
                      <a:cubicBezTo>
                        <a:pt x="1678690" y="133448"/>
                        <a:pt x="1700462" y="158683"/>
                        <a:pt x="1686608" y="209153"/>
                      </a:cubicBezTo>
                      <a:cubicBezTo>
                        <a:pt x="1672754" y="259623"/>
                        <a:pt x="1631190" y="357595"/>
                        <a:pt x="1573792" y="411034"/>
                      </a:cubicBezTo>
                      <a:cubicBezTo>
                        <a:pt x="1516394" y="464473"/>
                        <a:pt x="1425350" y="493172"/>
                        <a:pt x="1342223" y="529787"/>
                      </a:cubicBezTo>
                      <a:cubicBezTo>
                        <a:pt x="1259096" y="566403"/>
                        <a:pt x="1140342" y="608956"/>
                        <a:pt x="1075028" y="630727"/>
                      </a:cubicBezTo>
                      <a:cubicBezTo>
                        <a:pt x="1009714" y="652498"/>
                        <a:pt x="963202" y="668333"/>
                        <a:pt x="950337" y="660416"/>
                      </a:cubicBezTo>
                      <a:cubicBezTo>
                        <a:pt x="937472" y="652499"/>
                        <a:pt x="977057" y="593122"/>
                        <a:pt x="997839" y="583226"/>
                      </a:cubicBezTo>
                      <a:cubicBezTo>
                        <a:pt x="1018621" y="573330"/>
                        <a:pt x="1067111" y="607966"/>
                        <a:pt x="1075028" y="601039"/>
                      </a:cubicBezTo>
                      <a:cubicBezTo>
                        <a:pt x="1082945" y="594112"/>
                        <a:pt x="1037423" y="549579"/>
                        <a:pt x="1045340" y="541662"/>
                      </a:cubicBezTo>
                      <a:cubicBezTo>
                        <a:pt x="1053257" y="533745"/>
                        <a:pt x="1105707" y="560465"/>
                        <a:pt x="1122530" y="553538"/>
                      </a:cubicBezTo>
                      <a:cubicBezTo>
                        <a:pt x="1139353" y="546611"/>
                        <a:pt x="1107685" y="525829"/>
                        <a:pt x="1146280" y="500099"/>
                      </a:cubicBezTo>
                      <a:cubicBezTo>
                        <a:pt x="1184875" y="474369"/>
                        <a:pt x="1305607" y="422909"/>
                        <a:pt x="1354098" y="399158"/>
                      </a:cubicBezTo>
                      <a:cubicBezTo>
                        <a:pt x="1402589" y="375407"/>
                        <a:pt x="1409517" y="388273"/>
                        <a:pt x="1437226" y="357595"/>
                      </a:cubicBezTo>
                      <a:cubicBezTo>
                        <a:pt x="1464935" y="326917"/>
                        <a:pt x="1521343" y="218060"/>
                        <a:pt x="1520353" y="215091"/>
                      </a:cubicBezTo>
                      <a:cubicBezTo>
                        <a:pt x="1519363" y="212122"/>
                        <a:pt x="1471862" y="303166"/>
                        <a:pt x="1431288" y="339782"/>
                      </a:cubicBezTo>
                      <a:cubicBezTo>
                        <a:pt x="1390714" y="376398"/>
                        <a:pt x="1321441" y="413013"/>
                        <a:pt x="1276909" y="434784"/>
                      </a:cubicBezTo>
                      <a:cubicBezTo>
                        <a:pt x="1232377" y="456555"/>
                        <a:pt x="1215553" y="448639"/>
                        <a:pt x="1164093" y="470410"/>
                      </a:cubicBezTo>
                      <a:cubicBezTo>
                        <a:pt x="1112633" y="492181"/>
                        <a:pt x="1029506" y="522860"/>
                        <a:pt x="968150" y="565413"/>
                      </a:cubicBezTo>
                      <a:cubicBezTo>
                        <a:pt x="906794" y="607966"/>
                        <a:pt x="866220" y="662395"/>
                        <a:pt x="795958" y="725730"/>
                      </a:cubicBezTo>
                      <a:cubicBezTo>
                        <a:pt x="725696" y="789065"/>
                        <a:pt x="636630" y="889015"/>
                        <a:pt x="546576" y="945423"/>
                      </a:cubicBezTo>
                      <a:cubicBezTo>
                        <a:pt x="456521" y="1001831"/>
                        <a:pt x="346675" y="1069125"/>
                        <a:pt x="255631" y="1064177"/>
                      </a:cubicBezTo>
                      <a:cubicBezTo>
                        <a:pt x="164587" y="1059229"/>
                        <a:pt x="7238" y="989956"/>
                        <a:pt x="311" y="915735"/>
                      </a:cubicBezTo>
                      <a:cubicBezTo>
                        <a:pt x="-6616" y="841514"/>
                        <a:pt x="103231" y="700990"/>
                        <a:pt x="214067" y="618852"/>
                      </a:cubicBezTo>
                      <a:cubicBezTo>
                        <a:pt x="324903" y="536714"/>
                        <a:pt x="538660" y="485254"/>
                        <a:pt x="665330" y="422909"/>
                      </a:cubicBezTo>
                      <a:cubicBezTo>
                        <a:pt x="792000" y="360564"/>
                        <a:pt x="903826" y="289312"/>
                        <a:pt x="974088" y="244779"/>
                      </a:cubicBezTo>
                      <a:cubicBezTo>
                        <a:pt x="1044350" y="200247"/>
                        <a:pt x="1038413" y="183423"/>
                        <a:pt x="1086904" y="155714"/>
                      </a:cubicBezTo>
                      <a:cubicBezTo>
                        <a:pt x="1135395" y="128005"/>
                        <a:pt x="1248211" y="88421"/>
                        <a:pt x="1265034" y="78525"/>
                      </a:cubicBezTo>
                      <a:cubicBezTo>
                        <a:pt x="1281857" y="68629"/>
                        <a:pt x="1222480" y="83473"/>
                        <a:pt x="1187844" y="96338"/>
                      </a:cubicBezTo>
                      <a:cubicBezTo>
                        <a:pt x="1153208" y="109203"/>
                        <a:pt x="1094820" y="129984"/>
                        <a:pt x="1057215" y="155714"/>
                      </a:cubicBezTo>
                      <a:cubicBezTo>
                        <a:pt x="1019610" y="181444"/>
                        <a:pt x="999818" y="225977"/>
                        <a:pt x="962213" y="250717"/>
                      </a:cubicBezTo>
                      <a:cubicBezTo>
                        <a:pt x="924608" y="275457"/>
                        <a:pt x="857314" y="289312"/>
                        <a:pt x="831584" y="304156"/>
                      </a:cubicBezTo>
                      <a:cubicBezTo>
                        <a:pt x="805854" y="319000"/>
                        <a:pt x="807834" y="339782"/>
                        <a:pt x="807834" y="339782"/>
                      </a:cubicBezTo>
                      <a:cubicBezTo>
                        <a:pt x="798927" y="340772"/>
                        <a:pt x="787051" y="305145"/>
                        <a:pt x="778145" y="310093"/>
                      </a:cubicBezTo>
                      <a:cubicBezTo>
                        <a:pt x="769238" y="315041"/>
                        <a:pt x="778146" y="352647"/>
                        <a:pt x="754395" y="369470"/>
                      </a:cubicBezTo>
                      <a:cubicBezTo>
                        <a:pt x="730644" y="386294"/>
                        <a:pt x="638610" y="427857"/>
                        <a:pt x="635641" y="411034"/>
                      </a:cubicBezTo>
                      <a:cubicBezTo>
                        <a:pt x="632672" y="394211"/>
                        <a:pt x="698977" y="299208"/>
                        <a:pt x="736582" y="268530"/>
                      </a:cubicBezTo>
                      <a:cubicBezTo>
                        <a:pt x="774187" y="237852"/>
                        <a:pt x="815751" y="249727"/>
                        <a:pt x="861273" y="226966"/>
                      </a:cubicBezTo>
                      <a:cubicBezTo>
                        <a:pt x="906795" y="204205"/>
                        <a:pt x="955286" y="162642"/>
                        <a:pt x="1009714" y="131964"/>
                      </a:cubicBezTo>
                      <a:cubicBezTo>
                        <a:pt x="1064142" y="101286"/>
                        <a:pt x="1139353" y="64670"/>
                        <a:pt x="1187844" y="42899"/>
                      </a:cubicBezTo>
                      <a:cubicBezTo>
                        <a:pt x="1236335" y="21127"/>
                        <a:pt x="1261076" y="6283"/>
                        <a:pt x="1300660" y="1335"/>
                      </a:cubicBezTo>
                      <a:cubicBezTo>
                        <a:pt x="1340244" y="-3613"/>
                        <a:pt x="1391703" y="6283"/>
                        <a:pt x="1425350" y="13210"/>
                      </a:cubicBezTo>
                      <a:cubicBezTo>
                        <a:pt x="1458997" y="20137"/>
                        <a:pt x="1502540" y="42899"/>
                        <a:pt x="1502540" y="42899"/>
                      </a:cubicBezTo>
                      <a:lnTo>
                        <a:pt x="1656919" y="108213"/>
                      </a:lnTo>
                      <a:close/>
                    </a:path>
                  </a:pathLst>
                </a:custGeom>
                <a:solidFill>
                  <a:srgbClr val="F1C1B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31" name="Freeform 71">
                  <a:extLst>
                    <a:ext uri="{FF2B5EF4-FFF2-40B4-BE49-F238E27FC236}">
                      <a16:creationId xmlns:a16="http://schemas.microsoft.com/office/drawing/2014/main" id="{FBA29EE9-18A4-4631-0373-AE7C400C8C40}"/>
                    </a:ext>
                  </a:extLst>
                </p:cNvPr>
                <p:cNvSpPr/>
                <p:nvPr/>
              </p:nvSpPr>
              <p:spPr>
                <a:xfrm>
                  <a:off x="1799255" y="2455975"/>
                  <a:ext cx="2129318" cy="1643712"/>
                </a:xfrm>
                <a:custGeom>
                  <a:avLst/>
                  <a:gdLst>
                    <a:gd name="connsiteX0" fmla="*/ 2103805 w 2129318"/>
                    <a:gd name="connsiteY0" fmla="*/ 629816 h 1643712"/>
                    <a:gd name="connsiteX1" fmla="*/ 2103805 w 2129318"/>
                    <a:gd name="connsiteY1" fmla="*/ 440890 h 1643712"/>
                    <a:gd name="connsiteX2" fmla="*/ 1907323 w 2129318"/>
                    <a:gd name="connsiteY2" fmla="*/ 327535 h 1643712"/>
                    <a:gd name="connsiteX3" fmla="*/ 1778853 w 2129318"/>
                    <a:gd name="connsiteY3" fmla="*/ 221736 h 1643712"/>
                    <a:gd name="connsiteX4" fmla="*/ 1597485 w 2129318"/>
                    <a:gd name="connsiteY4" fmla="*/ 40368 h 1643712"/>
                    <a:gd name="connsiteX5" fmla="*/ 1461458 w 2129318"/>
                    <a:gd name="connsiteY5" fmla="*/ 10140 h 1643712"/>
                    <a:gd name="connsiteX6" fmla="*/ 1174291 w 2129318"/>
                    <a:gd name="connsiteY6" fmla="*/ 176394 h 1643712"/>
                    <a:gd name="connsiteX7" fmla="*/ 788883 w 2129318"/>
                    <a:gd name="connsiteY7" fmla="*/ 440890 h 1643712"/>
                    <a:gd name="connsiteX8" fmla="*/ 297676 w 2129318"/>
                    <a:gd name="connsiteY8" fmla="*/ 796070 h 1643712"/>
                    <a:gd name="connsiteX9" fmla="*/ 78523 w 2129318"/>
                    <a:gd name="connsiteY9" fmla="*/ 962325 h 1643712"/>
                    <a:gd name="connsiteX10" fmla="*/ 18066 w 2129318"/>
                    <a:gd name="connsiteY10" fmla="*/ 1075680 h 1643712"/>
                    <a:gd name="connsiteX11" fmla="*/ 33180 w 2129318"/>
                    <a:gd name="connsiteY11" fmla="*/ 1219264 h 1643712"/>
                    <a:gd name="connsiteX12" fmla="*/ 373247 w 2129318"/>
                    <a:gd name="connsiteY12" fmla="*/ 1362847 h 1643712"/>
                    <a:gd name="connsiteX13" fmla="*/ 599957 w 2129318"/>
                    <a:gd name="connsiteY13" fmla="*/ 1551773 h 1643712"/>
                    <a:gd name="connsiteX14" fmla="*/ 766212 w 2129318"/>
                    <a:gd name="connsiteY14" fmla="*/ 1627343 h 1643712"/>
                    <a:gd name="connsiteX15" fmla="*/ 902238 w 2129318"/>
                    <a:gd name="connsiteY15" fmla="*/ 1241935 h 1643712"/>
                    <a:gd name="connsiteX16" fmla="*/ 1348103 w 2129318"/>
                    <a:gd name="connsiteY16" fmla="*/ 1022781 h 1643712"/>
                    <a:gd name="connsiteX17" fmla="*/ 1892209 w 2129318"/>
                    <a:gd name="connsiteY17" fmla="*/ 758285 h 1643712"/>
                    <a:gd name="connsiteX18" fmla="*/ 2103805 w 2129318"/>
                    <a:gd name="connsiteY18" fmla="*/ 629816 h 164371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</a:cxnLst>
                  <a:rect l="l" t="t" r="r" b="b"/>
                  <a:pathLst>
                    <a:path w="2129318" h="1643712">
                      <a:moveTo>
                        <a:pt x="2103805" y="629816"/>
                      </a:moveTo>
                      <a:cubicBezTo>
                        <a:pt x="2139071" y="576917"/>
                        <a:pt x="2136552" y="491270"/>
                        <a:pt x="2103805" y="440890"/>
                      </a:cubicBezTo>
                      <a:cubicBezTo>
                        <a:pt x="2071058" y="390510"/>
                        <a:pt x="1961482" y="364061"/>
                        <a:pt x="1907323" y="327535"/>
                      </a:cubicBezTo>
                      <a:cubicBezTo>
                        <a:pt x="1853164" y="291009"/>
                        <a:pt x="1830493" y="269597"/>
                        <a:pt x="1778853" y="221736"/>
                      </a:cubicBezTo>
                      <a:cubicBezTo>
                        <a:pt x="1727213" y="173875"/>
                        <a:pt x="1650384" y="75634"/>
                        <a:pt x="1597485" y="40368"/>
                      </a:cubicBezTo>
                      <a:cubicBezTo>
                        <a:pt x="1544586" y="5102"/>
                        <a:pt x="1531990" y="-12531"/>
                        <a:pt x="1461458" y="10140"/>
                      </a:cubicBezTo>
                      <a:cubicBezTo>
                        <a:pt x="1390926" y="32811"/>
                        <a:pt x="1286387" y="104602"/>
                        <a:pt x="1174291" y="176394"/>
                      </a:cubicBezTo>
                      <a:cubicBezTo>
                        <a:pt x="1062195" y="248186"/>
                        <a:pt x="934985" y="337611"/>
                        <a:pt x="788883" y="440890"/>
                      </a:cubicBezTo>
                      <a:cubicBezTo>
                        <a:pt x="642780" y="544169"/>
                        <a:pt x="416069" y="709164"/>
                        <a:pt x="297676" y="796070"/>
                      </a:cubicBezTo>
                      <a:cubicBezTo>
                        <a:pt x="179283" y="882976"/>
                        <a:pt x="125125" y="915723"/>
                        <a:pt x="78523" y="962325"/>
                      </a:cubicBezTo>
                      <a:cubicBezTo>
                        <a:pt x="31921" y="1008927"/>
                        <a:pt x="25623" y="1032857"/>
                        <a:pt x="18066" y="1075680"/>
                      </a:cubicBezTo>
                      <a:cubicBezTo>
                        <a:pt x="10509" y="1118503"/>
                        <a:pt x="-26017" y="1171403"/>
                        <a:pt x="33180" y="1219264"/>
                      </a:cubicBezTo>
                      <a:cubicBezTo>
                        <a:pt x="92377" y="1267125"/>
                        <a:pt x="278784" y="1307429"/>
                        <a:pt x="373247" y="1362847"/>
                      </a:cubicBezTo>
                      <a:cubicBezTo>
                        <a:pt x="467710" y="1418265"/>
                        <a:pt x="534463" y="1507690"/>
                        <a:pt x="599957" y="1551773"/>
                      </a:cubicBezTo>
                      <a:cubicBezTo>
                        <a:pt x="665451" y="1595856"/>
                        <a:pt x="715832" y="1678983"/>
                        <a:pt x="766212" y="1627343"/>
                      </a:cubicBezTo>
                      <a:cubicBezTo>
                        <a:pt x="816592" y="1575703"/>
                        <a:pt x="805256" y="1342695"/>
                        <a:pt x="902238" y="1241935"/>
                      </a:cubicBezTo>
                      <a:cubicBezTo>
                        <a:pt x="999220" y="1141175"/>
                        <a:pt x="1348103" y="1022781"/>
                        <a:pt x="1348103" y="1022781"/>
                      </a:cubicBezTo>
                      <a:cubicBezTo>
                        <a:pt x="1513098" y="942173"/>
                        <a:pt x="1771297" y="823779"/>
                        <a:pt x="1892209" y="758285"/>
                      </a:cubicBezTo>
                      <a:cubicBezTo>
                        <a:pt x="2013121" y="692791"/>
                        <a:pt x="2068539" y="682715"/>
                        <a:pt x="2103805" y="629816"/>
                      </a:cubicBezTo>
                      <a:close/>
                    </a:path>
                  </a:pathLst>
                </a:custGeom>
                <a:solidFill>
                  <a:schemeClr val="accent6">
                    <a:lumMod val="60000"/>
                    <a:lumOff val="40000"/>
                  </a:schemeClr>
                </a:solidFill>
                <a:ln w="6350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32" name="Freeform 72">
                  <a:extLst>
                    <a:ext uri="{FF2B5EF4-FFF2-40B4-BE49-F238E27FC236}">
                      <a16:creationId xmlns:a16="http://schemas.microsoft.com/office/drawing/2014/main" id="{EFB6CA6C-2BF0-45C5-7183-388F9861B153}"/>
                    </a:ext>
                  </a:extLst>
                </p:cNvPr>
                <p:cNvSpPr/>
                <p:nvPr/>
              </p:nvSpPr>
              <p:spPr>
                <a:xfrm>
                  <a:off x="1823929" y="3546748"/>
                  <a:ext cx="737417" cy="536749"/>
                </a:xfrm>
                <a:custGeom>
                  <a:avLst/>
                  <a:gdLst>
                    <a:gd name="connsiteX0" fmla="*/ 341016 w 737417"/>
                    <a:gd name="connsiteY0" fmla="*/ 173833 h 536749"/>
                    <a:gd name="connsiteX1" fmla="*/ 38735 w 737417"/>
                    <a:gd name="connsiteY1" fmla="*/ 113377 h 536749"/>
                    <a:gd name="connsiteX2" fmla="*/ 38735 w 737417"/>
                    <a:gd name="connsiteY2" fmla="*/ 21 h 536749"/>
                    <a:gd name="connsiteX3" fmla="*/ 356130 w 737417"/>
                    <a:gd name="connsiteY3" fmla="*/ 105820 h 536749"/>
                    <a:gd name="connsiteX4" fmla="*/ 696196 w 737417"/>
                    <a:gd name="connsiteY4" fmla="*/ 309859 h 536749"/>
                    <a:gd name="connsiteX5" fmla="*/ 733981 w 737417"/>
                    <a:gd name="connsiteY5" fmla="*/ 445886 h 536749"/>
                    <a:gd name="connsiteX6" fmla="*/ 718867 w 737417"/>
                    <a:gd name="connsiteY6" fmla="*/ 536570 h 536749"/>
                    <a:gd name="connsiteX7" fmla="*/ 613068 w 737417"/>
                    <a:gd name="connsiteY7" fmla="*/ 423215 h 536749"/>
                    <a:gd name="connsiteX8" fmla="*/ 529941 w 737417"/>
                    <a:gd name="connsiteY8" fmla="*/ 317416 h 536749"/>
                    <a:gd name="connsiteX9" fmla="*/ 341016 w 737417"/>
                    <a:gd name="connsiteY9" fmla="*/ 173833 h 53674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737417" h="536749">
                      <a:moveTo>
                        <a:pt x="341016" y="173833"/>
                      </a:moveTo>
                      <a:cubicBezTo>
                        <a:pt x="259148" y="139827"/>
                        <a:pt x="89115" y="142346"/>
                        <a:pt x="38735" y="113377"/>
                      </a:cubicBezTo>
                      <a:cubicBezTo>
                        <a:pt x="-11645" y="84408"/>
                        <a:pt x="-14164" y="1280"/>
                        <a:pt x="38735" y="21"/>
                      </a:cubicBezTo>
                      <a:cubicBezTo>
                        <a:pt x="91634" y="-1238"/>
                        <a:pt x="246553" y="54180"/>
                        <a:pt x="356130" y="105820"/>
                      </a:cubicBezTo>
                      <a:cubicBezTo>
                        <a:pt x="465707" y="157460"/>
                        <a:pt x="633221" y="253181"/>
                        <a:pt x="696196" y="309859"/>
                      </a:cubicBezTo>
                      <a:cubicBezTo>
                        <a:pt x="759171" y="366537"/>
                        <a:pt x="730203" y="408101"/>
                        <a:pt x="733981" y="445886"/>
                      </a:cubicBezTo>
                      <a:cubicBezTo>
                        <a:pt x="737759" y="483671"/>
                        <a:pt x="739019" y="540348"/>
                        <a:pt x="718867" y="536570"/>
                      </a:cubicBezTo>
                      <a:cubicBezTo>
                        <a:pt x="698715" y="532792"/>
                        <a:pt x="644556" y="459741"/>
                        <a:pt x="613068" y="423215"/>
                      </a:cubicBezTo>
                      <a:cubicBezTo>
                        <a:pt x="581580" y="386689"/>
                        <a:pt x="570245" y="356461"/>
                        <a:pt x="529941" y="317416"/>
                      </a:cubicBezTo>
                      <a:cubicBezTo>
                        <a:pt x="489637" y="278371"/>
                        <a:pt x="422884" y="207839"/>
                        <a:pt x="341016" y="173833"/>
                      </a:cubicBezTo>
                      <a:close/>
                    </a:path>
                  </a:pathLst>
                </a:custGeom>
                <a:solidFill>
                  <a:srgbClr val="779568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33" name="Freeform 73">
                  <a:extLst>
                    <a:ext uri="{FF2B5EF4-FFF2-40B4-BE49-F238E27FC236}">
                      <a16:creationId xmlns:a16="http://schemas.microsoft.com/office/drawing/2014/main" id="{236D2B8C-A208-CA4F-BD35-61F094895507}"/>
                    </a:ext>
                  </a:extLst>
                </p:cNvPr>
                <p:cNvSpPr/>
                <p:nvPr/>
              </p:nvSpPr>
              <p:spPr>
                <a:xfrm>
                  <a:off x="2938319" y="2956625"/>
                  <a:ext cx="958671" cy="580205"/>
                </a:xfrm>
                <a:custGeom>
                  <a:avLst/>
                  <a:gdLst>
                    <a:gd name="connsiteX0" fmla="*/ 942070 w 958671"/>
                    <a:gd name="connsiteY0" fmla="*/ 696 h 580205"/>
                    <a:gd name="connsiteX1" fmla="*/ 926956 w 958671"/>
                    <a:gd name="connsiteY1" fmla="*/ 129166 h 580205"/>
                    <a:gd name="connsiteX2" fmla="*/ 783373 w 958671"/>
                    <a:gd name="connsiteY2" fmla="*/ 219850 h 580205"/>
                    <a:gd name="connsiteX3" fmla="*/ 269495 w 958671"/>
                    <a:gd name="connsiteY3" fmla="*/ 461675 h 580205"/>
                    <a:gd name="connsiteX4" fmla="*/ 4999 w 958671"/>
                    <a:gd name="connsiteY4" fmla="*/ 575030 h 580205"/>
                    <a:gd name="connsiteX5" fmla="*/ 488649 w 958671"/>
                    <a:gd name="connsiteY5" fmla="*/ 302977 h 580205"/>
                    <a:gd name="connsiteX6" fmla="*/ 730474 w 958671"/>
                    <a:gd name="connsiteY6" fmla="*/ 189622 h 580205"/>
                    <a:gd name="connsiteX7" fmla="*/ 942070 w 958671"/>
                    <a:gd name="connsiteY7" fmla="*/ 696 h 58020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</a:cxnLst>
                  <a:rect l="l" t="t" r="r" b="b"/>
                  <a:pathLst>
                    <a:path w="958671" h="580205">
                      <a:moveTo>
                        <a:pt x="942070" y="696"/>
                      </a:moveTo>
                      <a:cubicBezTo>
                        <a:pt x="974817" y="-9380"/>
                        <a:pt x="953405" y="92640"/>
                        <a:pt x="926956" y="129166"/>
                      </a:cubicBezTo>
                      <a:cubicBezTo>
                        <a:pt x="900507" y="165692"/>
                        <a:pt x="892950" y="164432"/>
                        <a:pt x="783373" y="219850"/>
                      </a:cubicBezTo>
                      <a:cubicBezTo>
                        <a:pt x="673796" y="275268"/>
                        <a:pt x="399224" y="402478"/>
                        <a:pt x="269495" y="461675"/>
                      </a:cubicBezTo>
                      <a:cubicBezTo>
                        <a:pt x="139766" y="520872"/>
                        <a:pt x="-31527" y="601480"/>
                        <a:pt x="4999" y="575030"/>
                      </a:cubicBezTo>
                      <a:cubicBezTo>
                        <a:pt x="41525" y="548580"/>
                        <a:pt x="367736" y="367212"/>
                        <a:pt x="488649" y="302977"/>
                      </a:cubicBezTo>
                      <a:cubicBezTo>
                        <a:pt x="609562" y="238742"/>
                        <a:pt x="654904" y="237483"/>
                        <a:pt x="730474" y="189622"/>
                      </a:cubicBezTo>
                      <a:cubicBezTo>
                        <a:pt x="806044" y="141761"/>
                        <a:pt x="909323" y="10772"/>
                        <a:pt x="942070" y="696"/>
                      </a:cubicBezTo>
                      <a:close/>
                    </a:path>
                  </a:pathLst>
                </a:custGeom>
                <a:solidFill>
                  <a:srgbClr val="779568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34" name="Freeform 74">
                  <a:extLst>
                    <a:ext uri="{FF2B5EF4-FFF2-40B4-BE49-F238E27FC236}">
                      <a16:creationId xmlns:a16="http://schemas.microsoft.com/office/drawing/2014/main" id="{EAC9E530-DAE4-B3D6-D88E-3D9541A6B180}"/>
                    </a:ext>
                  </a:extLst>
                </p:cNvPr>
                <p:cNvSpPr/>
                <p:nvPr/>
              </p:nvSpPr>
              <p:spPr>
                <a:xfrm>
                  <a:off x="2346306" y="2963270"/>
                  <a:ext cx="443274" cy="383934"/>
                </a:xfrm>
                <a:custGeom>
                  <a:avLst/>
                  <a:gdLst>
                    <a:gd name="connsiteX0" fmla="*/ 7 w 443274"/>
                    <a:gd name="connsiteY0" fmla="*/ 371903 h 383934"/>
                    <a:gd name="connsiteX1" fmla="*/ 204047 w 443274"/>
                    <a:gd name="connsiteY1" fmla="*/ 303889 h 383934"/>
                    <a:gd name="connsiteX2" fmla="*/ 294731 w 443274"/>
                    <a:gd name="connsiteY2" fmla="*/ 167863 h 383934"/>
                    <a:gd name="connsiteX3" fmla="*/ 332516 w 443274"/>
                    <a:gd name="connsiteY3" fmla="*/ 9165 h 383934"/>
                    <a:gd name="connsiteX4" fmla="*/ 438315 w 443274"/>
                    <a:gd name="connsiteY4" fmla="*/ 31837 h 383934"/>
                    <a:gd name="connsiteX5" fmla="*/ 415644 w 443274"/>
                    <a:gd name="connsiteY5" fmla="*/ 137635 h 383934"/>
                    <a:gd name="connsiteX6" fmla="*/ 324959 w 443274"/>
                    <a:gd name="connsiteY6" fmla="*/ 250990 h 383934"/>
                    <a:gd name="connsiteX7" fmla="*/ 211604 w 443274"/>
                    <a:gd name="connsiteY7" fmla="*/ 371903 h 383934"/>
                    <a:gd name="connsiteX8" fmla="*/ 7 w 443274"/>
                    <a:gd name="connsiteY8" fmla="*/ 371903 h 38393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</a:cxnLst>
                  <a:rect l="l" t="t" r="r" b="b"/>
                  <a:pathLst>
                    <a:path w="443274" h="383934">
                      <a:moveTo>
                        <a:pt x="7" y="371903"/>
                      </a:moveTo>
                      <a:cubicBezTo>
                        <a:pt x="-1253" y="360567"/>
                        <a:pt x="154927" y="337896"/>
                        <a:pt x="204047" y="303889"/>
                      </a:cubicBezTo>
                      <a:cubicBezTo>
                        <a:pt x="253167" y="269882"/>
                        <a:pt x="273320" y="216984"/>
                        <a:pt x="294731" y="167863"/>
                      </a:cubicBezTo>
                      <a:cubicBezTo>
                        <a:pt x="316143" y="118742"/>
                        <a:pt x="308585" y="31836"/>
                        <a:pt x="332516" y="9165"/>
                      </a:cubicBezTo>
                      <a:cubicBezTo>
                        <a:pt x="356447" y="-13506"/>
                        <a:pt x="424460" y="10425"/>
                        <a:pt x="438315" y="31837"/>
                      </a:cubicBezTo>
                      <a:cubicBezTo>
                        <a:pt x="452170" y="53249"/>
                        <a:pt x="434537" y="101110"/>
                        <a:pt x="415644" y="137635"/>
                      </a:cubicBezTo>
                      <a:cubicBezTo>
                        <a:pt x="396751" y="174160"/>
                        <a:pt x="358966" y="211945"/>
                        <a:pt x="324959" y="250990"/>
                      </a:cubicBezTo>
                      <a:cubicBezTo>
                        <a:pt x="290952" y="290035"/>
                        <a:pt x="259465" y="351751"/>
                        <a:pt x="211604" y="371903"/>
                      </a:cubicBezTo>
                      <a:cubicBezTo>
                        <a:pt x="163743" y="392055"/>
                        <a:pt x="1267" y="383239"/>
                        <a:pt x="7" y="371903"/>
                      </a:cubicBezTo>
                      <a:close/>
                    </a:path>
                  </a:pathLst>
                </a:custGeom>
                <a:solidFill>
                  <a:srgbClr val="779568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35" name="Freeform 75">
                  <a:extLst>
                    <a:ext uri="{FF2B5EF4-FFF2-40B4-BE49-F238E27FC236}">
                      <a16:creationId xmlns:a16="http://schemas.microsoft.com/office/drawing/2014/main" id="{38B7B855-12E2-6468-F24F-6D503683CBCE}"/>
                    </a:ext>
                  </a:extLst>
                </p:cNvPr>
                <p:cNvSpPr/>
                <p:nvPr/>
              </p:nvSpPr>
              <p:spPr>
                <a:xfrm>
                  <a:off x="3547761" y="2791040"/>
                  <a:ext cx="111058" cy="55041"/>
                </a:xfrm>
                <a:custGeom>
                  <a:avLst/>
                  <a:gdLst>
                    <a:gd name="connsiteX0" fmla="*/ 105917 w 111058"/>
                    <a:gd name="connsiteY0" fmla="*/ 27 h 55041"/>
                    <a:gd name="connsiteX1" fmla="*/ 119 w 111058"/>
                    <a:gd name="connsiteY1" fmla="*/ 52926 h 55041"/>
                    <a:gd name="connsiteX2" fmla="*/ 83246 w 111058"/>
                    <a:gd name="connsiteY2" fmla="*/ 45369 h 55041"/>
                    <a:gd name="connsiteX3" fmla="*/ 105917 w 111058"/>
                    <a:gd name="connsiteY3" fmla="*/ 27 h 550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058" h="55041">
                      <a:moveTo>
                        <a:pt x="105917" y="27"/>
                      </a:moveTo>
                      <a:cubicBezTo>
                        <a:pt x="92063" y="1286"/>
                        <a:pt x="3898" y="45369"/>
                        <a:pt x="119" y="52926"/>
                      </a:cubicBezTo>
                      <a:cubicBezTo>
                        <a:pt x="-3660" y="60483"/>
                        <a:pt x="83246" y="45369"/>
                        <a:pt x="83246" y="45369"/>
                      </a:cubicBezTo>
                      <a:cubicBezTo>
                        <a:pt x="103398" y="41591"/>
                        <a:pt x="119771" y="-1232"/>
                        <a:pt x="105917" y="27"/>
                      </a:cubicBezTo>
                      <a:close/>
                    </a:path>
                  </a:pathLst>
                </a:custGeom>
                <a:solidFill>
                  <a:srgbClr val="526546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36" name="Freeform 76">
                  <a:extLst>
                    <a:ext uri="{FF2B5EF4-FFF2-40B4-BE49-F238E27FC236}">
                      <a16:creationId xmlns:a16="http://schemas.microsoft.com/office/drawing/2014/main" id="{3AB8D6AC-F906-303A-249E-FE729F559755}"/>
                    </a:ext>
                  </a:extLst>
                </p:cNvPr>
                <p:cNvSpPr/>
                <p:nvPr/>
              </p:nvSpPr>
              <p:spPr>
                <a:xfrm rot="283412">
                  <a:off x="3724915" y="1999287"/>
                  <a:ext cx="1089478" cy="851240"/>
                </a:xfrm>
                <a:custGeom>
                  <a:avLst/>
                  <a:gdLst>
                    <a:gd name="connsiteX0" fmla="*/ 511397 w 1000748"/>
                    <a:gd name="connsiteY0" fmla="*/ 797173 h 799477"/>
                    <a:gd name="connsiteX1" fmla="*/ 417612 w 1000748"/>
                    <a:gd name="connsiteY1" fmla="*/ 698700 h 799477"/>
                    <a:gd name="connsiteX2" fmla="*/ 267557 w 1000748"/>
                    <a:gd name="connsiteY2" fmla="*/ 604915 h 799477"/>
                    <a:gd name="connsiteX3" fmla="*/ 187840 w 1000748"/>
                    <a:gd name="connsiteY3" fmla="*/ 403278 h 799477"/>
                    <a:gd name="connsiteX4" fmla="*/ 42474 w 1000748"/>
                    <a:gd name="connsiteY4" fmla="*/ 286047 h 799477"/>
                    <a:gd name="connsiteX5" fmla="*/ 9649 w 1000748"/>
                    <a:gd name="connsiteY5" fmla="*/ 206330 h 799477"/>
                    <a:gd name="connsiteX6" fmla="*/ 192529 w 1000748"/>
                    <a:gd name="connsiteY6" fmla="*/ 131303 h 799477"/>
                    <a:gd name="connsiteX7" fmla="*/ 323827 w 1000748"/>
                    <a:gd name="connsiteY7" fmla="*/ 4 h 799477"/>
                    <a:gd name="connsiteX8" fmla="*/ 572357 w 1000748"/>
                    <a:gd name="connsiteY8" fmla="*/ 135992 h 799477"/>
                    <a:gd name="connsiteX9" fmla="*/ 914670 w 1000748"/>
                    <a:gd name="connsiteY9" fmla="*/ 347007 h 799477"/>
                    <a:gd name="connsiteX10" fmla="*/ 994387 w 1000748"/>
                    <a:gd name="connsiteY10" fmla="*/ 454860 h 799477"/>
                    <a:gd name="connsiteX11" fmla="*/ 975630 w 1000748"/>
                    <a:gd name="connsiteY11" fmla="*/ 543955 h 799477"/>
                    <a:gd name="connsiteX12" fmla="*/ 816197 w 1000748"/>
                    <a:gd name="connsiteY12" fmla="*/ 595537 h 799477"/>
                    <a:gd name="connsiteX13" fmla="*/ 511397 w 1000748"/>
                    <a:gd name="connsiteY13" fmla="*/ 797173 h 79947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</a:cxnLst>
                  <a:rect l="l" t="t" r="r" b="b"/>
                  <a:pathLst>
                    <a:path w="1000748" h="799477">
                      <a:moveTo>
                        <a:pt x="511397" y="797173"/>
                      </a:moveTo>
                      <a:cubicBezTo>
                        <a:pt x="444966" y="814367"/>
                        <a:pt x="458252" y="730743"/>
                        <a:pt x="417612" y="698700"/>
                      </a:cubicBezTo>
                      <a:cubicBezTo>
                        <a:pt x="376972" y="666657"/>
                        <a:pt x="305852" y="654152"/>
                        <a:pt x="267557" y="604915"/>
                      </a:cubicBezTo>
                      <a:cubicBezTo>
                        <a:pt x="229262" y="555678"/>
                        <a:pt x="225354" y="456423"/>
                        <a:pt x="187840" y="403278"/>
                      </a:cubicBezTo>
                      <a:cubicBezTo>
                        <a:pt x="150326" y="350133"/>
                        <a:pt x="72172" y="318872"/>
                        <a:pt x="42474" y="286047"/>
                      </a:cubicBezTo>
                      <a:cubicBezTo>
                        <a:pt x="12776" y="253222"/>
                        <a:pt x="-15360" y="232121"/>
                        <a:pt x="9649" y="206330"/>
                      </a:cubicBezTo>
                      <a:cubicBezTo>
                        <a:pt x="34658" y="180539"/>
                        <a:pt x="140166" y="165691"/>
                        <a:pt x="192529" y="131303"/>
                      </a:cubicBezTo>
                      <a:cubicBezTo>
                        <a:pt x="244892" y="96915"/>
                        <a:pt x="260522" y="-777"/>
                        <a:pt x="323827" y="4"/>
                      </a:cubicBezTo>
                      <a:cubicBezTo>
                        <a:pt x="387132" y="785"/>
                        <a:pt x="473883" y="78158"/>
                        <a:pt x="572357" y="135992"/>
                      </a:cubicBezTo>
                      <a:cubicBezTo>
                        <a:pt x="670831" y="193826"/>
                        <a:pt x="844332" y="293862"/>
                        <a:pt x="914670" y="347007"/>
                      </a:cubicBezTo>
                      <a:cubicBezTo>
                        <a:pt x="985008" y="400152"/>
                        <a:pt x="984227" y="422035"/>
                        <a:pt x="994387" y="454860"/>
                      </a:cubicBezTo>
                      <a:cubicBezTo>
                        <a:pt x="1004547" y="487685"/>
                        <a:pt x="1005328" y="520509"/>
                        <a:pt x="975630" y="543955"/>
                      </a:cubicBezTo>
                      <a:cubicBezTo>
                        <a:pt x="945932" y="567401"/>
                        <a:pt x="892006" y="552552"/>
                        <a:pt x="816197" y="595537"/>
                      </a:cubicBezTo>
                      <a:cubicBezTo>
                        <a:pt x="740388" y="638522"/>
                        <a:pt x="577828" y="779979"/>
                        <a:pt x="511397" y="797173"/>
                      </a:cubicBezTo>
                      <a:close/>
                    </a:path>
                  </a:pathLst>
                </a:custGeom>
                <a:solidFill>
                  <a:srgbClr val="A9D08E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37" name="Freeform 77">
                  <a:extLst>
                    <a:ext uri="{FF2B5EF4-FFF2-40B4-BE49-F238E27FC236}">
                      <a16:creationId xmlns:a16="http://schemas.microsoft.com/office/drawing/2014/main" id="{7CC0C316-0C93-6833-9FDA-3576E4572609}"/>
                    </a:ext>
                  </a:extLst>
                </p:cNvPr>
                <p:cNvSpPr/>
                <p:nvPr/>
              </p:nvSpPr>
              <p:spPr>
                <a:xfrm>
                  <a:off x="4208574" y="2473568"/>
                  <a:ext cx="539235" cy="348893"/>
                </a:xfrm>
                <a:custGeom>
                  <a:avLst/>
                  <a:gdLst>
                    <a:gd name="connsiteX0" fmla="*/ 59288 w 539235"/>
                    <a:gd name="connsiteY0" fmla="*/ 343511 h 348893"/>
                    <a:gd name="connsiteX1" fmla="*/ 8488 w 539235"/>
                    <a:gd name="connsiteY1" fmla="*/ 318111 h 348893"/>
                    <a:gd name="connsiteX2" fmla="*/ 16954 w 539235"/>
                    <a:gd name="connsiteY2" fmla="*/ 237678 h 348893"/>
                    <a:gd name="connsiteX3" fmla="*/ 169354 w 539235"/>
                    <a:gd name="connsiteY3" fmla="*/ 165711 h 348893"/>
                    <a:gd name="connsiteX4" fmla="*/ 376788 w 539235"/>
                    <a:gd name="connsiteY4" fmla="*/ 119145 h 348893"/>
                    <a:gd name="connsiteX5" fmla="*/ 529188 w 539235"/>
                    <a:gd name="connsiteY5" fmla="*/ 611 h 348893"/>
                    <a:gd name="connsiteX6" fmla="*/ 508021 w 539235"/>
                    <a:gd name="connsiteY6" fmla="*/ 76811 h 348893"/>
                    <a:gd name="connsiteX7" fmla="*/ 372554 w 539235"/>
                    <a:gd name="connsiteY7" fmla="*/ 165711 h 348893"/>
                    <a:gd name="connsiteX8" fmla="*/ 190521 w 539235"/>
                    <a:gd name="connsiteY8" fmla="*/ 220745 h 348893"/>
                    <a:gd name="connsiteX9" fmla="*/ 59288 w 539235"/>
                    <a:gd name="connsiteY9" fmla="*/ 343511 h 3488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539235" h="348893">
                      <a:moveTo>
                        <a:pt x="59288" y="343511"/>
                      </a:moveTo>
                      <a:cubicBezTo>
                        <a:pt x="28949" y="359739"/>
                        <a:pt x="15544" y="335750"/>
                        <a:pt x="8488" y="318111"/>
                      </a:cubicBezTo>
                      <a:cubicBezTo>
                        <a:pt x="1432" y="300472"/>
                        <a:pt x="-9857" y="263078"/>
                        <a:pt x="16954" y="237678"/>
                      </a:cubicBezTo>
                      <a:cubicBezTo>
                        <a:pt x="43765" y="212278"/>
                        <a:pt x="109382" y="185466"/>
                        <a:pt x="169354" y="165711"/>
                      </a:cubicBezTo>
                      <a:cubicBezTo>
                        <a:pt x="229326" y="145955"/>
                        <a:pt x="316816" y="146662"/>
                        <a:pt x="376788" y="119145"/>
                      </a:cubicBezTo>
                      <a:cubicBezTo>
                        <a:pt x="436760" y="91628"/>
                        <a:pt x="507316" y="7667"/>
                        <a:pt x="529188" y="611"/>
                      </a:cubicBezTo>
                      <a:cubicBezTo>
                        <a:pt x="551060" y="-6445"/>
                        <a:pt x="534127" y="49294"/>
                        <a:pt x="508021" y="76811"/>
                      </a:cubicBezTo>
                      <a:cubicBezTo>
                        <a:pt x="481915" y="104328"/>
                        <a:pt x="425471" y="141722"/>
                        <a:pt x="372554" y="165711"/>
                      </a:cubicBezTo>
                      <a:cubicBezTo>
                        <a:pt x="319637" y="189700"/>
                        <a:pt x="242026" y="192523"/>
                        <a:pt x="190521" y="220745"/>
                      </a:cubicBezTo>
                      <a:cubicBezTo>
                        <a:pt x="139016" y="248967"/>
                        <a:pt x="89627" y="327283"/>
                        <a:pt x="59288" y="343511"/>
                      </a:cubicBezTo>
                      <a:close/>
                    </a:path>
                  </a:pathLst>
                </a:custGeom>
                <a:solidFill>
                  <a:srgbClr val="779568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38" name="Freeform 78">
                  <a:extLst>
                    <a:ext uri="{FF2B5EF4-FFF2-40B4-BE49-F238E27FC236}">
                      <a16:creationId xmlns:a16="http://schemas.microsoft.com/office/drawing/2014/main" id="{4152FC67-2651-4604-E195-F6218FEAC4A7}"/>
                    </a:ext>
                  </a:extLst>
                </p:cNvPr>
                <p:cNvSpPr/>
                <p:nvPr/>
              </p:nvSpPr>
              <p:spPr>
                <a:xfrm rot="16002952">
                  <a:off x="3063844" y="1961865"/>
                  <a:ext cx="45943" cy="45719"/>
                </a:xfrm>
                <a:custGeom>
                  <a:avLst/>
                  <a:gdLst>
                    <a:gd name="connsiteX0" fmla="*/ 105917 w 111058"/>
                    <a:gd name="connsiteY0" fmla="*/ 27 h 55041"/>
                    <a:gd name="connsiteX1" fmla="*/ 119 w 111058"/>
                    <a:gd name="connsiteY1" fmla="*/ 52926 h 55041"/>
                    <a:gd name="connsiteX2" fmla="*/ 83246 w 111058"/>
                    <a:gd name="connsiteY2" fmla="*/ 45369 h 55041"/>
                    <a:gd name="connsiteX3" fmla="*/ 105917 w 111058"/>
                    <a:gd name="connsiteY3" fmla="*/ 27 h 550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058" h="55041">
                      <a:moveTo>
                        <a:pt x="105917" y="27"/>
                      </a:moveTo>
                      <a:cubicBezTo>
                        <a:pt x="92063" y="1286"/>
                        <a:pt x="3898" y="45369"/>
                        <a:pt x="119" y="52926"/>
                      </a:cubicBezTo>
                      <a:cubicBezTo>
                        <a:pt x="-3660" y="60483"/>
                        <a:pt x="83246" y="45369"/>
                        <a:pt x="83246" y="45369"/>
                      </a:cubicBezTo>
                      <a:cubicBezTo>
                        <a:pt x="103398" y="41591"/>
                        <a:pt x="119771" y="-1232"/>
                        <a:pt x="105917" y="27"/>
                      </a:cubicBezTo>
                      <a:close/>
                    </a:path>
                  </a:pathLst>
                </a:custGeom>
                <a:solidFill>
                  <a:srgbClr val="113A6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39" name="Freeform 79">
                  <a:extLst>
                    <a:ext uri="{FF2B5EF4-FFF2-40B4-BE49-F238E27FC236}">
                      <a16:creationId xmlns:a16="http://schemas.microsoft.com/office/drawing/2014/main" id="{EC722857-751F-848A-D193-7C3CB35EACF5}"/>
                    </a:ext>
                  </a:extLst>
                </p:cNvPr>
                <p:cNvSpPr/>
                <p:nvPr/>
              </p:nvSpPr>
              <p:spPr>
                <a:xfrm rot="15100730">
                  <a:off x="3003784" y="2232550"/>
                  <a:ext cx="45943" cy="45719"/>
                </a:xfrm>
                <a:custGeom>
                  <a:avLst/>
                  <a:gdLst>
                    <a:gd name="connsiteX0" fmla="*/ 105917 w 111058"/>
                    <a:gd name="connsiteY0" fmla="*/ 27 h 55041"/>
                    <a:gd name="connsiteX1" fmla="*/ 119 w 111058"/>
                    <a:gd name="connsiteY1" fmla="*/ 52926 h 55041"/>
                    <a:gd name="connsiteX2" fmla="*/ 83246 w 111058"/>
                    <a:gd name="connsiteY2" fmla="*/ 45369 h 55041"/>
                    <a:gd name="connsiteX3" fmla="*/ 105917 w 111058"/>
                    <a:gd name="connsiteY3" fmla="*/ 27 h 550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058" h="55041">
                      <a:moveTo>
                        <a:pt x="105917" y="27"/>
                      </a:moveTo>
                      <a:cubicBezTo>
                        <a:pt x="92063" y="1286"/>
                        <a:pt x="3898" y="45369"/>
                        <a:pt x="119" y="52926"/>
                      </a:cubicBezTo>
                      <a:cubicBezTo>
                        <a:pt x="-3660" y="60483"/>
                        <a:pt x="83246" y="45369"/>
                        <a:pt x="83246" y="45369"/>
                      </a:cubicBezTo>
                      <a:cubicBezTo>
                        <a:pt x="103398" y="41591"/>
                        <a:pt x="119771" y="-1232"/>
                        <a:pt x="105917" y="27"/>
                      </a:cubicBezTo>
                      <a:close/>
                    </a:path>
                  </a:pathLst>
                </a:custGeom>
                <a:solidFill>
                  <a:srgbClr val="113A6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40" name="Freeform 80">
                  <a:extLst>
                    <a:ext uri="{FF2B5EF4-FFF2-40B4-BE49-F238E27FC236}">
                      <a16:creationId xmlns:a16="http://schemas.microsoft.com/office/drawing/2014/main" id="{FDC0A9D6-4243-B522-3F41-0AC71C5C4172}"/>
                    </a:ext>
                  </a:extLst>
                </p:cNvPr>
                <p:cNvSpPr/>
                <p:nvPr/>
              </p:nvSpPr>
              <p:spPr>
                <a:xfrm>
                  <a:off x="2951619" y="2298349"/>
                  <a:ext cx="111058" cy="55041"/>
                </a:xfrm>
                <a:custGeom>
                  <a:avLst/>
                  <a:gdLst>
                    <a:gd name="connsiteX0" fmla="*/ 105917 w 111058"/>
                    <a:gd name="connsiteY0" fmla="*/ 27 h 55041"/>
                    <a:gd name="connsiteX1" fmla="*/ 119 w 111058"/>
                    <a:gd name="connsiteY1" fmla="*/ 52926 h 55041"/>
                    <a:gd name="connsiteX2" fmla="*/ 83246 w 111058"/>
                    <a:gd name="connsiteY2" fmla="*/ 45369 h 55041"/>
                    <a:gd name="connsiteX3" fmla="*/ 105917 w 111058"/>
                    <a:gd name="connsiteY3" fmla="*/ 27 h 550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058" h="55041">
                      <a:moveTo>
                        <a:pt x="105917" y="27"/>
                      </a:moveTo>
                      <a:cubicBezTo>
                        <a:pt x="92063" y="1286"/>
                        <a:pt x="3898" y="45369"/>
                        <a:pt x="119" y="52926"/>
                      </a:cubicBezTo>
                      <a:cubicBezTo>
                        <a:pt x="-3660" y="60483"/>
                        <a:pt x="83246" y="45369"/>
                        <a:pt x="83246" y="45369"/>
                      </a:cubicBezTo>
                      <a:cubicBezTo>
                        <a:pt x="103398" y="41591"/>
                        <a:pt x="119771" y="-1232"/>
                        <a:pt x="105917" y="27"/>
                      </a:cubicBezTo>
                      <a:close/>
                    </a:path>
                  </a:pathLst>
                </a:custGeom>
                <a:solidFill>
                  <a:srgbClr val="113A6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41" name="Freeform 81">
                  <a:extLst>
                    <a:ext uri="{FF2B5EF4-FFF2-40B4-BE49-F238E27FC236}">
                      <a16:creationId xmlns:a16="http://schemas.microsoft.com/office/drawing/2014/main" id="{1186F776-3D58-39DB-8F2B-BDA7DFD2E779}"/>
                    </a:ext>
                  </a:extLst>
                </p:cNvPr>
                <p:cNvSpPr/>
                <p:nvPr/>
              </p:nvSpPr>
              <p:spPr>
                <a:xfrm rot="3795015">
                  <a:off x="2932852" y="1990448"/>
                  <a:ext cx="111058" cy="55041"/>
                </a:xfrm>
                <a:custGeom>
                  <a:avLst/>
                  <a:gdLst>
                    <a:gd name="connsiteX0" fmla="*/ 105917 w 111058"/>
                    <a:gd name="connsiteY0" fmla="*/ 27 h 55041"/>
                    <a:gd name="connsiteX1" fmla="*/ 119 w 111058"/>
                    <a:gd name="connsiteY1" fmla="*/ 52926 h 55041"/>
                    <a:gd name="connsiteX2" fmla="*/ 83246 w 111058"/>
                    <a:gd name="connsiteY2" fmla="*/ 45369 h 55041"/>
                    <a:gd name="connsiteX3" fmla="*/ 105917 w 111058"/>
                    <a:gd name="connsiteY3" fmla="*/ 27 h 550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058" h="55041">
                      <a:moveTo>
                        <a:pt x="105917" y="27"/>
                      </a:moveTo>
                      <a:cubicBezTo>
                        <a:pt x="92063" y="1286"/>
                        <a:pt x="3898" y="45369"/>
                        <a:pt x="119" y="52926"/>
                      </a:cubicBezTo>
                      <a:cubicBezTo>
                        <a:pt x="-3660" y="60483"/>
                        <a:pt x="83246" y="45369"/>
                        <a:pt x="83246" y="45369"/>
                      </a:cubicBezTo>
                      <a:cubicBezTo>
                        <a:pt x="103398" y="41591"/>
                        <a:pt x="119771" y="-1232"/>
                        <a:pt x="105917" y="27"/>
                      </a:cubicBezTo>
                      <a:close/>
                    </a:path>
                  </a:pathLst>
                </a:custGeom>
                <a:solidFill>
                  <a:srgbClr val="113A6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42" name="Freeform 82">
                  <a:extLst>
                    <a:ext uri="{FF2B5EF4-FFF2-40B4-BE49-F238E27FC236}">
                      <a16:creationId xmlns:a16="http://schemas.microsoft.com/office/drawing/2014/main" id="{93FE6EDF-CBE9-6AC6-C2FA-C6EDAA1B79C5}"/>
                    </a:ext>
                  </a:extLst>
                </p:cNvPr>
                <p:cNvSpPr/>
                <p:nvPr/>
              </p:nvSpPr>
              <p:spPr>
                <a:xfrm rot="15418727">
                  <a:off x="3428794" y="1900775"/>
                  <a:ext cx="63382" cy="45719"/>
                </a:xfrm>
                <a:custGeom>
                  <a:avLst/>
                  <a:gdLst>
                    <a:gd name="connsiteX0" fmla="*/ 105917 w 111058"/>
                    <a:gd name="connsiteY0" fmla="*/ 27 h 55041"/>
                    <a:gd name="connsiteX1" fmla="*/ 119 w 111058"/>
                    <a:gd name="connsiteY1" fmla="*/ 52926 h 55041"/>
                    <a:gd name="connsiteX2" fmla="*/ 83246 w 111058"/>
                    <a:gd name="connsiteY2" fmla="*/ 45369 h 55041"/>
                    <a:gd name="connsiteX3" fmla="*/ 105917 w 111058"/>
                    <a:gd name="connsiteY3" fmla="*/ 27 h 550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058" h="55041">
                      <a:moveTo>
                        <a:pt x="105917" y="27"/>
                      </a:moveTo>
                      <a:cubicBezTo>
                        <a:pt x="92063" y="1286"/>
                        <a:pt x="3898" y="45369"/>
                        <a:pt x="119" y="52926"/>
                      </a:cubicBezTo>
                      <a:cubicBezTo>
                        <a:pt x="-3660" y="60483"/>
                        <a:pt x="83246" y="45369"/>
                        <a:pt x="83246" y="45369"/>
                      </a:cubicBezTo>
                      <a:cubicBezTo>
                        <a:pt x="103398" y="41591"/>
                        <a:pt x="119771" y="-1232"/>
                        <a:pt x="105917" y="27"/>
                      </a:cubicBezTo>
                      <a:close/>
                    </a:path>
                  </a:pathLst>
                </a:custGeom>
                <a:solidFill>
                  <a:srgbClr val="113A6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43" name="Freeform 83">
                  <a:extLst>
                    <a:ext uri="{FF2B5EF4-FFF2-40B4-BE49-F238E27FC236}">
                      <a16:creationId xmlns:a16="http://schemas.microsoft.com/office/drawing/2014/main" id="{1E1C709C-38EB-454E-029B-327EA8C0D253}"/>
                    </a:ext>
                  </a:extLst>
                </p:cNvPr>
                <p:cNvSpPr/>
                <p:nvPr/>
              </p:nvSpPr>
              <p:spPr>
                <a:xfrm rot="16622775">
                  <a:off x="3514543" y="1978401"/>
                  <a:ext cx="111058" cy="55041"/>
                </a:xfrm>
                <a:custGeom>
                  <a:avLst/>
                  <a:gdLst>
                    <a:gd name="connsiteX0" fmla="*/ 105917 w 111058"/>
                    <a:gd name="connsiteY0" fmla="*/ 27 h 55041"/>
                    <a:gd name="connsiteX1" fmla="*/ 119 w 111058"/>
                    <a:gd name="connsiteY1" fmla="*/ 52926 h 55041"/>
                    <a:gd name="connsiteX2" fmla="*/ 83246 w 111058"/>
                    <a:gd name="connsiteY2" fmla="*/ 45369 h 55041"/>
                    <a:gd name="connsiteX3" fmla="*/ 105917 w 111058"/>
                    <a:gd name="connsiteY3" fmla="*/ 27 h 550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058" h="55041">
                      <a:moveTo>
                        <a:pt x="105917" y="27"/>
                      </a:moveTo>
                      <a:cubicBezTo>
                        <a:pt x="92063" y="1286"/>
                        <a:pt x="3898" y="45369"/>
                        <a:pt x="119" y="52926"/>
                      </a:cubicBezTo>
                      <a:cubicBezTo>
                        <a:pt x="-3660" y="60483"/>
                        <a:pt x="83246" y="45369"/>
                        <a:pt x="83246" y="45369"/>
                      </a:cubicBezTo>
                      <a:cubicBezTo>
                        <a:pt x="103398" y="41591"/>
                        <a:pt x="119771" y="-1232"/>
                        <a:pt x="105917" y="27"/>
                      </a:cubicBezTo>
                      <a:close/>
                    </a:path>
                  </a:pathLst>
                </a:custGeom>
                <a:solidFill>
                  <a:srgbClr val="113A6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44" name="Freeform 84">
                  <a:extLst>
                    <a:ext uri="{FF2B5EF4-FFF2-40B4-BE49-F238E27FC236}">
                      <a16:creationId xmlns:a16="http://schemas.microsoft.com/office/drawing/2014/main" id="{5F9D5F06-E970-B0FE-5D59-00F3D7ACA276}"/>
                    </a:ext>
                  </a:extLst>
                </p:cNvPr>
                <p:cNvSpPr/>
                <p:nvPr/>
              </p:nvSpPr>
              <p:spPr>
                <a:xfrm rot="16002952">
                  <a:off x="3189877" y="1825090"/>
                  <a:ext cx="45943" cy="45719"/>
                </a:xfrm>
                <a:custGeom>
                  <a:avLst/>
                  <a:gdLst>
                    <a:gd name="connsiteX0" fmla="*/ 105917 w 111058"/>
                    <a:gd name="connsiteY0" fmla="*/ 27 h 55041"/>
                    <a:gd name="connsiteX1" fmla="*/ 119 w 111058"/>
                    <a:gd name="connsiteY1" fmla="*/ 52926 h 55041"/>
                    <a:gd name="connsiteX2" fmla="*/ 83246 w 111058"/>
                    <a:gd name="connsiteY2" fmla="*/ 45369 h 55041"/>
                    <a:gd name="connsiteX3" fmla="*/ 105917 w 111058"/>
                    <a:gd name="connsiteY3" fmla="*/ 27 h 550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058" h="55041">
                      <a:moveTo>
                        <a:pt x="105917" y="27"/>
                      </a:moveTo>
                      <a:cubicBezTo>
                        <a:pt x="92063" y="1286"/>
                        <a:pt x="3898" y="45369"/>
                        <a:pt x="119" y="52926"/>
                      </a:cubicBezTo>
                      <a:cubicBezTo>
                        <a:pt x="-3660" y="60483"/>
                        <a:pt x="83246" y="45369"/>
                        <a:pt x="83246" y="45369"/>
                      </a:cubicBezTo>
                      <a:cubicBezTo>
                        <a:pt x="103398" y="41591"/>
                        <a:pt x="119771" y="-1232"/>
                        <a:pt x="105917" y="27"/>
                      </a:cubicBezTo>
                      <a:close/>
                    </a:path>
                  </a:pathLst>
                </a:custGeom>
                <a:solidFill>
                  <a:srgbClr val="113A6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45" name="Freeform 85">
                  <a:extLst>
                    <a:ext uri="{FF2B5EF4-FFF2-40B4-BE49-F238E27FC236}">
                      <a16:creationId xmlns:a16="http://schemas.microsoft.com/office/drawing/2014/main" id="{7FC3A11E-9018-F400-6285-5EFA7CBA2846}"/>
                    </a:ext>
                  </a:extLst>
                </p:cNvPr>
                <p:cNvSpPr/>
                <p:nvPr/>
              </p:nvSpPr>
              <p:spPr>
                <a:xfrm>
                  <a:off x="3217943" y="2282327"/>
                  <a:ext cx="74833" cy="132519"/>
                </a:xfrm>
                <a:custGeom>
                  <a:avLst/>
                  <a:gdLst>
                    <a:gd name="connsiteX0" fmla="*/ 86109 w 86109"/>
                    <a:gd name="connsiteY0" fmla="*/ 9291 h 141227"/>
                    <a:gd name="connsiteX1" fmla="*/ 24603 w 86109"/>
                    <a:gd name="connsiteY1" fmla="*/ 21592 h 141227"/>
                    <a:gd name="connsiteX2" fmla="*/ 0 w 86109"/>
                    <a:gd name="connsiteY2" fmla="*/ 124103 h 141227"/>
                    <a:gd name="connsiteX3" fmla="*/ 24603 w 86109"/>
                    <a:gd name="connsiteY3" fmla="*/ 132304 h 141227"/>
                    <a:gd name="connsiteX4" fmla="*/ 86109 w 86109"/>
                    <a:gd name="connsiteY4" fmla="*/ 9291 h 14122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86109" h="141227">
                      <a:moveTo>
                        <a:pt x="86109" y="9291"/>
                      </a:moveTo>
                      <a:cubicBezTo>
                        <a:pt x="86109" y="-9161"/>
                        <a:pt x="38954" y="2457"/>
                        <a:pt x="24603" y="21592"/>
                      </a:cubicBezTo>
                      <a:cubicBezTo>
                        <a:pt x="10252" y="40727"/>
                        <a:pt x="0" y="124103"/>
                        <a:pt x="0" y="124103"/>
                      </a:cubicBezTo>
                      <a:cubicBezTo>
                        <a:pt x="0" y="142555"/>
                        <a:pt x="10252" y="147339"/>
                        <a:pt x="24603" y="132304"/>
                      </a:cubicBezTo>
                      <a:cubicBezTo>
                        <a:pt x="38954" y="117269"/>
                        <a:pt x="86109" y="27743"/>
                        <a:pt x="86109" y="9291"/>
                      </a:cubicBezTo>
                      <a:close/>
                    </a:path>
                  </a:pathLst>
                </a:custGeom>
                <a:solidFill>
                  <a:srgbClr val="113A6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46" name="Freeform 86">
                  <a:extLst>
                    <a:ext uri="{FF2B5EF4-FFF2-40B4-BE49-F238E27FC236}">
                      <a16:creationId xmlns:a16="http://schemas.microsoft.com/office/drawing/2014/main" id="{31BA0194-132D-178C-A176-92C1BEA9ADCB}"/>
                    </a:ext>
                  </a:extLst>
                </p:cNvPr>
                <p:cNvSpPr/>
                <p:nvPr/>
              </p:nvSpPr>
              <p:spPr>
                <a:xfrm rot="15906806" flipH="1">
                  <a:off x="3538135" y="2232529"/>
                  <a:ext cx="184486" cy="150994"/>
                </a:xfrm>
                <a:custGeom>
                  <a:avLst/>
                  <a:gdLst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736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3768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332367 w 558286"/>
                    <a:gd name="connsiteY12" fmla="*/ 163337 h 359548"/>
                    <a:gd name="connsiteX13" fmla="*/ 424442 w 558286"/>
                    <a:gd name="connsiteY13" fmla="*/ 182387 h 359548"/>
                    <a:gd name="connsiteX14" fmla="*/ 519692 w 558286"/>
                    <a:gd name="connsiteY14" fmla="*/ 220487 h 359548"/>
                    <a:gd name="connsiteX15" fmla="*/ 557792 w 558286"/>
                    <a:gd name="connsiteY15" fmla="*/ 220487 h 359548"/>
                    <a:gd name="connsiteX16" fmla="*/ 529217 w 558286"/>
                    <a:gd name="connsiteY16" fmla="*/ 179212 h 359548"/>
                    <a:gd name="connsiteX17" fmla="*/ 379992 w 558286"/>
                    <a:gd name="connsiteY17" fmla="*/ 144287 h 359548"/>
                    <a:gd name="connsiteX18" fmla="*/ 335542 w 558286"/>
                    <a:gd name="connsiteY18" fmla="*/ 103012 h 359548"/>
                    <a:gd name="connsiteX19" fmla="*/ 427617 w 558286"/>
                    <a:gd name="connsiteY19" fmla="*/ 122062 h 359548"/>
                    <a:gd name="connsiteX20" fmla="*/ 503817 w 558286"/>
                    <a:gd name="connsiteY20" fmla="*/ 150637 h 359548"/>
                    <a:gd name="connsiteX21" fmla="*/ 510167 w 558286"/>
                    <a:gd name="connsiteY21" fmla="*/ 109362 h 359548"/>
                    <a:gd name="connsiteX22" fmla="*/ 411742 w 558286"/>
                    <a:gd name="connsiteY22" fmla="*/ 52212 h 359548"/>
                    <a:gd name="connsiteX23" fmla="*/ 322842 w 558286"/>
                    <a:gd name="connsiteY23" fmla="*/ 23637 h 359548"/>
                    <a:gd name="connsiteX24" fmla="*/ 243467 w 558286"/>
                    <a:gd name="connsiteY24" fmla="*/ 64912 h 359548"/>
                    <a:gd name="connsiteX25" fmla="*/ 205367 w 558286"/>
                    <a:gd name="connsiteY25" fmla="*/ 144287 h 359548"/>
                    <a:gd name="connsiteX26" fmla="*/ 249817 w 558286"/>
                    <a:gd name="connsiteY26" fmla="*/ 55387 h 359548"/>
                    <a:gd name="connsiteX27" fmla="*/ 214892 w 558286"/>
                    <a:gd name="connsiteY27" fmla="*/ 1412 h 359548"/>
                    <a:gd name="connsiteX28" fmla="*/ 97417 w 558286"/>
                    <a:gd name="connsiteY28" fmla="*/ 23637 h 359548"/>
                    <a:gd name="connsiteX29" fmla="*/ 27567 w 558286"/>
                    <a:gd name="connsiteY29" fmla="*/ 106187 h 359548"/>
                    <a:gd name="connsiteX30" fmla="*/ 2167 w 558286"/>
                    <a:gd name="connsiteY30" fmla="*/ 220487 h 359548"/>
                    <a:gd name="connsiteX31" fmla="*/ 78367 w 558286"/>
                    <a:gd name="connsiteY31" fmla="*/ 242712 h 359548"/>
                    <a:gd name="connsiteX32" fmla="*/ 68842 w 558286"/>
                    <a:gd name="connsiteY32" fmla="*/ 188737 h 359548"/>
                    <a:gd name="connsiteX33" fmla="*/ 81542 w 558286"/>
                    <a:gd name="connsiteY33" fmla="*/ 125237 h 359548"/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736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3768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332367 w 558286"/>
                    <a:gd name="connsiteY12" fmla="*/ 163337 h 359548"/>
                    <a:gd name="connsiteX13" fmla="*/ 424442 w 558286"/>
                    <a:gd name="connsiteY13" fmla="*/ 182387 h 359548"/>
                    <a:gd name="connsiteX14" fmla="*/ 519692 w 558286"/>
                    <a:gd name="connsiteY14" fmla="*/ 220487 h 359548"/>
                    <a:gd name="connsiteX15" fmla="*/ 557792 w 558286"/>
                    <a:gd name="connsiteY15" fmla="*/ 220487 h 359548"/>
                    <a:gd name="connsiteX16" fmla="*/ 529217 w 558286"/>
                    <a:gd name="connsiteY16" fmla="*/ 179212 h 359548"/>
                    <a:gd name="connsiteX17" fmla="*/ 379992 w 558286"/>
                    <a:gd name="connsiteY17" fmla="*/ 134762 h 359548"/>
                    <a:gd name="connsiteX18" fmla="*/ 335542 w 558286"/>
                    <a:gd name="connsiteY18" fmla="*/ 103012 h 359548"/>
                    <a:gd name="connsiteX19" fmla="*/ 427617 w 558286"/>
                    <a:gd name="connsiteY19" fmla="*/ 122062 h 359548"/>
                    <a:gd name="connsiteX20" fmla="*/ 503817 w 558286"/>
                    <a:gd name="connsiteY20" fmla="*/ 150637 h 359548"/>
                    <a:gd name="connsiteX21" fmla="*/ 510167 w 558286"/>
                    <a:gd name="connsiteY21" fmla="*/ 109362 h 359548"/>
                    <a:gd name="connsiteX22" fmla="*/ 411742 w 558286"/>
                    <a:gd name="connsiteY22" fmla="*/ 52212 h 359548"/>
                    <a:gd name="connsiteX23" fmla="*/ 322842 w 558286"/>
                    <a:gd name="connsiteY23" fmla="*/ 23637 h 359548"/>
                    <a:gd name="connsiteX24" fmla="*/ 243467 w 558286"/>
                    <a:gd name="connsiteY24" fmla="*/ 64912 h 359548"/>
                    <a:gd name="connsiteX25" fmla="*/ 205367 w 558286"/>
                    <a:gd name="connsiteY25" fmla="*/ 144287 h 359548"/>
                    <a:gd name="connsiteX26" fmla="*/ 249817 w 558286"/>
                    <a:gd name="connsiteY26" fmla="*/ 55387 h 359548"/>
                    <a:gd name="connsiteX27" fmla="*/ 214892 w 558286"/>
                    <a:gd name="connsiteY27" fmla="*/ 1412 h 359548"/>
                    <a:gd name="connsiteX28" fmla="*/ 97417 w 558286"/>
                    <a:gd name="connsiteY28" fmla="*/ 23637 h 359548"/>
                    <a:gd name="connsiteX29" fmla="*/ 27567 w 558286"/>
                    <a:gd name="connsiteY29" fmla="*/ 106187 h 359548"/>
                    <a:gd name="connsiteX30" fmla="*/ 2167 w 558286"/>
                    <a:gd name="connsiteY30" fmla="*/ 220487 h 359548"/>
                    <a:gd name="connsiteX31" fmla="*/ 78367 w 558286"/>
                    <a:gd name="connsiteY31" fmla="*/ 242712 h 359548"/>
                    <a:gd name="connsiteX32" fmla="*/ 68842 w 558286"/>
                    <a:gd name="connsiteY32" fmla="*/ 188737 h 359548"/>
                    <a:gd name="connsiteX33" fmla="*/ 81542 w 558286"/>
                    <a:gd name="connsiteY33" fmla="*/ 125237 h 359548"/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736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3768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332367 w 558286"/>
                    <a:gd name="connsiteY12" fmla="*/ 163337 h 359548"/>
                    <a:gd name="connsiteX13" fmla="*/ 424442 w 558286"/>
                    <a:gd name="connsiteY13" fmla="*/ 198262 h 359548"/>
                    <a:gd name="connsiteX14" fmla="*/ 519692 w 558286"/>
                    <a:gd name="connsiteY14" fmla="*/ 220487 h 359548"/>
                    <a:gd name="connsiteX15" fmla="*/ 557792 w 558286"/>
                    <a:gd name="connsiteY15" fmla="*/ 220487 h 359548"/>
                    <a:gd name="connsiteX16" fmla="*/ 529217 w 558286"/>
                    <a:gd name="connsiteY16" fmla="*/ 179212 h 359548"/>
                    <a:gd name="connsiteX17" fmla="*/ 379992 w 558286"/>
                    <a:gd name="connsiteY17" fmla="*/ 134762 h 359548"/>
                    <a:gd name="connsiteX18" fmla="*/ 335542 w 558286"/>
                    <a:gd name="connsiteY18" fmla="*/ 103012 h 359548"/>
                    <a:gd name="connsiteX19" fmla="*/ 427617 w 558286"/>
                    <a:gd name="connsiteY19" fmla="*/ 122062 h 359548"/>
                    <a:gd name="connsiteX20" fmla="*/ 503817 w 558286"/>
                    <a:gd name="connsiteY20" fmla="*/ 150637 h 359548"/>
                    <a:gd name="connsiteX21" fmla="*/ 510167 w 558286"/>
                    <a:gd name="connsiteY21" fmla="*/ 109362 h 359548"/>
                    <a:gd name="connsiteX22" fmla="*/ 411742 w 558286"/>
                    <a:gd name="connsiteY22" fmla="*/ 52212 h 359548"/>
                    <a:gd name="connsiteX23" fmla="*/ 322842 w 558286"/>
                    <a:gd name="connsiteY23" fmla="*/ 23637 h 359548"/>
                    <a:gd name="connsiteX24" fmla="*/ 243467 w 558286"/>
                    <a:gd name="connsiteY24" fmla="*/ 64912 h 359548"/>
                    <a:gd name="connsiteX25" fmla="*/ 205367 w 558286"/>
                    <a:gd name="connsiteY25" fmla="*/ 144287 h 359548"/>
                    <a:gd name="connsiteX26" fmla="*/ 249817 w 558286"/>
                    <a:gd name="connsiteY26" fmla="*/ 55387 h 359548"/>
                    <a:gd name="connsiteX27" fmla="*/ 214892 w 558286"/>
                    <a:gd name="connsiteY27" fmla="*/ 1412 h 359548"/>
                    <a:gd name="connsiteX28" fmla="*/ 97417 w 558286"/>
                    <a:gd name="connsiteY28" fmla="*/ 23637 h 359548"/>
                    <a:gd name="connsiteX29" fmla="*/ 27567 w 558286"/>
                    <a:gd name="connsiteY29" fmla="*/ 106187 h 359548"/>
                    <a:gd name="connsiteX30" fmla="*/ 2167 w 558286"/>
                    <a:gd name="connsiteY30" fmla="*/ 220487 h 359548"/>
                    <a:gd name="connsiteX31" fmla="*/ 78367 w 558286"/>
                    <a:gd name="connsiteY31" fmla="*/ 242712 h 359548"/>
                    <a:gd name="connsiteX32" fmla="*/ 68842 w 558286"/>
                    <a:gd name="connsiteY32" fmla="*/ 188737 h 359548"/>
                    <a:gd name="connsiteX33" fmla="*/ 81542 w 558286"/>
                    <a:gd name="connsiteY33" fmla="*/ 125237 h 359548"/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736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3768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424442 w 558286"/>
                    <a:gd name="connsiteY12" fmla="*/ 198262 h 359548"/>
                    <a:gd name="connsiteX13" fmla="*/ 519692 w 558286"/>
                    <a:gd name="connsiteY13" fmla="*/ 220487 h 359548"/>
                    <a:gd name="connsiteX14" fmla="*/ 557792 w 558286"/>
                    <a:gd name="connsiteY14" fmla="*/ 220487 h 359548"/>
                    <a:gd name="connsiteX15" fmla="*/ 529217 w 558286"/>
                    <a:gd name="connsiteY15" fmla="*/ 179212 h 359548"/>
                    <a:gd name="connsiteX16" fmla="*/ 379992 w 558286"/>
                    <a:gd name="connsiteY16" fmla="*/ 134762 h 359548"/>
                    <a:gd name="connsiteX17" fmla="*/ 335542 w 558286"/>
                    <a:gd name="connsiteY17" fmla="*/ 103012 h 359548"/>
                    <a:gd name="connsiteX18" fmla="*/ 427617 w 558286"/>
                    <a:gd name="connsiteY18" fmla="*/ 122062 h 359548"/>
                    <a:gd name="connsiteX19" fmla="*/ 503817 w 558286"/>
                    <a:gd name="connsiteY19" fmla="*/ 150637 h 359548"/>
                    <a:gd name="connsiteX20" fmla="*/ 510167 w 558286"/>
                    <a:gd name="connsiteY20" fmla="*/ 109362 h 359548"/>
                    <a:gd name="connsiteX21" fmla="*/ 411742 w 558286"/>
                    <a:gd name="connsiteY21" fmla="*/ 52212 h 359548"/>
                    <a:gd name="connsiteX22" fmla="*/ 322842 w 558286"/>
                    <a:gd name="connsiteY22" fmla="*/ 23637 h 359548"/>
                    <a:gd name="connsiteX23" fmla="*/ 243467 w 558286"/>
                    <a:gd name="connsiteY23" fmla="*/ 64912 h 359548"/>
                    <a:gd name="connsiteX24" fmla="*/ 205367 w 558286"/>
                    <a:gd name="connsiteY24" fmla="*/ 144287 h 359548"/>
                    <a:gd name="connsiteX25" fmla="*/ 249817 w 558286"/>
                    <a:gd name="connsiteY25" fmla="*/ 55387 h 359548"/>
                    <a:gd name="connsiteX26" fmla="*/ 214892 w 558286"/>
                    <a:gd name="connsiteY26" fmla="*/ 1412 h 359548"/>
                    <a:gd name="connsiteX27" fmla="*/ 97417 w 558286"/>
                    <a:gd name="connsiteY27" fmla="*/ 23637 h 359548"/>
                    <a:gd name="connsiteX28" fmla="*/ 27567 w 558286"/>
                    <a:gd name="connsiteY28" fmla="*/ 106187 h 359548"/>
                    <a:gd name="connsiteX29" fmla="*/ 2167 w 558286"/>
                    <a:gd name="connsiteY29" fmla="*/ 220487 h 359548"/>
                    <a:gd name="connsiteX30" fmla="*/ 78367 w 558286"/>
                    <a:gd name="connsiteY30" fmla="*/ 242712 h 359548"/>
                    <a:gd name="connsiteX31" fmla="*/ 68842 w 558286"/>
                    <a:gd name="connsiteY31" fmla="*/ 188737 h 359548"/>
                    <a:gd name="connsiteX32" fmla="*/ 81542 w 558286"/>
                    <a:gd name="connsiteY32" fmla="*/ 125237 h 359548"/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736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3768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386342 w 558286"/>
                    <a:gd name="connsiteY12" fmla="*/ 182387 h 359548"/>
                    <a:gd name="connsiteX13" fmla="*/ 519692 w 558286"/>
                    <a:gd name="connsiteY13" fmla="*/ 220487 h 359548"/>
                    <a:gd name="connsiteX14" fmla="*/ 557792 w 558286"/>
                    <a:gd name="connsiteY14" fmla="*/ 220487 h 359548"/>
                    <a:gd name="connsiteX15" fmla="*/ 529217 w 558286"/>
                    <a:gd name="connsiteY15" fmla="*/ 179212 h 359548"/>
                    <a:gd name="connsiteX16" fmla="*/ 379992 w 558286"/>
                    <a:gd name="connsiteY16" fmla="*/ 134762 h 359548"/>
                    <a:gd name="connsiteX17" fmla="*/ 335542 w 558286"/>
                    <a:gd name="connsiteY17" fmla="*/ 103012 h 359548"/>
                    <a:gd name="connsiteX18" fmla="*/ 427617 w 558286"/>
                    <a:gd name="connsiteY18" fmla="*/ 122062 h 359548"/>
                    <a:gd name="connsiteX19" fmla="*/ 503817 w 558286"/>
                    <a:gd name="connsiteY19" fmla="*/ 150637 h 359548"/>
                    <a:gd name="connsiteX20" fmla="*/ 510167 w 558286"/>
                    <a:gd name="connsiteY20" fmla="*/ 109362 h 359548"/>
                    <a:gd name="connsiteX21" fmla="*/ 411742 w 558286"/>
                    <a:gd name="connsiteY21" fmla="*/ 52212 h 359548"/>
                    <a:gd name="connsiteX22" fmla="*/ 322842 w 558286"/>
                    <a:gd name="connsiteY22" fmla="*/ 23637 h 359548"/>
                    <a:gd name="connsiteX23" fmla="*/ 243467 w 558286"/>
                    <a:gd name="connsiteY23" fmla="*/ 64912 h 359548"/>
                    <a:gd name="connsiteX24" fmla="*/ 205367 w 558286"/>
                    <a:gd name="connsiteY24" fmla="*/ 144287 h 359548"/>
                    <a:gd name="connsiteX25" fmla="*/ 249817 w 558286"/>
                    <a:gd name="connsiteY25" fmla="*/ 55387 h 359548"/>
                    <a:gd name="connsiteX26" fmla="*/ 214892 w 558286"/>
                    <a:gd name="connsiteY26" fmla="*/ 1412 h 359548"/>
                    <a:gd name="connsiteX27" fmla="*/ 97417 w 558286"/>
                    <a:gd name="connsiteY27" fmla="*/ 23637 h 359548"/>
                    <a:gd name="connsiteX28" fmla="*/ 27567 w 558286"/>
                    <a:gd name="connsiteY28" fmla="*/ 106187 h 359548"/>
                    <a:gd name="connsiteX29" fmla="*/ 2167 w 558286"/>
                    <a:gd name="connsiteY29" fmla="*/ 220487 h 359548"/>
                    <a:gd name="connsiteX30" fmla="*/ 78367 w 558286"/>
                    <a:gd name="connsiteY30" fmla="*/ 242712 h 359548"/>
                    <a:gd name="connsiteX31" fmla="*/ 68842 w 558286"/>
                    <a:gd name="connsiteY31" fmla="*/ 188737 h 359548"/>
                    <a:gd name="connsiteX32" fmla="*/ 81542 w 558286"/>
                    <a:gd name="connsiteY32" fmla="*/ 125237 h 359548"/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736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4022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386342 w 558286"/>
                    <a:gd name="connsiteY12" fmla="*/ 182387 h 359548"/>
                    <a:gd name="connsiteX13" fmla="*/ 519692 w 558286"/>
                    <a:gd name="connsiteY13" fmla="*/ 220487 h 359548"/>
                    <a:gd name="connsiteX14" fmla="*/ 557792 w 558286"/>
                    <a:gd name="connsiteY14" fmla="*/ 220487 h 359548"/>
                    <a:gd name="connsiteX15" fmla="*/ 529217 w 558286"/>
                    <a:gd name="connsiteY15" fmla="*/ 179212 h 359548"/>
                    <a:gd name="connsiteX16" fmla="*/ 379992 w 558286"/>
                    <a:gd name="connsiteY16" fmla="*/ 134762 h 359548"/>
                    <a:gd name="connsiteX17" fmla="*/ 335542 w 558286"/>
                    <a:gd name="connsiteY17" fmla="*/ 103012 h 359548"/>
                    <a:gd name="connsiteX18" fmla="*/ 427617 w 558286"/>
                    <a:gd name="connsiteY18" fmla="*/ 122062 h 359548"/>
                    <a:gd name="connsiteX19" fmla="*/ 503817 w 558286"/>
                    <a:gd name="connsiteY19" fmla="*/ 150637 h 359548"/>
                    <a:gd name="connsiteX20" fmla="*/ 510167 w 558286"/>
                    <a:gd name="connsiteY20" fmla="*/ 109362 h 359548"/>
                    <a:gd name="connsiteX21" fmla="*/ 411742 w 558286"/>
                    <a:gd name="connsiteY21" fmla="*/ 52212 h 359548"/>
                    <a:gd name="connsiteX22" fmla="*/ 322842 w 558286"/>
                    <a:gd name="connsiteY22" fmla="*/ 23637 h 359548"/>
                    <a:gd name="connsiteX23" fmla="*/ 243467 w 558286"/>
                    <a:gd name="connsiteY23" fmla="*/ 64912 h 359548"/>
                    <a:gd name="connsiteX24" fmla="*/ 205367 w 558286"/>
                    <a:gd name="connsiteY24" fmla="*/ 144287 h 359548"/>
                    <a:gd name="connsiteX25" fmla="*/ 249817 w 558286"/>
                    <a:gd name="connsiteY25" fmla="*/ 55387 h 359548"/>
                    <a:gd name="connsiteX26" fmla="*/ 214892 w 558286"/>
                    <a:gd name="connsiteY26" fmla="*/ 1412 h 359548"/>
                    <a:gd name="connsiteX27" fmla="*/ 97417 w 558286"/>
                    <a:gd name="connsiteY27" fmla="*/ 23637 h 359548"/>
                    <a:gd name="connsiteX28" fmla="*/ 27567 w 558286"/>
                    <a:gd name="connsiteY28" fmla="*/ 106187 h 359548"/>
                    <a:gd name="connsiteX29" fmla="*/ 2167 w 558286"/>
                    <a:gd name="connsiteY29" fmla="*/ 220487 h 359548"/>
                    <a:gd name="connsiteX30" fmla="*/ 78367 w 558286"/>
                    <a:gd name="connsiteY30" fmla="*/ 242712 h 359548"/>
                    <a:gd name="connsiteX31" fmla="*/ 68842 w 558286"/>
                    <a:gd name="connsiteY31" fmla="*/ 188737 h 359548"/>
                    <a:gd name="connsiteX32" fmla="*/ 81542 w 558286"/>
                    <a:gd name="connsiteY32" fmla="*/ 125237 h 359548"/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355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4022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386342 w 558286"/>
                    <a:gd name="connsiteY12" fmla="*/ 182387 h 359548"/>
                    <a:gd name="connsiteX13" fmla="*/ 519692 w 558286"/>
                    <a:gd name="connsiteY13" fmla="*/ 220487 h 359548"/>
                    <a:gd name="connsiteX14" fmla="*/ 557792 w 558286"/>
                    <a:gd name="connsiteY14" fmla="*/ 220487 h 359548"/>
                    <a:gd name="connsiteX15" fmla="*/ 529217 w 558286"/>
                    <a:gd name="connsiteY15" fmla="*/ 179212 h 359548"/>
                    <a:gd name="connsiteX16" fmla="*/ 379992 w 558286"/>
                    <a:gd name="connsiteY16" fmla="*/ 134762 h 359548"/>
                    <a:gd name="connsiteX17" fmla="*/ 335542 w 558286"/>
                    <a:gd name="connsiteY17" fmla="*/ 103012 h 359548"/>
                    <a:gd name="connsiteX18" fmla="*/ 427617 w 558286"/>
                    <a:gd name="connsiteY18" fmla="*/ 122062 h 359548"/>
                    <a:gd name="connsiteX19" fmla="*/ 503817 w 558286"/>
                    <a:gd name="connsiteY19" fmla="*/ 150637 h 359548"/>
                    <a:gd name="connsiteX20" fmla="*/ 510167 w 558286"/>
                    <a:gd name="connsiteY20" fmla="*/ 109362 h 359548"/>
                    <a:gd name="connsiteX21" fmla="*/ 411742 w 558286"/>
                    <a:gd name="connsiteY21" fmla="*/ 52212 h 359548"/>
                    <a:gd name="connsiteX22" fmla="*/ 322842 w 558286"/>
                    <a:gd name="connsiteY22" fmla="*/ 23637 h 359548"/>
                    <a:gd name="connsiteX23" fmla="*/ 243467 w 558286"/>
                    <a:gd name="connsiteY23" fmla="*/ 64912 h 359548"/>
                    <a:gd name="connsiteX24" fmla="*/ 205367 w 558286"/>
                    <a:gd name="connsiteY24" fmla="*/ 144287 h 359548"/>
                    <a:gd name="connsiteX25" fmla="*/ 249817 w 558286"/>
                    <a:gd name="connsiteY25" fmla="*/ 55387 h 359548"/>
                    <a:gd name="connsiteX26" fmla="*/ 214892 w 558286"/>
                    <a:gd name="connsiteY26" fmla="*/ 1412 h 359548"/>
                    <a:gd name="connsiteX27" fmla="*/ 97417 w 558286"/>
                    <a:gd name="connsiteY27" fmla="*/ 23637 h 359548"/>
                    <a:gd name="connsiteX28" fmla="*/ 27567 w 558286"/>
                    <a:gd name="connsiteY28" fmla="*/ 106187 h 359548"/>
                    <a:gd name="connsiteX29" fmla="*/ 2167 w 558286"/>
                    <a:gd name="connsiteY29" fmla="*/ 220487 h 359548"/>
                    <a:gd name="connsiteX30" fmla="*/ 78367 w 558286"/>
                    <a:gd name="connsiteY30" fmla="*/ 242712 h 359548"/>
                    <a:gd name="connsiteX31" fmla="*/ 68842 w 558286"/>
                    <a:gd name="connsiteY31" fmla="*/ 188737 h 359548"/>
                    <a:gd name="connsiteX32" fmla="*/ 81542 w 558286"/>
                    <a:gd name="connsiteY32" fmla="*/ 125237 h 359548"/>
                    <a:gd name="connsiteX0" fmla="*/ 81542 w 558286"/>
                    <a:gd name="connsiteY0" fmla="*/ 125237 h 358073"/>
                    <a:gd name="connsiteX1" fmla="*/ 116467 w 558286"/>
                    <a:gd name="connsiteY1" fmla="*/ 249062 h 358073"/>
                    <a:gd name="connsiteX2" fmla="*/ 427617 w 558286"/>
                    <a:gd name="connsiteY2" fmla="*/ 357012 h 358073"/>
                    <a:gd name="connsiteX3" fmla="*/ 421267 w 558286"/>
                    <a:gd name="connsiteY3" fmla="*/ 303037 h 358073"/>
                    <a:gd name="connsiteX4" fmla="*/ 335542 w 558286"/>
                    <a:gd name="connsiteY4" fmla="*/ 283987 h 358073"/>
                    <a:gd name="connsiteX5" fmla="*/ 294267 w 558286"/>
                    <a:gd name="connsiteY5" fmla="*/ 258587 h 358073"/>
                    <a:gd name="connsiteX6" fmla="*/ 313317 w 558286"/>
                    <a:gd name="connsiteY6" fmla="*/ 236362 h 358073"/>
                    <a:gd name="connsiteX7" fmla="*/ 453017 w 558286"/>
                    <a:gd name="connsiteY7" fmla="*/ 274462 h 358073"/>
                    <a:gd name="connsiteX8" fmla="*/ 497467 w 558286"/>
                    <a:gd name="connsiteY8" fmla="*/ 268112 h 358073"/>
                    <a:gd name="connsiteX9" fmla="*/ 484767 w 558286"/>
                    <a:gd name="connsiteY9" fmla="*/ 242712 h 358073"/>
                    <a:gd name="connsiteX10" fmla="*/ 402217 w 558286"/>
                    <a:gd name="connsiteY10" fmla="*/ 210962 h 358073"/>
                    <a:gd name="connsiteX11" fmla="*/ 316492 w 558286"/>
                    <a:gd name="connsiteY11" fmla="*/ 191912 h 358073"/>
                    <a:gd name="connsiteX12" fmla="*/ 386342 w 558286"/>
                    <a:gd name="connsiteY12" fmla="*/ 182387 h 358073"/>
                    <a:gd name="connsiteX13" fmla="*/ 519692 w 558286"/>
                    <a:gd name="connsiteY13" fmla="*/ 220487 h 358073"/>
                    <a:gd name="connsiteX14" fmla="*/ 557792 w 558286"/>
                    <a:gd name="connsiteY14" fmla="*/ 220487 h 358073"/>
                    <a:gd name="connsiteX15" fmla="*/ 529217 w 558286"/>
                    <a:gd name="connsiteY15" fmla="*/ 179212 h 358073"/>
                    <a:gd name="connsiteX16" fmla="*/ 379992 w 558286"/>
                    <a:gd name="connsiteY16" fmla="*/ 134762 h 358073"/>
                    <a:gd name="connsiteX17" fmla="*/ 335542 w 558286"/>
                    <a:gd name="connsiteY17" fmla="*/ 103012 h 358073"/>
                    <a:gd name="connsiteX18" fmla="*/ 427617 w 558286"/>
                    <a:gd name="connsiteY18" fmla="*/ 122062 h 358073"/>
                    <a:gd name="connsiteX19" fmla="*/ 503817 w 558286"/>
                    <a:gd name="connsiteY19" fmla="*/ 150637 h 358073"/>
                    <a:gd name="connsiteX20" fmla="*/ 510167 w 558286"/>
                    <a:gd name="connsiteY20" fmla="*/ 109362 h 358073"/>
                    <a:gd name="connsiteX21" fmla="*/ 411742 w 558286"/>
                    <a:gd name="connsiteY21" fmla="*/ 52212 h 358073"/>
                    <a:gd name="connsiteX22" fmla="*/ 322842 w 558286"/>
                    <a:gd name="connsiteY22" fmla="*/ 23637 h 358073"/>
                    <a:gd name="connsiteX23" fmla="*/ 243467 w 558286"/>
                    <a:gd name="connsiteY23" fmla="*/ 64912 h 358073"/>
                    <a:gd name="connsiteX24" fmla="*/ 205367 w 558286"/>
                    <a:gd name="connsiteY24" fmla="*/ 144287 h 358073"/>
                    <a:gd name="connsiteX25" fmla="*/ 249817 w 558286"/>
                    <a:gd name="connsiteY25" fmla="*/ 55387 h 358073"/>
                    <a:gd name="connsiteX26" fmla="*/ 214892 w 558286"/>
                    <a:gd name="connsiteY26" fmla="*/ 1412 h 358073"/>
                    <a:gd name="connsiteX27" fmla="*/ 97417 w 558286"/>
                    <a:gd name="connsiteY27" fmla="*/ 23637 h 358073"/>
                    <a:gd name="connsiteX28" fmla="*/ 27567 w 558286"/>
                    <a:gd name="connsiteY28" fmla="*/ 106187 h 358073"/>
                    <a:gd name="connsiteX29" fmla="*/ 2167 w 558286"/>
                    <a:gd name="connsiteY29" fmla="*/ 220487 h 358073"/>
                    <a:gd name="connsiteX30" fmla="*/ 78367 w 558286"/>
                    <a:gd name="connsiteY30" fmla="*/ 242712 h 358073"/>
                    <a:gd name="connsiteX31" fmla="*/ 68842 w 558286"/>
                    <a:gd name="connsiteY31" fmla="*/ 188737 h 358073"/>
                    <a:gd name="connsiteX32" fmla="*/ 81542 w 558286"/>
                    <a:gd name="connsiteY32" fmla="*/ 125237 h 358073"/>
                    <a:gd name="connsiteX0" fmla="*/ 81542 w 558286"/>
                    <a:gd name="connsiteY0" fmla="*/ 125237 h 333294"/>
                    <a:gd name="connsiteX1" fmla="*/ 116467 w 558286"/>
                    <a:gd name="connsiteY1" fmla="*/ 249062 h 333294"/>
                    <a:gd name="connsiteX2" fmla="*/ 395867 w 558286"/>
                    <a:gd name="connsiteY2" fmla="*/ 331612 h 333294"/>
                    <a:gd name="connsiteX3" fmla="*/ 421267 w 558286"/>
                    <a:gd name="connsiteY3" fmla="*/ 303037 h 333294"/>
                    <a:gd name="connsiteX4" fmla="*/ 335542 w 558286"/>
                    <a:gd name="connsiteY4" fmla="*/ 283987 h 333294"/>
                    <a:gd name="connsiteX5" fmla="*/ 294267 w 558286"/>
                    <a:gd name="connsiteY5" fmla="*/ 258587 h 333294"/>
                    <a:gd name="connsiteX6" fmla="*/ 313317 w 558286"/>
                    <a:gd name="connsiteY6" fmla="*/ 236362 h 333294"/>
                    <a:gd name="connsiteX7" fmla="*/ 453017 w 558286"/>
                    <a:gd name="connsiteY7" fmla="*/ 274462 h 333294"/>
                    <a:gd name="connsiteX8" fmla="*/ 497467 w 558286"/>
                    <a:gd name="connsiteY8" fmla="*/ 268112 h 333294"/>
                    <a:gd name="connsiteX9" fmla="*/ 484767 w 558286"/>
                    <a:gd name="connsiteY9" fmla="*/ 242712 h 333294"/>
                    <a:gd name="connsiteX10" fmla="*/ 402217 w 558286"/>
                    <a:gd name="connsiteY10" fmla="*/ 210962 h 333294"/>
                    <a:gd name="connsiteX11" fmla="*/ 316492 w 558286"/>
                    <a:gd name="connsiteY11" fmla="*/ 191912 h 333294"/>
                    <a:gd name="connsiteX12" fmla="*/ 386342 w 558286"/>
                    <a:gd name="connsiteY12" fmla="*/ 182387 h 333294"/>
                    <a:gd name="connsiteX13" fmla="*/ 519692 w 558286"/>
                    <a:gd name="connsiteY13" fmla="*/ 220487 h 333294"/>
                    <a:gd name="connsiteX14" fmla="*/ 557792 w 558286"/>
                    <a:gd name="connsiteY14" fmla="*/ 220487 h 333294"/>
                    <a:gd name="connsiteX15" fmla="*/ 529217 w 558286"/>
                    <a:gd name="connsiteY15" fmla="*/ 179212 h 333294"/>
                    <a:gd name="connsiteX16" fmla="*/ 379992 w 558286"/>
                    <a:gd name="connsiteY16" fmla="*/ 134762 h 333294"/>
                    <a:gd name="connsiteX17" fmla="*/ 335542 w 558286"/>
                    <a:gd name="connsiteY17" fmla="*/ 103012 h 333294"/>
                    <a:gd name="connsiteX18" fmla="*/ 427617 w 558286"/>
                    <a:gd name="connsiteY18" fmla="*/ 122062 h 333294"/>
                    <a:gd name="connsiteX19" fmla="*/ 503817 w 558286"/>
                    <a:gd name="connsiteY19" fmla="*/ 150637 h 333294"/>
                    <a:gd name="connsiteX20" fmla="*/ 510167 w 558286"/>
                    <a:gd name="connsiteY20" fmla="*/ 109362 h 333294"/>
                    <a:gd name="connsiteX21" fmla="*/ 411742 w 558286"/>
                    <a:gd name="connsiteY21" fmla="*/ 52212 h 333294"/>
                    <a:gd name="connsiteX22" fmla="*/ 322842 w 558286"/>
                    <a:gd name="connsiteY22" fmla="*/ 23637 h 333294"/>
                    <a:gd name="connsiteX23" fmla="*/ 243467 w 558286"/>
                    <a:gd name="connsiteY23" fmla="*/ 64912 h 333294"/>
                    <a:gd name="connsiteX24" fmla="*/ 205367 w 558286"/>
                    <a:gd name="connsiteY24" fmla="*/ 144287 h 333294"/>
                    <a:gd name="connsiteX25" fmla="*/ 249817 w 558286"/>
                    <a:gd name="connsiteY25" fmla="*/ 55387 h 333294"/>
                    <a:gd name="connsiteX26" fmla="*/ 214892 w 558286"/>
                    <a:gd name="connsiteY26" fmla="*/ 1412 h 333294"/>
                    <a:gd name="connsiteX27" fmla="*/ 97417 w 558286"/>
                    <a:gd name="connsiteY27" fmla="*/ 23637 h 333294"/>
                    <a:gd name="connsiteX28" fmla="*/ 27567 w 558286"/>
                    <a:gd name="connsiteY28" fmla="*/ 106187 h 333294"/>
                    <a:gd name="connsiteX29" fmla="*/ 2167 w 558286"/>
                    <a:gd name="connsiteY29" fmla="*/ 220487 h 333294"/>
                    <a:gd name="connsiteX30" fmla="*/ 78367 w 558286"/>
                    <a:gd name="connsiteY30" fmla="*/ 242712 h 333294"/>
                    <a:gd name="connsiteX31" fmla="*/ 68842 w 558286"/>
                    <a:gd name="connsiteY31" fmla="*/ 188737 h 333294"/>
                    <a:gd name="connsiteX32" fmla="*/ 81542 w 558286"/>
                    <a:gd name="connsiteY32" fmla="*/ 125237 h 333294"/>
                    <a:gd name="connsiteX0" fmla="*/ 81542 w 558286"/>
                    <a:gd name="connsiteY0" fmla="*/ 125237 h 333472"/>
                    <a:gd name="connsiteX1" fmla="*/ 116467 w 558286"/>
                    <a:gd name="connsiteY1" fmla="*/ 249062 h 333472"/>
                    <a:gd name="connsiteX2" fmla="*/ 395867 w 558286"/>
                    <a:gd name="connsiteY2" fmla="*/ 331612 h 333472"/>
                    <a:gd name="connsiteX3" fmla="*/ 421267 w 558286"/>
                    <a:gd name="connsiteY3" fmla="*/ 303037 h 333472"/>
                    <a:gd name="connsiteX4" fmla="*/ 348242 w 558286"/>
                    <a:gd name="connsiteY4" fmla="*/ 261762 h 333472"/>
                    <a:gd name="connsiteX5" fmla="*/ 294267 w 558286"/>
                    <a:gd name="connsiteY5" fmla="*/ 258587 h 333472"/>
                    <a:gd name="connsiteX6" fmla="*/ 313317 w 558286"/>
                    <a:gd name="connsiteY6" fmla="*/ 236362 h 333472"/>
                    <a:gd name="connsiteX7" fmla="*/ 453017 w 558286"/>
                    <a:gd name="connsiteY7" fmla="*/ 274462 h 333472"/>
                    <a:gd name="connsiteX8" fmla="*/ 497467 w 558286"/>
                    <a:gd name="connsiteY8" fmla="*/ 268112 h 333472"/>
                    <a:gd name="connsiteX9" fmla="*/ 484767 w 558286"/>
                    <a:gd name="connsiteY9" fmla="*/ 242712 h 333472"/>
                    <a:gd name="connsiteX10" fmla="*/ 402217 w 558286"/>
                    <a:gd name="connsiteY10" fmla="*/ 210962 h 333472"/>
                    <a:gd name="connsiteX11" fmla="*/ 316492 w 558286"/>
                    <a:gd name="connsiteY11" fmla="*/ 191912 h 333472"/>
                    <a:gd name="connsiteX12" fmla="*/ 386342 w 558286"/>
                    <a:gd name="connsiteY12" fmla="*/ 182387 h 333472"/>
                    <a:gd name="connsiteX13" fmla="*/ 519692 w 558286"/>
                    <a:gd name="connsiteY13" fmla="*/ 220487 h 333472"/>
                    <a:gd name="connsiteX14" fmla="*/ 557792 w 558286"/>
                    <a:gd name="connsiteY14" fmla="*/ 220487 h 333472"/>
                    <a:gd name="connsiteX15" fmla="*/ 529217 w 558286"/>
                    <a:gd name="connsiteY15" fmla="*/ 179212 h 333472"/>
                    <a:gd name="connsiteX16" fmla="*/ 379992 w 558286"/>
                    <a:gd name="connsiteY16" fmla="*/ 134762 h 333472"/>
                    <a:gd name="connsiteX17" fmla="*/ 335542 w 558286"/>
                    <a:gd name="connsiteY17" fmla="*/ 103012 h 333472"/>
                    <a:gd name="connsiteX18" fmla="*/ 427617 w 558286"/>
                    <a:gd name="connsiteY18" fmla="*/ 122062 h 333472"/>
                    <a:gd name="connsiteX19" fmla="*/ 503817 w 558286"/>
                    <a:gd name="connsiteY19" fmla="*/ 150637 h 333472"/>
                    <a:gd name="connsiteX20" fmla="*/ 510167 w 558286"/>
                    <a:gd name="connsiteY20" fmla="*/ 109362 h 333472"/>
                    <a:gd name="connsiteX21" fmla="*/ 411742 w 558286"/>
                    <a:gd name="connsiteY21" fmla="*/ 52212 h 333472"/>
                    <a:gd name="connsiteX22" fmla="*/ 322842 w 558286"/>
                    <a:gd name="connsiteY22" fmla="*/ 23637 h 333472"/>
                    <a:gd name="connsiteX23" fmla="*/ 243467 w 558286"/>
                    <a:gd name="connsiteY23" fmla="*/ 64912 h 333472"/>
                    <a:gd name="connsiteX24" fmla="*/ 205367 w 558286"/>
                    <a:gd name="connsiteY24" fmla="*/ 144287 h 333472"/>
                    <a:gd name="connsiteX25" fmla="*/ 249817 w 558286"/>
                    <a:gd name="connsiteY25" fmla="*/ 55387 h 333472"/>
                    <a:gd name="connsiteX26" fmla="*/ 214892 w 558286"/>
                    <a:gd name="connsiteY26" fmla="*/ 1412 h 333472"/>
                    <a:gd name="connsiteX27" fmla="*/ 97417 w 558286"/>
                    <a:gd name="connsiteY27" fmla="*/ 23637 h 333472"/>
                    <a:gd name="connsiteX28" fmla="*/ 27567 w 558286"/>
                    <a:gd name="connsiteY28" fmla="*/ 106187 h 333472"/>
                    <a:gd name="connsiteX29" fmla="*/ 2167 w 558286"/>
                    <a:gd name="connsiteY29" fmla="*/ 220487 h 333472"/>
                    <a:gd name="connsiteX30" fmla="*/ 78367 w 558286"/>
                    <a:gd name="connsiteY30" fmla="*/ 242712 h 333472"/>
                    <a:gd name="connsiteX31" fmla="*/ 68842 w 558286"/>
                    <a:gd name="connsiteY31" fmla="*/ 188737 h 333472"/>
                    <a:gd name="connsiteX32" fmla="*/ 81542 w 558286"/>
                    <a:gd name="connsiteY32" fmla="*/ 125237 h 33347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</a:cxnLst>
                  <a:rect l="l" t="t" r="r" b="b"/>
                  <a:pathLst>
                    <a:path w="558286" h="333472">
                      <a:moveTo>
                        <a:pt x="81542" y="125237"/>
                      </a:moveTo>
                      <a:cubicBezTo>
                        <a:pt x="89479" y="135291"/>
                        <a:pt x="64080" y="214666"/>
                        <a:pt x="116467" y="249062"/>
                      </a:cubicBezTo>
                      <a:cubicBezTo>
                        <a:pt x="168854" y="283458"/>
                        <a:pt x="345067" y="322616"/>
                        <a:pt x="395867" y="331612"/>
                      </a:cubicBezTo>
                      <a:cubicBezTo>
                        <a:pt x="446667" y="340608"/>
                        <a:pt x="429205" y="314679"/>
                        <a:pt x="421267" y="303037"/>
                      </a:cubicBezTo>
                      <a:cubicBezTo>
                        <a:pt x="413330" y="291395"/>
                        <a:pt x="369409" y="269170"/>
                        <a:pt x="348242" y="261762"/>
                      </a:cubicBezTo>
                      <a:cubicBezTo>
                        <a:pt x="327075" y="254354"/>
                        <a:pt x="300088" y="262820"/>
                        <a:pt x="294267" y="258587"/>
                      </a:cubicBezTo>
                      <a:cubicBezTo>
                        <a:pt x="288446" y="254354"/>
                        <a:pt x="286859" y="233716"/>
                        <a:pt x="313317" y="236362"/>
                      </a:cubicBezTo>
                      <a:cubicBezTo>
                        <a:pt x="339775" y="239008"/>
                        <a:pt x="422325" y="269170"/>
                        <a:pt x="453017" y="274462"/>
                      </a:cubicBezTo>
                      <a:cubicBezTo>
                        <a:pt x="483709" y="279754"/>
                        <a:pt x="492175" y="273404"/>
                        <a:pt x="497467" y="268112"/>
                      </a:cubicBezTo>
                      <a:cubicBezTo>
                        <a:pt x="502759" y="262820"/>
                        <a:pt x="500642" y="252237"/>
                        <a:pt x="484767" y="242712"/>
                      </a:cubicBezTo>
                      <a:cubicBezTo>
                        <a:pt x="468892" y="233187"/>
                        <a:pt x="430263" y="219429"/>
                        <a:pt x="402217" y="210962"/>
                      </a:cubicBezTo>
                      <a:cubicBezTo>
                        <a:pt x="374171" y="202495"/>
                        <a:pt x="319138" y="196674"/>
                        <a:pt x="316492" y="191912"/>
                      </a:cubicBezTo>
                      <a:cubicBezTo>
                        <a:pt x="313846" y="187150"/>
                        <a:pt x="352475" y="177625"/>
                        <a:pt x="386342" y="182387"/>
                      </a:cubicBezTo>
                      <a:cubicBezTo>
                        <a:pt x="420209" y="187149"/>
                        <a:pt x="491117" y="214137"/>
                        <a:pt x="519692" y="220487"/>
                      </a:cubicBezTo>
                      <a:cubicBezTo>
                        <a:pt x="548267" y="226837"/>
                        <a:pt x="556205" y="227366"/>
                        <a:pt x="557792" y="220487"/>
                      </a:cubicBezTo>
                      <a:cubicBezTo>
                        <a:pt x="559379" y="213608"/>
                        <a:pt x="558850" y="193500"/>
                        <a:pt x="529217" y="179212"/>
                      </a:cubicBezTo>
                      <a:cubicBezTo>
                        <a:pt x="499584" y="164924"/>
                        <a:pt x="412271" y="147462"/>
                        <a:pt x="379992" y="134762"/>
                      </a:cubicBezTo>
                      <a:cubicBezTo>
                        <a:pt x="347713" y="122062"/>
                        <a:pt x="327605" y="105129"/>
                        <a:pt x="335542" y="103012"/>
                      </a:cubicBezTo>
                      <a:cubicBezTo>
                        <a:pt x="343479" y="100895"/>
                        <a:pt x="399571" y="114124"/>
                        <a:pt x="427617" y="122062"/>
                      </a:cubicBezTo>
                      <a:cubicBezTo>
                        <a:pt x="455663" y="130000"/>
                        <a:pt x="490059" y="152754"/>
                        <a:pt x="503817" y="150637"/>
                      </a:cubicBezTo>
                      <a:cubicBezTo>
                        <a:pt x="517575" y="148520"/>
                        <a:pt x="525513" y="125766"/>
                        <a:pt x="510167" y="109362"/>
                      </a:cubicBezTo>
                      <a:cubicBezTo>
                        <a:pt x="494821" y="92958"/>
                        <a:pt x="442963" y="66499"/>
                        <a:pt x="411742" y="52212"/>
                      </a:cubicBezTo>
                      <a:cubicBezTo>
                        <a:pt x="380521" y="37924"/>
                        <a:pt x="350888" y="21520"/>
                        <a:pt x="322842" y="23637"/>
                      </a:cubicBezTo>
                      <a:cubicBezTo>
                        <a:pt x="294796" y="25754"/>
                        <a:pt x="263046" y="44804"/>
                        <a:pt x="243467" y="64912"/>
                      </a:cubicBezTo>
                      <a:cubicBezTo>
                        <a:pt x="223888" y="85020"/>
                        <a:pt x="204309" y="145875"/>
                        <a:pt x="205367" y="144287"/>
                      </a:cubicBezTo>
                      <a:cubicBezTo>
                        <a:pt x="206425" y="142699"/>
                        <a:pt x="248229" y="79200"/>
                        <a:pt x="249817" y="55387"/>
                      </a:cubicBezTo>
                      <a:cubicBezTo>
                        <a:pt x="251405" y="31574"/>
                        <a:pt x="240292" y="6704"/>
                        <a:pt x="214892" y="1412"/>
                      </a:cubicBezTo>
                      <a:cubicBezTo>
                        <a:pt x="189492" y="-3880"/>
                        <a:pt x="128638" y="6175"/>
                        <a:pt x="97417" y="23637"/>
                      </a:cubicBezTo>
                      <a:cubicBezTo>
                        <a:pt x="66196" y="41099"/>
                        <a:pt x="43442" y="73379"/>
                        <a:pt x="27567" y="106187"/>
                      </a:cubicBezTo>
                      <a:cubicBezTo>
                        <a:pt x="11692" y="138995"/>
                        <a:pt x="-6300" y="197733"/>
                        <a:pt x="2167" y="220487"/>
                      </a:cubicBezTo>
                      <a:cubicBezTo>
                        <a:pt x="10634" y="243241"/>
                        <a:pt x="67254" y="248004"/>
                        <a:pt x="78367" y="242712"/>
                      </a:cubicBezTo>
                      <a:cubicBezTo>
                        <a:pt x="89480" y="237420"/>
                        <a:pt x="69900" y="205141"/>
                        <a:pt x="68842" y="188737"/>
                      </a:cubicBezTo>
                      <a:cubicBezTo>
                        <a:pt x="67784" y="172333"/>
                        <a:pt x="73605" y="115183"/>
                        <a:pt x="81542" y="125237"/>
                      </a:cubicBezTo>
                      <a:close/>
                    </a:path>
                  </a:pathLst>
                </a:custGeom>
                <a:solidFill>
                  <a:schemeClr val="bg1">
                    <a:lumMod val="8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47" name="Freeform 87">
                  <a:extLst>
                    <a:ext uri="{FF2B5EF4-FFF2-40B4-BE49-F238E27FC236}">
                      <a16:creationId xmlns:a16="http://schemas.microsoft.com/office/drawing/2014/main" id="{65EFC4BF-6AC9-9277-213C-0BCAF3376E03}"/>
                    </a:ext>
                  </a:extLst>
                </p:cNvPr>
                <p:cNvSpPr/>
                <p:nvPr/>
              </p:nvSpPr>
              <p:spPr>
                <a:xfrm rot="14514315">
                  <a:off x="3548788" y="2134584"/>
                  <a:ext cx="59406" cy="112818"/>
                </a:xfrm>
                <a:custGeom>
                  <a:avLst/>
                  <a:gdLst>
                    <a:gd name="connsiteX0" fmla="*/ 86109 w 86109"/>
                    <a:gd name="connsiteY0" fmla="*/ 9291 h 141227"/>
                    <a:gd name="connsiteX1" fmla="*/ 24603 w 86109"/>
                    <a:gd name="connsiteY1" fmla="*/ 21592 h 141227"/>
                    <a:gd name="connsiteX2" fmla="*/ 0 w 86109"/>
                    <a:gd name="connsiteY2" fmla="*/ 124103 h 141227"/>
                    <a:gd name="connsiteX3" fmla="*/ 24603 w 86109"/>
                    <a:gd name="connsiteY3" fmla="*/ 132304 h 141227"/>
                    <a:gd name="connsiteX4" fmla="*/ 86109 w 86109"/>
                    <a:gd name="connsiteY4" fmla="*/ 9291 h 14122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86109" h="141227">
                      <a:moveTo>
                        <a:pt x="86109" y="9291"/>
                      </a:moveTo>
                      <a:cubicBezTo>
                        <a:pt x="86109" y="-9161"/>
                        <a:pt x="38954" y="2457"/>
                        <a:pt x="24603" y="21592"/>
                      </a:cubicBezTo>
                      <a:cubicBezTo>
                        <a:pt x="10252" y="40727"/>
                        <a:pt x="0" y="124103"/>
                        <a:pt x="0" y="124103"/>
                      </a:cubicBezTo>
                      <a:cubicBezTo>
                        <a:pt x="0" y="142555"/>
                        <a:pt x="10252" y="147339"/>
                        <a:pt x="24603" y="132304"/>
                      </a:cubicBezTo>
                      <a:cubicBezTo>
                        <a:pt x="38954" y="117269"/>
                        <a:pt x="86109" y="27743"/>
                        <a:pt x="86109" y="9291"/>
                      </a:cubicBezTo>
                      <a:close/>
                    </a:path>
                  </a:pathLst>
                </a:custGeom>
                <a:solidFill>
                  <a:srgbClr val="113A6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sp>
              <p:nvSpPr>
                <p:cNvPr id="48" name="Freeform 88">
                  <a:extLst>
                    <a:ext uri="{FF2B5EF4-FFF2-40B4-BE49-F238E27FC236}">
                      <a16:creationId xmlns:a16="http://schemas.microsoft.com/office/drawing/2014/main" id="{023E5CF1-B6AC-B9CD-D42F-22330D6E6A55}"/>
                    </a:ext>
                  </a:extLst>
                </p:cNvPr>
                <p:cNvSpPr/>
                <p:nvPr/>
              </p:nvSpPr>
              <p:spPr>
                <a:xfrm>
                  <a:off x="3112887" y="2014970"/>
                  <a:ext cx="111058" cy="55041"/>
                </a:xfrm>
                <a:custGeom>
                  <a:avLst/>
                  <a:gdLst>
                    <a:gd name="connsiteX0" fmla="*/ 105917 w 111058"/>
                    <a:gd name="connsiteY0" fmla="*/ 27 h 55041"/>
                    <a:gd name="connsiteX1" fmla="*/ 119 w 111058"/>
                    <a:gd name="connsiteY1" fmla="*/ 52926 h 55041"/>
                    <a:gd name="connsiteX2" fmla="*/ 83246 w 111058"/>
                    <a:gd name="connsiteY2" fmla="*/ 45369 h 55041"/>
                    <a:gd name="connsiteX3" fmla="*/ 105917 w 111058"/>
                    <a:gd name="connsiteY3" fmla="*/ 27 h 5504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058" h="55041">
                      <a:moveTo>
                        <a:pt x="105917" y="27"/>
                      </a:moveTo>
                      <a:cubicBezTo>
                        <a:pt x="92063" y="1286"/>
                        <a:pt x="3898" y="45369"/>
                        <a:pt x="119" y="52926"/>
                      </a:cubicBezTo>
                      <a:cubicBezTo>
                        <a:pt x="-3660" y="60483"/>
                        <a:pt x="83246" y="45369"/>
                        <a:pt x="83246" y="45369"/>
                      </a:cubicBezTo>
                      <a:cubicBezTo>
                        <a:pt x="103398" y="41591"/>
                        <a:pt x="119771" y="-1232"/>
                        <a:pt x="105917" y="27"/>
                      </a:cubicBezTo>
                      <a:close/>
                    </a:path>
                  </a:pathLst>
                </a:custGeom>
                <a:solidFill>
                  <a:srgbClr val="113A6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  <p:grpSp>
              <p:nvGrpSpPr>
                <p:cNvPr id="49" name="Group 48">
                  <a:extLst>
                    <a:ext uri="{FF2B5EF4-FFF2-40B4-BE49-F238E27FC236}">
                      <a16:creationId xmlns:a16="http://schemas.microsoft.com/office/drawing/2014/main" id="{5298FF4F-E768-F0D5-A2D8-595E203170E0}"/>
                    </a:ext>
                  </a:extLst>
                </p:cNvPr>
                <p:cNvGrpSpPr/>
                <p:nvPr/>
              </p:nvGrpSpPr>
              <p:grpSpPr>
                <a:xfrm>
                  <a:off x="3092877" y="1430461"/>
                  <a:ext cx="350489" cy="407915"/>
                  <a:chOff x="7890646" y="2584624"/>
                  <a:chExt cx="239082" cy="340497"/>
                </a:xfrm>
              </p:grpSpPr>
              <p:sp>
                <p:nvSpPr>
                  <p:cNvPr id="57" name="Freeform 97">
                    <a:extLst>
                      <a:ext uri="{FF2B5EF4-FFF2-40B4-BE49-F238E27FC236}">
                        <a16:creationId xmlns:a16="http://schemas.microsoft.com/office/drawing/2014/main" id="{B1711947-BD90-60CE-4EED-A9C1E4A86249}"/>
                      </a:ext>
                    </a:extLst>
                  </p:cNvPr>
                  <p:cNvSpPr/>
                  <p:nvPr/>
                </p:nvSpPr>
                <p:spPr>
                  <a:xfrm>
                    <a:off x="7890646" y="2584624"/>
                    <a:ext cx="228641" cy="283279"/>
                  </a:xfrm>
                  <a:custGeom>
                    <a:avLst/>
                    <a:gdLst>
                      <a:gd name="connsiteX0" fmla="*/ 18928 w 234334"/>
                      <a:gd name="connsiteY0" fmla="*/ 148177 h 305227"/>
                      <a:gd name="connsiteX1" fmla="*/ 25506 w 234334"/>
                      <a:gd name="connsiteY1" fmla="*/ 207383 h 305227"/>
                      <a:gd name="connsiteX2" fmla="*/ 101158 w 234334"/>
                      <a:gd name="connsiteY2" fmla="*/ 266588 h 305227"/>
                      <a:gd name="connsiteX3" fmla="*/ 206413 w 234334"/>
                      <a:gd name="connsiteY3" fmla="*/ 302770 h 305227"/>
                      <a:gd name="connsiteX4" fmla="*/ 229437 w 234334"/>
                      <a:gd name="connsiteY4" fmla="*/ 197515 h 305227"/>
                      <a:gd name="connsiteX5" fmla="*/ 229437 w 234334"/>
                      <a:gd name="connsiteY5" fmla="*/ 92260 h 305227"/>
                      <a:gd name="connsiteX6" fmla="*/ 176810 w 234334"/>
                      <a:gd name="connsiteY6" fmla="*/ 6741 h 305227"/>
                      <a:gd name="connsiteX7" fmla="*/ 64977 w 234334"/>
                      <a:gd name="connsiteY7" fmla="*/ 13319 h 305227"/>
                      <a:gd name="connsiteX8" fmla="*/ 2482 w 234334"/>
                      <a:gd name="connsiteY8" fmla="*/ 75814 h 305227"/>
                      <a:gd name="connsiteX9" fmla="*/ 18928 w 234334"/>
                      <a:gd name="connsiteY9" fmla="*/ 148177 h 305227"/>
                      <a:gd name="connsiteX0" fmla="*/ 18928 w 235009"/>
                      <a:gd name="connsiteY0" fmla="*/ 148177 h 283279"/>
                      <a:gd name="connsiteX1" fmla="*/ 25506 w 235009"/>
                      <a:gd name="connsiteY1" fmla="*/ 207383 h 283279"/>
                      <a:gd name="connsiteX2" fmla="*/ 101158 w 235009"/>
                      <a:gd name="connsiteY2" fmla="*/ 266588 h 283279"/>
                      <a:gd name="connsiteX3" fmla="*/ 193693 w 235009"/>
                      <a:gd name="connsiteY3" fmla="*/ 278539 h 283279"/>
                      <a:gd name="connsiteX4" fmla="*/ 229437 w 235009"/>
                      <a:gd name="connsiteY4" fmla="*/ 197515 h 283279"/>
                      <a:gd name="connsiteX5" fmla="*/ 229437 w 235009"/>
                      <a:gd name="connsiteY5" fmla="*/ 92260 h 283279"/>
                      <a:gd name="connsiteX6" fmla="*/ 176810 w 235009"/>
                      <a:gd name="connsiteY6" fmla="*/ 6741 h 283279"/>
                      <a:gd name="connsiteX7" fmla="*/ 64977 w 235009"/>
                      <a:gd name="connsiteY7" fmla="*/ 13319 h 283279"/>
                      <a:gd name="connsiteX8" fmla="*/ 2482 w 235009"/>
                      <a:gd name="connsiteY8" fmla="*/ 75814 h 283279"/>
                      <a:gd name="connsiteX9" fmla="*/ 18928 w 235009"/>
                      <a:gd name="connsiteY9" fmla="*/ 148177 h 283279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</a:cxnLst>
                    <a:rect l="l" t="t" r="r" b="b"/>
                    <a:pathLst>
                      <a:path w="235009" h="283279">
                        <a:moveTo>
                          <a:pt x="18928" y="148177"/>
                        </a:moveTo>
                        <a:cubicBezTo>
                          <a:pt x="22765" y="170105"/>
                          <a:pt x="11801" y="187648"/>
                          <a:pt x="25506" y="207383"/>
                        </a:cubicBezTo>
                        <a:cubicBezTo>
                          <a:pt x="39211" y="227118"/>
                          <a:pt x="73127" y="254729"/>
                          <a:pt x="101158" y="266588"/>
                        </a:cubicBezTo>
                        <a:cubicBezTo>
                          <a:pt x="129189" y="278447"/>
                          <a:pt x="172313" y="290051"/>
                          <a:pt x="193693" y="278539"/>
                        </a:cubicBezTo>
                        <a:cubicBezTo>
                          <a:pt x="215073" y="267027"/>
                          <a:pt x="223480" y="228561"/>
                          <a:pt x="229437" y="197515"/>
                        </a:cubicBezTo>
                        <a:cubicBezTo>
                          <a:pt x="235394" y="166469"/>
                          <a:pt x="238208" y="124056"/>
                          <a:pt x="229437" y="92260"/>
                        </a:cubicBezTo>
                        <a:cubicBezTo>
                          <a:pt x="220666" y="60464"/>
                          <a:pt x="204220" y="19898"/>
                          <a:pt x="176810" y="6741"/>
                        </a:cubicBezTo>
                        <a:cubicBezTo>
                          <a:pt x="149400" y="-6416"/>
                          <a:pt x="94032" y="1807"/>
                          <a:pt x="64977" y="13319"/>
                        </a:cubicBezTo>
                        <a:cubicBezTo>
                          <a:pt x="35922" y="24831"/>
                          <a:pt x="12350" y="56627"/>
                          <a:pt x="2482" y="75814"/>
                        </a:cubicBezTo>
                        <a:cubicBezTo>
                          <a:pt x="-7386" y="95001"/>
                          <a:pt x="15091" y="126249"/>
                          <a:pt x="18928" y="148177"/>
                        </a:cubicBezTo>
                        <a:close/>
                      </a:path>
                    </a:pathLst>
                  </a:custGeom>
                  <a:solidFill>
                    <a:srgbClr val="174684"/>
                  </a:solidFill>
                  <a:ln w="6350">
                    <a:solidFill>
                      <a:schemeClr val="bg2">
                        <a:lumMod val="1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NL" sz="700"/>
                  </a:p>
                </p:txBody>
              </p:sp>
              <p:sp>
                <p:nvSpPr>
                  <p:cNvPr id="58" name="Freeform 98">
                    <a:extLst>
                      <a:ext uri="{FF2B5EF4-FFF2-40B4-BE49-F238E27FC236}">
                        <a16:creationId xmlns:a16="http://schemas.microsoft.com/office/drawing/2014/main" id="{4D1DFE07-2CB6-DCA1-74D7-631B8DCC4685}"/>
                      </a:ext>
                    </a:extLst>
                  </p:cNvPr>
                  <p:cNvSpPr/>
                  <p:nvPr/>
                </p:nvSpPr>
                <p:spPr>
                  <a:xfrm>
                    <a:off x="7942519" y="2669511"/>
                    <a:ext cx="178279" cy="255610"/>
                  </a:xfrm>
                  <a:custGeom>
                    <a:avLst/>
                    <a:gdLst>
                      <a:gd name="connsiteX0" fmla="*/ 159385 w 221626"/>
                      <a:gd name="connsiteY0" fmla="*/ 209822 h 264643"/>
                      <a:gd name="connsiteX1" fmla="*/ 153035 w 221626"/>
                      <a:gd name="connsiteY1" fmla="*/ 260622 h 264643"/>
                      <a:gd name="connsiteX2" fmla="*/ 80010 w 221626"/>
                      <a:gd name="connsiteY2" fmla="*/ 257447 h 264643"/>
                      <a:gd name="connsiteX3" fmla="*/ 48260 w 221626"/>
                      <a:gd name="connsiteY3" fmla="*/ 225697 h 264643"/>
                      <a:gd name="connsiteX4" fmla="*/ 70485 w 221626"/>
                      <a:gd name="connsiteY4" fmla="*/ 155847 h 264643"/>
                      <a:gd name="connsiteX5" fmla="*/ 35560 w 221626"/>
                      <a:gd name="connsiteY5" fmla="*/ 127272 h 264643"/>
                      <a:gd name="connsiteX6" fmla="*/ 22860 w 221626"/>
                      <a:gd name="connsiteY6" fmla="*/ 70122 h 264643"/>
                      <a:gd name="connsiteX7" fmla="*/ 635 w 221626"/>
                      <a:gd name="connsiteY7" fmla="*/ 51072 h 264643"/>
                      <a:gd name="connsiteX8" fmla="*/ 10160 w 221626"/>
                      <a:gd name="connsiteY8" fmla="*/ 272 h 264643"/>
                      <a:gd name="connsiteX9" fmla="*/ 51435 w 221626"/>
                      <a:gd name="connsiteY9" fmla="*/ 32022 h 264643"/>
                      <a:gd name="connsiteX10" fmla="*/ 64135 w 221626"/>
                      <a:gd name="connsiteY10" fmla="*/ 57422 h 264643"/>
                      <a:gd name="connsiteX11" fmla="*/ 76835 w 221626"/>
                      <a:gd name="connsiteY11" fmla="*/ 82822 h 264643"/>
                      <a:gd name="connsiteX12" fmla="*/ 118110 w 221626"/>
                      <a:gd name="connsiteY12" fmla="*/ 79647 h 264643"/>
                      <a:gd name="connsiteX13" fmla="*/ 178435 w 221626"/>
                      <a:gd name="connsiteY13" fmla="*/ 85997 h 264643"/>
                      <a:gd name="connsiteX14" fmla="*/ 219710 w 221626"/>
                      <a:gd name="connsiteY14" fmla="*/ 98697 h 264643"/>
                      <a:gd name="connsiteX15" fmla="*/ 213360 w 221626"/>
                      <a:gd name="connsiteY15" fmla="*/ 184422 h 264643"/>
                      <a:gd name="connsiteX16" fmla="*/ 159385 w 221626"/>
                      <a:gd name="connsiteY16" fmla="*/ 209822 h 264643"/>
                      <a:gd name="connsiteX0" fmla="*/ 159385 w 221626"/>
                      <a:gd name="connsiteY0" fmla="*/ 209822 h 264772"/>
                      <a:gd name="connsiteX1" fmla="*/ 153035 w 221626"/>
                      <a:gd name="connsiteY1" fmla="*/ 260622 h 264772"/>
                      <a:gd name="connsiteX2" fmla="*/ 80010 w 221626"/>
                      <a:gd name="connsiteY2" fmla="*/ 257447 h 264772"/>
                      <a:gd name="connsiteX3" fmla="*/ 25927 w 221626"/>
                      <a:gd name="connsiteY3" fmla="*/ 222680 h 264772"/>
                      <a:gd name="connsiteX4" fmla="*/ 70485 w 221626"/>
                      <a:gd name="connsiteY4" fmla="*/ 155847 h 264772"/>
                      <a:gd name="connsiteX5" fmla="*/ 35560 w 221626"/>
                      <a:gd name="connsiteY5" fmla="*/ 127272 h 264772"/>
                      <a:gd name="connsiteX6" fmla="*/ 22860 w 221626"/>
                      <a:gd name="connsiteY6" fmla="*/ 70122 h 264772"/>
                      <a:gd name="connsiteX7" fmla="*/ 635 w 221626"/>
                      <a:gd name="connsiteY7" fmla="*/ 51072 h 264772"/>
                      <a:gd name="connsiteX8" fmla="*/ 10160 w 221626"/>
                      <a:gd name="connsiteY8" fmla="*/ 272 h 264772"/>
                      <a:gd name="connsiteX9" fmla="*/ 51435 w 221626"/>
                      <a:gd name="connsiteY9" fmla="*/ 32022 h 264772"/>
                      <a:gd name="connsiteX10" fmla="*/ 64135 w 221626"/>
                      <a:gd name="connsiteY10" fmla="*/ 57422 h 264772"/>
                      <a:gd name="connsiteX11" fmla="*/ 76835 w 221626"/>
                      <a:gd name="connsiteY11" fmla="*/ 82822 h 264772"/>
                      <a:gd name="connsiteX12" fmla="*/ 118110 w 221626"/>
                      <a:gd name="connsiteY12" fmla="*/ 79647 h 264772"/>
                      <a:gd name="connsiteX13" fmla="*/ 178435 w 221626"/>
                      <a:gd name="connsiteY13" fmla="*/ 85997 h 264772"/>
                      <a:gd name="connsiteX14" fmla="*/ 219710 w 221626"/>
                      <a:gd name="connsiteY14" fmla="*/ 98697 h 264772"/>
                      <a:gd name="connsiteX15" fmla="*/ 213360 w 221626"/>
                      <a:gd name="connsiteY15" fmla="*/ 184422 h 264772"/>
                      <a:gd name="connsiteX16" fmla="*/ 159385 w 221626"/>
                      <a:gd name="connsiteY16" fmla="*/ 209822 h 264772"/>
                      <a:gd name="connsiteX0" fmla="*/ 159385 w 221626"/>
                      <a:gd name="connsiteY0" fmla="*/ 209822 h 264772"/>
                      <a:gd name="connsiteX1" fmla="*/ 153035 w 221626"/>
                      <a:gd name="connsiteY1" fmla="*/ 260622 h 264772"/>
                      <a:gd name="connsiteX2" fmla="*/ 80010 w 221626"/>
                      <a:gd name="connsiteY2" fmla="*/ 257447 h 264772"/>
                      <a:gd name="connsiteX3" fmla="*/ 25927 w 221626"/>
                      <a:gd name="connsiteY3" fmla="*/ 222680 h 264772"/>
                      <a:gd name="connsiteX4" fmla="*/ 42569 w 221626"/>
                      <a:gd name="connsiteY4" fmla="*/ 146797 h 264772"/>
                      <a:gd name="connsiteX5" fmla="*/ 35560 w 221626"/>
                      <a:gd name="connsiteY5" fmla="*/ 127272 h 264772"/>
                      <a:gd name="connsiteX6" fmla="*/ 22860 w 221626"/>
                      <a:gd name="connsiteY6" fmla="*/ 70122 h 264772"/>
                      <a:gd name="connsiteX7" fmla="*/ 635 w 221626"/>
                      <a:gd name="connsiteY7" fmla="*/ 51072 h 264772"/>
                      <a:gd name="connsiteX8" fmla="*/ 10160 w 221626"/>
                      <a:gd name="connsiteY8" fmla="*/ 272 h 264772"/>
                      <a:gd name="connsiteX9" fmla="*/ 51435 w 221626"/>
                      <a:gd name="connsiteY9" fmla="*/ 32022 h 264772"/>
                      <a:gd name="connsiteX10" fmla="*/ 64135 w 221626"/>
                      <a:gd name="connsiteY10" fmla="*/ 57422 h 264772"/>
                      <a:gd name="connsiteX11" fmla="*/ 76835 w 221626"/>
                      <a:gd name="connsiteY11" fmla="*/ 82822 h 264772"/>
                      <a:gd name="connsiteX12" fmla="*/ 118110 w 221626"/>
                      <a:gd name="connsiteY12" fmla="*/ 79647 h 264772"/>
                      <a:gd name="connsiteX13" fmla="*/ 178435 w 221626"/>
                      <a:gd name="connsiteY13" fmla="*/ 85997 h 264772"/>
                      <a:gd name="connsiteX14" fmla="*/ 219710 w 221626"/>
                      <a:gd name="connsiteY14" fmla="*/ 98697 h 264772"/>
                      <a:gd name="connsiteX15" fmla="*/ 213360 w 221626"/>
                      <a:gd name="connsiteY15" fmla="*/ 184422 h 264772"/>
                      <a:gd name="connsiteX16" fmla="*/ 159385 w 221626"/>
                      <a:gd name="connsiteY16" fmla="*/ 209822 h 264772"/>
                      <a:gd name="connsiteX0" fmla="*/ 161389 w 223630"/>
                      <a:gd name="connsiteY0" fmla="*/ 228778 h 283728"/>
                      <a:gd name="connsiteX1" fmla="*/ 155039 w 223630"/>
                      <a:gd name="connsiteY1" fmla="*/ 279578 h 283728"/>
                      <a:gd name="connsiteX2" fmla="*/ 82014 w 223630"/>
                      <a:gd name="connsiteY2" fmla="*/ 276403 h 283728"/>
                      <a:gd name="connsiteX3" fmla="*/ 27931 w 223630"/>
                      <a:gd name="connsiteY3" fmla="*/ 241636 h 283728"/>
                      <a:gd name="connsiteX4" fmla="*/ 44573 w 223630"/>
                      <a:gd name="connsiteY4" fmla="*/ 165753 h 283728"/>
                      <a:gd name="connsiteX5" fmla="*/ 37564 w 223630"/>
                      <a:gd name="connsiteY5" fmla="*/ 146228 h 283728"/>
                      <a:gd name="connsiteX6" fmla="*/ 24864 w 223630"/>
                      <a:gd name="connsiteY6" fmla="*/ 89078 h 283728"/>
                      <a:gd name="connsiteX7" fmla="*/ 2639 w 223630"/>
                      <a:gd name="connsiteY7" fmla="*/ 70028 h 283728"/>
                      <a:gd name="connsiteX8" fmla="*/ 12164 w 223630"/>
                      <a:gd name="connsiteY8" fmla="*/ 19228 h 283728"/>
                      <a:gd name="connsiteX9" fmla="*/ 107249 w 223630"/>
                      <a:gd name="connsiteY9" fmla="*/ 3092 h 283728"/>
                      <a:gd name="connsiteX10" fmla="*/ 66139 w 223630"/>
                      <a:gd name="connsiteY10" fmla="*/ 76378 h 283728"/>
                      <a:gd name="connsiteX11" fmla="*/ 78839 w 223630"/>
                      <a:gd name="connsiteY11" fmla="*/ 101778 h 283728"/>
                      <a:gd name="connsiteX12" fmla="*/ 120114 w 223630"/>
                      <a:gd name="connsiteY12" fmla="*/ 98603 h 283728"/>
                      <a:gd name="connsiteX13" fmla="*/ 180439 w 223630"/>
                      <a:gd name="connsiteY13" fmla="*/ 104953 h 283728"/>
                      <a:gd name="connsiteX14" fmla="*/ 221714 w 223630"/>
                      <a:gd name="connsiteY14" fmla="*/ 117653 h 283728"/>
                      <a:gd name="connsiteX15" fmla="*/ 215364 w 223630"/>
                      <a:gd name="connsiteY15" fmla="*/ 203378 h 283728"/>
                      <a:gd name="connsiteX16" fmla="*/ 161389 w 223630"/>
                      <a:gd name="connsiteY16" fmla="*/ 228778 h 283728"/>
                      <a:gd name="connsiteX0" fmla="*/ 161389 w 223630"/>
                      <a:gd name="connsiteY0" fmla="*/ 226404 h 281354"/>
                      <a:gd name="connsiteX1" fmla="*/ 155039 w 223630"/>
                      <a:gd name="connsiteY1" fmla="*/ 277204 h 281354"/>
                      <a:gd name="connsiteX2" fmla="*/ 82014 w 223630"/>
                      <a:gd name="connsiteY2" fmla="*/ 274029 h 281354"/>
                      <a:gd name="connsiteX3" fmla="*/ 27931 w 223630"/>
                      <a:gd name="connsiteY3" fmla="*/ 239262 h 281354"/>
                      <a:gd name="connsiteX4" fmla="*/ 44573 w 223630"/>
                      <a:gd name="connsiteY4" fmla="*/ 163379 h 281354"/>
                      <a:gd name="connsiteX5" fmla="*/ 37564 w 223630"/>
                      <a:gd name="connsiteY5" fmla="*/ 143854 h 281354"/>
                      <a:gd name="connsiteX6" fmla="*/ 24864 w 223630"/>
                      <a:gd name="connsiteY6" fmla="*/ 86704 h 281354"/>
                      <a:gd name="connsiteX7" fmla="*/ 2639 w 223630"/>
                      <a:gd name="connsiteY7" fmla="*/ 67654 h 281354"/>
                      <a:gd name="connsiteX8" fmla="*/ 12164 w 223630"/>
                      <a:gd name="connsiteY8" fmla="*/ 16854 h 281354"/>
                      <a:gd name="connsiteX9" fmla="*/ 107249 w 223630"/>
                      <a:gd name="connsiteY9" fmla="*/ 718 h 281354"/>
                      <a:gd name="connsiteX10" fmla="*/ 205412 w 223630"/>
                      <a:gd name="connsiteY10" fmla="*/ 36379 h 281354"/>
                      <a:gd name="connsiteX11" fmla="*/ 78839 w 223630"/>
                      <a:gd name="connsiteY11" fmla="*/ 99404 h 281354"/>
                      <a:gd name="connsiteX12" fmla="*/ 120114 w 223630"/>
                      <a:gd name="connsiteY12" fmla="*/ 96229 h 281354"/>
                      <a:gd name="connsiteX13" fmla="*/ 180439 w 223630"/>
                      <a:gd name="connsiteY13" fmla="*/ 102579 h 281354"/>
                      <a:gd name="connsiteX14" fmla="*/ 221714 w 223630"/>
                      <a:gd name="connsiteY14" fmla="*/ 115279 h 281354"/>
                      <a:gd name="connsiteX15" fmla="*/ 215364 w 223630"/>
                      <a:gd name="connsiteY15" fmla="*/ 201004 h 281354"/>
                      <a:gd name="connsiteX16" fmla="*/ 161389 w 223630"/>
                      <a:gd name="connsiteY16" fmla="*/ 226404 h 281354"/>
                      <a:gd name="connsiteX0" fmla="*/ 161389 w 223630"/>
                      <a:gd name="connsiteY0" fmla="*/ 226404 h 281354"/>
                      <a:gd name="connsiteX1" fmla="*/ 155039 w 223630"/>
                      <a:gd name="connsiteY1" fmla="*/ 277204 h 281354"/>
                      <a:gd name="connsiteX2" fmla="*/ 82014 w 223630"/>
                      <a:gd name="connsiteY2" fmla="*/ 274029 h 281354"/>
                      <a:gd name="connsiteX3" fmla="*/ 27931 w 223630"/>
                      <a:gd name="connsiteY3" fmla="*/ 239262 h 281354"/>
                      <a:gd name="connsiteX4" fmla="*/ 44573 w 223630"/>
                      <a:gd name="connsiteY4" fmla="*/ 163379 h 281354"/>
                      <a:gd name="connsiteX5" fmla="*/ 37564 w 223630"/>
                      <a:gd name="connsiteY5" fmla="*/ 143854 h 281354"/>
                      <a:gd name="connsiteX6" fmla="*/ 24864 w 223630"/>
                      <a:gd name="connsiteY6" fmla="*/ 86704 h 281354"/>
                      <a:gd name="connsiteX7" fmla="*/ 2639 w 223630"/>
                      <a:gd name="connsiteY7" fmla="*/ 67654 h 281354"/>
                      <a:gd name="connsiteX8" fmla="*/ 12164 w 223630"/>
                      <a:gd name="connsiteY8" fmla="*/ 16854 h 281354"/>
                      <a:gd name="connsiteX9" fmla="*/ 107249 w 223630"/>
                      <a:gd name="connsiteY9" fmla="*/ 718 h 281354"/>
                      <a:gd name="connsiteX10" fmla="*/ 205412 w 223630"/>
                      <a:gd name="connsiteY10" fmla="*/ 36379 h 281354"/>
                      <a:gd name="connsiteX11" fmla="*/ 211781 w 223630"/>
                      <a:gd name="connsiteY11" fmla="*/ 99404 h 281354"/>
                      <a:gd name="connsiteX12" fmla="*/ 120114 w 223630"/>
                      <a:gd name="connsiteY12" fmla="*/ 96229 h 281354"/>
                      <a:gd name="connsiteX13" fmla="*/ 180439 w 223630"/>
                      <a:gd name="connsiteY13" fmla="*/ 102579 h 281354"/>
                      <a:gd name="connsiteX14" fmla="*/ 221714 w 223630"/>
                      <a:gd name="connsiteY14" fmla="*/ 115279 h 281354"/>
                      <a:gd name="connsiteX15" fmla="*/ 215364 w 223630"/>
                      <a:gd name="connsiteY15" fmla="*/ 201004 h 281354"/>
                      <a:gd name="connsiteX16" fmla="*/ 161389 w 223630"/>
                      <a:gd name="connsiteY16" fmla="*/ 226404 h 281354"/>
                      <a:gd name="connsiteX0" fmla="*/ 164767 w 227008"/>
                      <a:gd name="connsiteY0" fmla="*/ 236357 h 291307"/>
                      <a:gd name="connsiteX1" fmla="*/ 158417 w 227008"/>
                      <a:gd name="connsiteY1" fmla="*/ 287157 h 291307"/>
                      <a:gd name="connsiteX2" fmla="*/ 85392 w 227008"/>
                      <a:gd name="connsiteY2" fmla="*/ 283982 h 291307"/>
                      <a:gd name="connsiteX3" fmla="*/ 31309 w 227008"/>
                      <a:gd name="connsiteY3" fmla="*/ 249215 h 291307"/>
                      <a:gd name="connsiteX4" fmla="*/ 47951 w 227008"/>
                      <a:gd name="connsiteY4" fmla="*/ 173332 h 291307"/>
                      <a:gd name="connsiteX5" fmla="*/ 40942 w 227008"/>
                      <a:gd name="connsiteY5" fmla="*/ 153807 h 291307"/>
                      <a:gd name="connsiteX6" fmla="*/ 28242 w 227008"/>
                      <a:gd name="connsiteY6" fmla="*/ 96657 h 291307"/>
                      <a:gd name="connsiteX7" fmla="*/ 6017 w 227008"/>
                      <a:gd name="connsiteY7" fmla="*/ 77607 h 291307"/>
                      <a:gd name="connsiteX8" fmla="*/ 15542 w 227008"/>
                      <a:gd name="connsiteY8" fmla="*/ 26807 h 291307"/>
                      <a:gd name="connsiteX9" fmla="*/ 164437 w 227008"/>
                      <a:gd name="connsiteY9" fmla="*/ 410 h 291307"/>
                      <a:gd name="connsiteX10" fmla="*/ 208790 w 227008"/>
                      <a:gd name="connsiteY10" fmla="*/ 46332 h 291307"/>
                      <a:gd name="connsiteX11" fmla="*/ 215159 w 227008"/>
                      <a:gd name="connsiteY11" fmla="*/ 109357 h 291307"/>
                      <a:gd name="connsiteX12" fmla="*/ 123492 w 227008"/>
                      <a:gd name="connsiteY12" fmla="*/ 106182 h 291307"/>
                      <a:gd name="connsiteX13" fmla="*/ 183817 w 227008"/>
                      <a:gd name="connsiteY13" fmla="*/ 112532 h 291307"/>
                      <a:gd name="connsiteX14" fmla="*/ 225092 w 227008"/>
                      <a:gd name="connsiteY14" fmla="*/ 125232 h 291307"/>
                      <a:gd name="connsiteX15" fmla="*/ 218742 w 227008"/>
                      <a:gd name="connsiteY15" fmla="*/ 210957 h 291307"/>
                      <a:gd name="connsiteX16" fmla="*/ 164767 w 227008"/>
                      <a:gd name="connsiteY16" fmla="*/ 236357 h 291307"/>
                      <a:gd name="connsiteX0" fmla="*/ 164767 w 229794"/>
                      <a:gd name="connsiteY0" fmla="*/ 235994 h 290944"/>
                      <a:gd name="connsiteX1" fmla="*/ 158417 w 229794"/>
                      <a:gd name="connsiteY1" fmla="*/ 286794 h 290944"/>
                      <a:gd name="connsiteX2" fmla="*/ 85392 w 229794"/>
                      <a:gd name="connsiteY2" fmla="*/ 283619 h 290944"/>
                      <a:gd name="connsiteX3" fmla="*/ 31309 w 229794"/>
                      <a:gd name="connsiteY3" fmla="*/ 248852 h 290944"/>
                      <a:gd name="connsiteX4" fmla="*/ 47951 w 229794"/>
                      <a:gd name="connsiteY4" fmla="*/ 172969 h 290944"/>
                      <a:gd name="connsiteX5" fmla="*/ 40942 w 229794"/>
                      <a:gd name="connsiteY5" fmla="*/ 153444 h 290944"/>
                      <a:gd name="connsiteX6" fmla="*/ 28242 w 229794"/>
                      <a:gd name="connsiteY6" fmla="*/ 96294 h 290944"/>
                      <a:gd name="connsiteX7" fmla="*/ 6017 w 229794"/>
                      <a:gd name="connsiteY7" fmla="*/ 77244 h 290944"/>
                      <a:gd name="connsiteX8" fmla="*/ 15542 w 229794"/>
                      <a:gd name="connsiteY8" fmla="*/ 26444 h 290944"/>
                      <a:gd name="connsiteX9" fmla="*/ 164437 w 229794"/>
                      <a:gd name="connsiteY9" fmla="*/ 47 h 290944"/>
                      <a:gd name="connsiteX10" fmla="*/ 224616 w 229794"/>
                      <a:gd name="connsiteY10" fmla="*/ 32288 h 290944"/>
                      <a:gd name="connsiteX11" fmla="*/ 215159 w 229794"/>
                      <a:gd name="connsiteY11" fmla="*/ 108994 h 290944"/>
                      <a:gd name="connsiteX12" fmla="*/ 123492 w 229794"/>
                      <a:gd name="connsiteY12" fmla="*/ 105819 h 290944"/>
                      <a:gd name="connsiteX13" fmla="*/ 183817 w 229794"/>
                      <a:gd name="connsiteY13" fmla="*/ 112169 h 290944"/>
                      <a:gd name="connsiteX14" fmla="*/ 225092 w 229794"/>
                      <a:gd name="connsiteY14" fmla="*/ 124869 h 290944"/>
                      <a:gd name="connsiteX15" fmla="*/ 218742 w 229794"/>
                      <a:gd name="connsiteY15" fmla="*/ 210594 h 290944"/>
                      <a:gd name="connsiteX16" fmla="*/ 164767 w 229794"/>
                      <a:gd name="connsiteY16" fmla="*/ 235994 h 290944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</a:cxnLst>
                    <a:rect l="l" t="t" r="r" b="b"/>
                    <a:pathLst>
                      <a:path w="229794" h="290944">
                        <a:moveTo>
                          <a:pt x="164767" y="235994"/>
                        </a:moveTo>
                        <a:cubicBezTo>
                          <a:pt x="154713" y="248694"/>
                          <a:pt x="171646" y="278857"/>
                          <a:pt x="158417" y="286794"/>
                        </a:cubicBezTo>
                        <a:cubicBezTo>
                          <a:pt x="145188" y="294731"/>
                          <a:pt x="106577" y="289943"/>
                          <a:pt x="85392" y="283619"/>
                        </a:cubicBezTo>
                        <a:cubicBezTo>
                          <a:pt x="64207" y="277295"/>
                          <a:pt x="37549" y="267294"/>
                          <a:pt x="31309" y="248852"/>
                        </a:cubicBezTo>
                        <a:cubicBezTo>
                          <a:pt x="25069" y="230410"/>
                          <a:pt x="46345" y="188870"/>
                          <a:pt x="47951" y="172969"/>
                        </a:cubicBezTo>
                        <a:cubicBezTo>
                          <a:pt x="49557" y="157068"/>
                          <a:pt x="44227" y="166223"/>
                          <a:pt x="40942" y="153444"/>
                        </a:cubicBezTo>
                        <a:cubicBezTo>
                          <a:pt x="37657" y="140665"/>
                          <a:pt x="34063" y="108994"/>
                          <a:pt x="28242" y="96294"/>
                        </a:cubicBezTo>
                        <a:cubicBezTo>
                          <a:pt x="22421" y="83594"/>
                          <a:pt x="8134" y="88886"/>
                          <a:pt x="6017" y="77244"/>
                        </a:cubicBezTo>
                        <a:cubicBezTo>
                          <a:pt x="3900" y="65602"/>
                          <a:pt x="-10861" y="39310"/>
                          <a:pt x="15542" y="26444"/>
                        </a:cubicBezTo>
                        <a:cubicBezTo>
                          <a:pt x="41945" y="13578"/>
                          <a:pt x="129591" y="-927"/>
                          <a:pt x="164437" y="47"/>
                        </a:cubicBezTo>
                        <a:cubicBezTo>
                          <a:pt x="199283" y="1021"/>
                          <a:pt x="216162" y="14130"/>
                          <a:pt x="224616" y="32288"/>
                        </a:cubicBezTo>
                        <a:cubicBezTo>
                          <a:pt x="233070" y="50446"/>
                          <a:pt x="232013" y="96739"/>
                          <a:pt x="215159" y="108994"/>
                        </a:cubicBezTo>
                        <a:cubicBezTo>
                          <a:pt x="198305" y="121249"/>
                          <a:pt x="128716" y="105290"/>
                          <a:pt x="123492" y="105819"/>
                        </a:cubicBezTo>
                        <a:cubicBezTo>
                          <a:pt x="118268" y="106348"/>
                          <a:pt x="166884" y="108994"/>
                          <a:pt x="183817" y="112169"/>
                        </a:cubicBezTo>
                        <a:cubicBezTo>
                          <a:pt x="200750" y="115344"/>
                          <a:pt x="219271" y="108465"/>
                          <a:pt x="225092" y="124869"/>
                        </a:cubicBezTo>
                        <a:cubicBezTo>
                          <a:pt x="230913" y="141273"/>
                          <a:pt x="221917" y="192073"/>
                          <a:pt x="218742" y="210594"/>
                        </a:cubicBezTo>
                        <a:cubicBezTo>
                          <a:pt x="215567" y="229115"/>
                          <a:pt x="174821" y="223294"/>
                          <a:pt x="164767" y="235994"/>
                        </a:cubicBezTo>
                        <a:close/>
                      </a:path>
                    </a:pathLst>
                  </a:custGeom>
                  <a:solidFill>
                    <a:srgbClr val="D2A79B"/>
                  </a:solidFill>
                  <a:ln w="6350">
                    <a:solidFill>
                      <a:schemeClr val="bg2">
                        <a:lumMod val="1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NL" sz="700" dirty="0"/>
                  </a:p>
                </p:txBody>
              </p:sp>
              <p:sp>
                <p:nvSpPr>
                  <p:cNvPr id="59" name="Freeform 99">
                    <a:extLst>
                      <a:ext uri="{FF2B5EF4-FFF2-40B4-BE49-F238E27FC236}">
                        <a16:creationId xmlns:a16="http://schemas.microsoft.com/office/drawing/2014/main" id="{3F287667-80E5-A243-574A-11E3F77E6402}"/>
                      </a:ext>
                    </a:extLst>
                  </p:cNvPr>
                  <p:cNvSpPr/>
                  <p:nvPr/>
                </p:nvSpPr>
                <p:spPr>
                  <a:xfrm>
                    <a:off x="7957681" y="2738688"/>
                    <a:ext cx="172047" cy="129260"/>
                  </a:xfrm>
                  <a:custGeom>
                    <a:avLst/>
                    <a:gdLst>
                      <a:gd name="connsiteX0" fmla="*/ 173440 w 181722"/>
                      <a:gd name="connsiteY0" fmla="*/ 81374 h 132836"/>
                      <a:gd name="connsiteX1" fmla="*/ 154390 w 181722"/>
                      <a:gd name="connsiteY1" fmla="*/ 132174 h 132836"/>
                      <a:gd name="connsiteX2" fmla="*/ 94065 w 181722"/>
                      <a:gd name="connsiteY2" fmla="*/ 106774 h 132836"/>
                      <a:gd name="connsiteX3" fmla="*/ 5165 w 181722"/>
                      <a:gd name="connsiteY3" fmla="*/ 55974 h 132836"/>
                      <a:gd name="connsiteX4" fmla="*/ 17865 w 181722"/>
                      <a:gd name="connsiteY4" fmla="*/ 5174 h 132836"/>
                      <a:gd name="connsiteX5" fmla="*/ 78190 w 181722"/>
                      <a:gd name="connsiteY5" fmla="*/ 5174 h 132836"/>
                      <a:gd name="connsiteX6" fmla="*/ 173440 w 181722"/>
                      <a:gd name="connsiteY6" fmla="*/ 5174 h 132836"/>
                      <a:gd name="connsiteX7" fmla="*/ 173440 w 181722"/>
                      <a:gd name="connsiteY7" fmla="*/ 81374 h 132836"/>
                      <a:gd name="connsiteX0" fmla="*/ 173440 w 181834"/>
                      <a:gd name="connsiteY0" fmla="*/ 81374 h 111356"/>
                      <a:gd name="connsiteX1" fmla="*/ 151774 w 181834"/>
                      <a:gd name="connsiteY1" fmla="*/ 106080 h 111356"/>
                      <a:gd name="connsiteX2" fmla="*/ 94065 w 181834"/>
                      <a:gd name="connsiteY2" fmla="*/ 106774 h 111356"/>
                      <a:gd name="connsiteX3" fmla="*/ 5165 w 181834"/>
                      <a:gd name="connsiteY3" fmla="*/ 55974 h 111356"/>
                      <a:gd name="connsiteX4" fmla="*/ 17865 w 181834"/>
                      <a:gd name="connsiteY4" fmla="*/ 5174 h 111356"/>
                      <a:gd name="connsiteX5" fmla="*/ 78190 w 181834"/>
                      <a:gd name="connsiteY5" fmla="*/ 5174 h 111356"/>
                      <a:gd name="connsiteX6" fmla="*/ 173440 w 181834"/>
                      <a:gd name="connsiteY6" fmla="*/ 5174 h 111356"/>
                      <a:gd name="connsiteX7" fmla="*/ 173440 w 181834"/>
                      <a:gd name="connsiteY7" fmla="*/ 81374 h 11135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</a:cxnLst>
                    <a:rect l="l" t="t" r="r" b="b"/>
                    <a:pathLst>
                      <a:path w="181834" h="111356">
                        <a:moveTo>
                          <a:pt x="173440" y="81374"/>
                        </a:moveTo>
                        <a:cubicBezTo>
                          <a:pt x="169829" y="98192"/>
                          <a:pt x="165003" y="101847"/>
                          <a:pt x="151774" y="106080"/>
                        </a:cubicBezTo>
                        <a:cubicBezTo>
                          <a:pt x="138545" y="110313"/>
                          <a:pt x="118500" y="115125"/>
                          <a:pt x="94065" y="106774"/>
                        </a:cubicBezTo>
                        <a:cubicBezTo>
                          <a:pt x="69630" y="98423"/>
                          <a:pt x="17865" y="72907"/>
                          <a:pt x="5165" y="55974"/>
                        </a:cubicBezTo>
                        <a:cubicBezTo>
                          <a:pt x="-7535" y="39041"/>
                          <a:pt x="5694" y="13641"/>
                          <a:pt x="17865" y="5174"/>
                        </a:cubicBezTo>
                        <a:cubicBezTo>
                          <a:pt x="30036" y="-3293"/>
                          <a:pt x="78190" y="5174"/>
                          <a:pt x="78190" y="5174"/>
                        </a:cubicBezTo>
                        <a:cubicBezTo>
                          <a:pt x="104119" y="5174"/>
                          <a:pt x="156507" y="-6468"/>
                          <a:pt x="173440" y="5174"/>
                        </a:cubicBezTo>
                        <a:cubicBezTo>
                          <a:pt x="190373" y="16816"/>
                          <a:pt x="177051" y="64556"/>
                          <a:pt x="173440" y="81374"/>
                        </a:cubicBezTo>
                        <a:close/>
                      </a:path>
                    </a:pathLst>
                  </a:custGeom>
                  <a:solidFill>
                    <a:schemeClr val="bg1">
                      <a:lumMod val="95000"/>
                    </a:schemeClr>
                  </a:solidFill>
                  <a:ln w="6350">
                    <a:solidFill>
                      <a:schemeClr val="bg2">
                        <a:lumMod val="1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NL" sz="700"/>
                  </a:p>
                </p:txBody>
              </p:sp>
            </p:grpSp>
            <p:sp>
              <p:nvSpPr>
                <p:cNvPr id="50" name="Oval 49">
                  <a:extLst>
                    <a:ext uri="{FF2B5EF4-FFF2-40B4-BE49-F238E27FC236}">
                      <a16:creationId xmlns:a16="http://schemas.microsoft.com/office/drawing/2014/main" id="{00BC2BEE-6557-C536-FBFC-E98BE8C7DED5}"/>
                    </a:ext>
                  </a:extLst>
                </p:cNvPr>
                <p:cNvSpPr/>
                <p:nvPr/>
              </p:nvSpPr>
              <p:spPr>
                <a:xfrm>
                  <a:off x="3208939" y="1537276"/>
                  <a:ext cx="96636" cy="97642"/>
                </a:xfrm>
                <a:prstGeom prst="ellipse">
                  <a:avLst/>
                </a:prstGeom>
                <a:solidFill>
                  <a:schemeClr val="tx1">
                    <a:lumMod val="65000"/>
                    <a:lumOff val="35000"/>
                    <a:alpha val="98394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dirty="0"/>
                </a:p>
              </p:txBody>
            </p:sp>
            <p:sp>
              <p:nvSpPr>
                <p:cNvPr id="51" name="Oval 50">
                  <a:extLst>
                    <a:ext uri="{FF2B5EF4-FFF2-40B4-BE49-F238E27FC236}">
                      <a16:creationId xmlns:a16="http://schemas.microsoft.com/office/drawing/2014/main" id="{D45368D2-DAF1-8015-2048-2FD2E6C4309B}"/>
                    </a:ext>
                  </a:extLst>
                </p:cNvPr>
                <p:cNvSpPr/>
                <p:nvPr/>
              </p:nvSpPr>
              <p:spPr>
                <a:xfrm>
                  <a:off x="3330472" y="1534772"/>
                  <a:ext cx="96636" cy="96226"/>
                </a:xfrm>
                <a:prstGeom prst="ellipse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/>
                </a:p>
              </p:txBody>
            </p:sp>
            <p:sp>
              <p:nvSpPr>
                <p:cNvPr id="52" name="Rounded Rectangle 92">
                  <a:extLst>
                    <a:ext uri="{FF2B5EF4-FFF2-40B4-BE49-F238E27FC236}">
                      <a16:creationId xmlns:a16="http://schemas.microsoft.com/office/drawing/2014/main" id="{E2A53B21-86F5-0549-4A25-16BBA9A767E8}"/>
                    </a:ext>
                  </a:extLst>
                </p:cNvPr>
                <p:cNvSpPr/>
                <p:nvPr/>
              </p:nvSpPr>
              <p:spPr>
                <a:xfrm rot="17303525">
                  <a:off x="3339742" y="2316954"/>
                  <a:ext cx="117475" cy="45719"/>
                </a:xfrm>
                <a:prstGeom prst="round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/>
                </a:p>
              </p:txBody>
            </p:sp>
            <p:cxnSp>
              <p:nvCxnSpPr>
                <p:cNvPr id="53" name="Straight Connector 52">
                  <a:extLst>
                    <a:ext uri="{FF2B5EF4-FFF2-40B4-BE49-F238E27FC236}">
                      <a16:creationId xmlns:a16="http://schemas.microsoft.com/office/drawing/2014/main" id="{A1622F49-D429-24A0-4D5E-3BBD80159A4F}"/>
                    </a:ext>
                  </a:extLst>
                </p:cNvPr>
                <p:cNvCxnSpPr>
                  <a:cxnSpLocks/>
                  <a:stCxn id="50" idx="6"/>
                  <a:endCxn id="51" idx="2"/>
                </p:cNvCxnSpPr>
                <p:nvPr/>
              </p:nvCxnSpPr>
              <p:spPr>
                <a:xfrm flipV="1">
                  <a:off x="3305575" y="1582885"/>
                  <a:ext cx="24897" cy="321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Straight Connector 53">
                  <a:extLst>
                    <a:ext uri="{FF2B5EF4-FFF2-40B4-BE49-F238E27FC236}">
                      <a16:creationId xmlns:a16="http://schemas.microsoft.com/office/drawing/2014/main" id="{747BFCA6-758D-5088-1A68-125391F5D61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653671" y="2039680"/>
                  <a:ext cx="74693" cy="231107"/>
                </a:xfrm>
                <a:prstGeom prst="line">
                  <a:avLst/>
                </a:prstGeom>
                <a:ln w="9525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5" name="Rounded Rectangle 95">
                  <a:extLst>
                    <a:ext uri="{FF2B5EF4-FFF2-40B4-BE49-F238E27FC236}">
                      <a16:creationId xmlns:a16="http://schemas.microsoft.com/office/drawing/2014/main" id="{4A26A101-1AAC-0A9D-68F5-E122683F6728}"/>
                    </a:ext>
                  </a:extLst>
                </p:cNvPr>
                <p:cNvSpPr/>
                <p:nvPr/>
              </p:nvSpPr>
              <p:spPr>
                <a:xfrm rot="17303525">
                  <a:off x="3699380" y="1967789"/>
                  <a:ext cx="95776" cy="53703"/>
                </a:xfrm>
                <a:prstGeom prst="round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/>
                </a:p>
              </p:txBody>
            </p:sp>
            <p:sp>
              <p:nvSpPr>
                <p:cNvPr id="56" name="Freeform 96">
                  <a:extLst>
                    <a:ext uri="{FF2B5EF4-FFF2-40B4-BE49-F238E27FC236}">
                      <a16:creationId xmlns:a16="http://schemas.microsoft.com/office/drawing/2014/main" id="{AEE515D6-0C07-8BFE-D8B9-150FF5BBB1E2}"/>
                    </a:ext>
                  </a:extLst>
                </p:cNvPr>
                <p:cNvSpPr/>
                <p:nvPr/>
              </p:nvSpPr>
              <p:spPr>
                <a:xfrm rot="21040798">
                  <a:off x="3257459" y="2283996"/>
                  <a:ext cx="221568" cy="134292"/>
                </a:xfrm>
                <a:custGeom>
                  <a:avLst/>
                  <a:gdLst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736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3768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332367 w 558286"/>
                    <a:gd name="connsiteY12" fmla="*/ 163337 h 359548"/>
                    <a:gd name="connsiteX13" fmla="*/ 424442 w 558286"/>
                    <a:gd name="connsiteY13" fmla="*/ 182387 h 359548"/>
                    <a:gd name="connsiteX14" fmla="*/ 519692 w 558286"/>
                    <a:gd name="connsiteY14" fmla="*/ 220487 h 359548"/>
                    <a:gd name="connsiteX15" fmla="*/ 557792 w 558286"/>
                    <a:gd name="connsiteY15" fmla="*/ 220487 h 359548"/>
                    <a:gd name="connsiteX16" fmla="*/ 529217 w 558286"/>
                    <a:gd name="connsiteY16" fmla="*/ 179212 h 359548"/>
                    <a:gd name="connsiteX17" fmla="*/ 379992 w 558286"/>
                    <a:gd name="connsiteY17" fmla="*/ 144287 h 359548"/>
                    <a:gd name="connsiteX18" fmla="*/ 335542 w 558286"/>
                    <a:gd name="connsiteY18" fmla="*/ 103012 h 359548"/>
                    <a:gd name="connsiteX19" fmla="*/ 427617 w 558286"/>
                    <a:gd name="connsiteY19" fmla="*/ 122062 h 359548"/>
                    <a:gd name="connsiteX20" fmla="*/ 503817 w 558286"/>
                    <a:gd name="connsiteY20" fmla="*/ 150637 h 359548"/>
                    <a:gd name="connsiteX21" fmla="*/ 510167 w 558286"/>
                    <a:gd name="connsiteY21" fmla="*/ 109362 h 359548"/>
                    <a:gd name="connsiteX22" fmla="*/ 411742 w 558286"/>
                    <a:gd name="connsiteY22" fmla="*/ 52212 h 359548"/>
                    <a:gd name="connsiteX23" fmla="*/ 322842 w 558286"/>
                    <a:gd name="connsiteY23" fmla="*/ 23637 h 359548"/>
                    <a:gd name="connsiteX24" fmla="*/ 243467 w 558286"/>
                    <a:gd name="connsiteY24" fmla="*/ 64912 h 359548"/>
                    <a:gd name="connsiteX25" fmla="*/ 205367 w 558286"/>
                    <a:gd name="connsiteY25" fmla="*/ 144287 h 359548"/>
                    <a:gd name="connsiteX26" fmla="*/ 249817 w 558286"/>
                    <a:gd name="connsiteY26" fmla="*/ 55387 h 359548"/>
                    <a:gd name="connsiteX27" fmla="*/ 214892 w 558286"/>
                    <a:gd name="connsiteY27" fmla="*/ 1412 h 359548"/>
                    <a:gd name="connsiteX28" fmla="*/ 97417 w 558286"/>
                    <a:gd name="connsiteY28" fmla="*/ 23637 h 359548"/>
                    <a:gd name="connsiteX29" fmla="*/ 27567 w 558286"/>
                    <a:gd name="connsiteY29" fmla="*/ 106187 h 359548"/>
                    <a:gd name="connsiteX30" fmla="*/ 2167 w 558286"/>
                    <a:gd name="connsiteY30" fmla="*/ 220487 h 359548"/>
                    <a:gd name="connsiteX31" fmla="*/ 78367 w 558286"/>
                    <a:gd name="connsiteY31" fmla="*/ 242712 h 359548"/>
                    <a:gd name="connsiteX32" fmla="*/ 68842 w 558286"/>
                    <a:gd name="connsiteY32" fmla="*/ 188737 h 359548"/>
                    <a:gd name="connsiteX33" fmla="*/ 81542 w 558286"/>
                    <a:gd name="connsiteY33" fmla="*/ 125237 h 359548"/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736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3768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332367 w 558286"/>
                    <a:gd name="connsiteY12" fmla="*/ 163337 h 359548"/>
                    <a:gd name="connsiteX13" fmla="*/ 424442 w 558286"/>
                    <a:gd name="connsiteY13" fmla="*/ 182387 h 359548"/>
                    <a:gd name="connsiteX14" fmla="*/ 519692 w 558286"/>
                    <a:gd name="connsiteY14" fmla="*/ 220487 h 359548"/>
                    <a:gd name="connsiteX15" fmla="*/ 557792 w 558286"/>
                    <a:gd name="connsiteY15" fmla="*/ 220487 h 359548"/>
                    <a:gd name="connsiteX16" fmla="*/ 529217 w 558286"/>
                    <a:gd name="connsiteY16" fmla="*/ 179212 h 359548"/>
                    <a:gd name="connsiteX17" fmla="*/ 379992 w 558286"/>
                    <a:gd name="connsiteY17" fmla="*/ 134762 h 359548"/>
                    <a:gd name="connsiteX18" fmla="*/ 335542 w 558286"/>
                    <a:gd name="connsiteY18" fmla="*/ 103012 h 359548"/>
                    <a:gd name="connsiteX19" fmla="*/ 427617 w 558286"/>
                    <a:gd name="connsiteY19" fmla="*/ 122062 h 359548"/>
                    <a:gd name="connsiteX20" fmla="*/ 503817 w 558286"/>
                    <a:gd name="connsiteY20" fmla="*/ 150637 h 359548"/>
                    <a:gd name="connsiteX21" fmla="*/ 510167 w 558286"/>
                    <a:gd name="connsiteY21" fmla="*/ 109362 h 359548"/>
                    <a:gd name="connsiteX22" fmla="*/ 411742 w 558286"/>
                    <a:gd name="connsiteY22" fmla="*/ 52212 h 359548"/>
                    <a:gd name="connsiteX23" fmla="*/ 322842 w 558286"/>
                    <a:gd name="connsiteY23" fmla="*/ 23637 h 359548"/>
                    <a:gd name="connsiteX24" fmla="*/ 243467 w 558286"/>
                    <a:gd name="connsiteY24" fmla="*/ 64912 h 359548"/>
                    <a:gd name="connsiteX25" fmla="*/ 205367 w 558286"/>
                    <a:gd name="connsiteY25" fmla="*/ 144287 h 359548"/>
                    <a:gd name="connsiteX26" fmla="*/ 249817 w 558286"/>
                    <a:gd name="connsiteY26" fmla="*/ 55387 h 359548"/>
                    <a:gd name="connsiteX27" fmla="*/ 214892 w 558286"/>
                    <a:gd name="connsiteY27" fmla="*/ 1412 h 359548"/>
                    <a:gd name="connsiteX28" fmla="*/ 97417 w 558286"/>
                    <a:gd name="connsiteY28" fmla="*/ 23637 h 359548"/>
                    <a:gd name="connsiteX29" fmla="*/ 27567 w 558286"/>
                    <a:gd name="connsiteY29" fmla="*/ 106187 h 359548"/>
                    <a:gd name="connsiteX30" fmla="*/ 2167 w 558286"/>
                    <a:gd name="connsiteY30" fmla="*/ 220487 h 359548"/>
                    <a:gd name="connsiteX31" fmla="*/ 78367 w 558286"/>
                    <a:gd name="connsiteY31" fmla="*/ 242712 h 359548"/>
                    <a:gd name="connsiteX32" fmla="*/ 68842 w 558286"/>
                    <a:gd name="connsiteY32" fmla="*/ 188737 h 359548"/>
                    <a:gd name="connsiteX33" fmla="*/ 81542 w 558286"/>
                    <a:gd name="connsiteY33" fmla="*/ 125237 h 359548"/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736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3768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332367 w 558286"/>
                    <a:gd name="connsiteY12" fmla="*/ 163337 h 359548"/>
                    <a:gd name="connsiteX13" fmla="*/ 424442 w 558286"/>
                    <a:gd name="connsiteY13" fmla="*/ 198262 h 359548"/>
                    <a:gd name="connsiteX14" fmla="*/ 519692 w 558286"/>
                    <a:gd name="connsiteY14" fmla="*/ 220487 h 359548"/>
                    <a:gd name="connsiteX15" fmla="*/ 557792 w 558286"/>
                    <a:gd name="connsiteY15" fmla="*/ 220487 h 359548"/>
                    <a:gd name="connsiteX16" fmla="*/ 529217 w 558286"/>
                    <a:gd name="connsiteY16" fmla="*/ 179212 h 359548"/>
                    <a:gd name="connsiteX17" fmla="*/ 379992 w 558286"/>
                    <a:gd name="connsiteY17" fmla="*/ 134762 h 359548"/>
                    <a:gd name="connsiteX18" fmla="*/ 335542 w 558286"/>
                    <a:gd name="connsiteY18" fmla="*/ 103012 h 359548"/>
                    <a:gd name="connsiteX19" fmla="*/ 427617 w 558286"/>
                    <a:gd name="connsiteY19" fmla="*/ 122062 h 359548"/>
                    <a:gd name="connsiteX20" fmla="*/ 503817 w 558286"/>
                    <a:gd name="connsiteY20" fmla="*/ 150637 h 359548"/>
                    <a:gd name="connsiteX21" fmla="*/ 510167 w 558286"/>
                    <a:gd name="connsiteY21" fmla="*/ 109362 h 359548"/>
                    <a:gd name="connsiteX22" fmla="*/ 411742 w 558286"/>
                    <a:gd name="connsiteY22" fmla="*/ 52212 h 359548"/>
                    <a:gd name="connsiteX23" fmla="*/ 322842 w 558286"/>
                    <a:gd name="connsiteY23" fmla="*/ 23637 h 359548"/>
                    <a:gd name="connsiteX24" fmla="*/ 243467 w 558286"/>
                    <a:gd name="connsiteY24" fmla="*/ 64912 h 359548"/>
                    <a:gd name="connsiteX25" fmla="*/ 205367 w 558286"/>
                    <a:gd name="connsiteY25" fmla="*/ 144287 h 359548"/>
                    <a:gd name="connsiteX26" fmla="*/ 249817 w 558286"/>
                    <a:gd name="connsiteY26" fmla="*/ 55387 h 359548"/>
                    <a:gd name="connsiteX27" fmla="*/ 214892 w 558286"/>
                    <a:gd name="connsiteY27" fmla="*/ 1412 h 359548"/>
                    <a:gd name="connsiteX28" fmla="*/ 97417 w 558286"/>
                    <a:gd name="connsiteY28" fmla="*/ 23637 h 359548"/>
                    <a:gd name="connsiteX29" fmla="*/ 27567 w 558286"/>
                    <a:gd name="connsiteY29" fmla="*/ 106187 h 359548"/>
                    <a:gd name="connsiteX30" fmla="*/ 2167 w 558286"/>
                    <a:gd name="connsiteY30" fmla="*/ 220487 h 359548"/>
                    <a:gd name="connsiteX31" fmla="*/ 78367 w 558286"/>
                    <a:gd name="connsiteY31" fmla="*/ 242712 h 359548"/>
                    <a:gd name="connsiteX32" fmla="*/ 68842 w 558286"/>
                    <a:gd name="connsiteY32" fmla="*/ 188737 h 359548"/>
                    <a:gd name="connsiteX33" fmla="*/ 81542 w 558286"/>
                    <a:gd name="connsiteY33" fmla="*/ 125237 h 359548"/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736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3768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424442 w 558286"/>
                    <a:gd name="connsiteY12" fmla="*/ 198262 h 359548"/>
                    <a:gd name="connsiteX13" fmla="*/ 519692 w 558286"/>
                    <a:gd name="connsiteY13" fmla="*/ 220487 h 359548"/>
                    <a:gd name="connsiteX14" fmla="*/ 557792 w 558286"/>
                    <a:gd name="connsiteY14" fmla="*/ 220487 h 359548"/>
                    <a:gd name="connsiteX15" fmla="*/ 529217 w 558286"/>
                    <a:gd name="connsiteY15" fmla="*/ 179212 h 359548"/>
                    <a:gd name="connsiteX16" fmla="*/ 379992 w 558286"/>
                    <a:gd name="connsiteY16" fmla="*/ 134762 h 359548"/>
                    <a:gd name="connsiteX17" fmla="*/ 335542 w 558286"/>
                    <a:gd name="connsiteY17" fmla="*/ 103012 h 359548"/>
                    <a:gd name="connsiteX18" fmla="*/ 427617 w 558286"/>
                    <a:gd name="connsiteY18" fmla="*/ 122062 h 359548"/>
                    <a:gd name="connsiteX19" fmla="*/ 503817 w 558286"/>
                    <a:gd name="connsiteY19" fmla="*/ 150637 h 359548"/>
                    <a:gd name="connsiteX20" fmla="*/ 510167 w 558286"/>
                    <a:gd name="connsiteY20" fmla="*/ 109362 h 359548"/>
                    <a:gd name="connsiteX21" fmla="*/ 411742 w 558286"/>
                    <a:gd name="connsiteY21" fmla="*/ 52212 h 359548"/>
                    <a:gd name="connsiteX22" fmla="*/ 322842 w 558286"/>
                    <a:gd name="connsiteY22" fmla="*/ 23637 h 359548"/>
                    <a:gd name="connsiteX23" fmla="*/ 243467 w 558286"/>
                    <a:gd name="connsiteY23" fmla="*/ 64912 h 359548"/>
                    <a:gd name="connsiteX24" fmla="*/ 205367 w 558286"/>
                    <a:gd name="connsiteY24" fmla="*/ 144287 h 359548"/>
                    <a:gd name="connsiteX25" fmla="*/ 249817 w 558286"/>
                    <a:gd name="connsiteY25" fmla="*/ 55387 h 359548"/>
                    <a:gd name="connsiteX26" fmla="*/ 214892 w 558286"/>
                    <a:gd name="connsiteY26" fmla="*/ 1412 h 359548"/>
                    <a:gd name="connsiteX27" fmla="*/ 97417 w 558286"/>
                    <a:gd name="connsiteY27" fmla="*/ 23637 h 359548"/>
                    <a:gd name="connsiteX28" fmla="*/ 27567 w 558286"/>
                    <a:gd name="connsiteY28" fmla="*/ 106187 h 359548"/>
                    <a:gd name="connsiteX29" fmla="*/ 2167 w 558286"/>
                    <a:gd name="connsiteY29" fmla="*/ 220487 h 359548"/>
                    <a:gd name="connsiteX30" fmla="*/ 78367 w 558286"/>
                    <a:gd name="connsiteY30" fmla="*/ 242712 h 359548"/>
                    <a:gd name="connsiteX31" fmla="*/ 68842 w 558286"/>
                    <a:gd name="connsiteY31" fmla="*/ 188737 h 359548"/>
                    <a:gd name="connsiteX32" fmla="*/ 81542 w 558286"/>
                    <a:gd name="connsiteY32" fmla="*/ 125237 h 359548"/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736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3768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386342 w 558286"/>
                    <a:gd name="connsiteY12" fmla="*/ 182387 h 359548"/>
                    <a:gd name="connsiteX13" fmla="*/ 519692 w 558286"/>
                    <a:gd name="connsiteY13" fmla="*/ 220487 h 359548"/>
                    <a:gd name="connsiteX14" fmla="*/ 557792 w 558286"/>
                    <a:gd name="connsiteY14" fmla="*/ 220487 h 359548"/>
                    <a:gd name="connsiteX15" fmla="*/ 529217 w 558286"/>
                    <a:gd name="connsiteY15" fmla="*/ 179212 h 359548"/>
                    <a:gd name="connsiteX16" fmla="*/ 379992 w 558286"/>
                    <a:gd name="connsiteY16" fmla="*/ 134762 h 359548"/>
                    <a:gd name="connsiteX17" fmla="*/ 335542 w 558286"/>
                    <a:gd name="connsiteY17" fmla="*/ 103012 h 359548"/>
                    <a:gd name="connsiteX18" fmla="*/ 427617 w 558286"/>
                    <a:gd name="connsiteY18" fmla="*/ 122062 h 359548"/>
                    <a:gd name="connsiteX19" fmla="*/ 503817 w 558286"/>
                    <a:gd name="connsiteY19" fmla="*/ 150637 h 359548"/>
                    <a:gd name="connsiteX20" fmla="*/ 510167 w 558286"/>
                    <a:gd name="connsiteY20" fmla="*/ 109362 h 359548"/>
                    <a:gd name="connsiteX21" fmla="*/ 411742 w 558286"/>
                    <a:gd name="connsiteY21" fmla="*/ 52212 h 359548"/>
                    <a:gd name="connsiteX22" fmla="*/ 322842 w 558286"/>
                    <a:gd name="connsiteY22" fmla="*/ 23637 h 359548"/>
                    <a:gd name="connsiteX23" fmla="*/ 243467 w 558286"/>
                    <a:gd name="connsiteY23" fmla="*/ 64912 h 359548"/>
                    <a:gd name="connsiteX24" fmla="*/ 205367 w 558286"/>
                    <a:gd name="connsiteY24" fmla="*/ 144287 h 359548"/>
                    <a:gd name="connsiteX25" fmla="*/ 249817 w 558286"/>
                    <a:gd name="connsiteY25" fmla="*/ 55387 h 359548"/>
                    <a:gd name="connsiteX26" fmla="*/ 214892 w 558286"/>
                    <a:gd name="connsiteY26" fmla="*/ 1412 h 359548"/>
                    <a:gd name="connsiteX27" fmla="*/ 97417 w 558286"/>
                    <a:gd name="connsiteY27" fmla="*/ 23637 h 359548"/>
                    <a:gd name="connsiteX28" fmla="*/ 27567 w 558286"/>
                    <a:gd name="connsiteY28" fmla="*/ 106187 h 359548"/>
                    <a:gd name="connsiteX29" fmla="*/ 2167 w 558286"/>
                    <a:gd name="connsiteY29" fmla="*/ 220487 h 359548"/>
                    <a:gd name="connsiteX30" fmla="*/ 78367 w 558286"/>
                    <a:gd name="connsiteY30" fmla="*/ 242712 h 359548"/>
                    <a:gd name="connsiteX31" fmla="*/ 68842 w 558286"/>
                    <a:gd name="connsiteY31" fmla="*/ 188737 h 359548"/>
                    <a:gd name="connsiteX32" fmla="*/ 81542 w 558286"/>
                    <a:gd name="connsiteY32" fmla="*/ 125237 h 359548"/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736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4022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386342 w 558286"/>
                    <a:gd name="connsiteY12" fmla="*/ 182387 h 359548"/>
                    <a:gd name="connsiteX13" fmla="*/ 519692 w 558286"/>
                    <a:gd name="connsiteY13" fmla="*/ 220487 h 359548"/>
                    <a:gd name="connsiteX14" fmla="*/ 557792 w 558286"/>
                    <a:gd name="connsiteY14" fmla="*/ 220487 h 359548"/>
                    <a:gd name="connsiteX15" fmla="*/ 529217 w 558286"/>
                    <a:gd name="connsiteY15" fmla="*/ 179212 h 359548"/>
                    <a:gd name="connsiteX16" fmla="*/ 379992 w 558286"/>
                    <a:gd name="connsiteY16" fmla="*/ 134762 h 359548"/>
                    <a:gd name="connsiteX17" fmla="*/ 335542 w 558286"/>
                    <a:gd name="connsiteY17" fmla="*/ 103012 h 359548"/>
                    <a:gd name="connsiteX18" fmla="*/ 427617 w 558286"/>
                    <a:gd name="connsiteY18" fmla="*/ 122062 h 359548"/>
                    <a:gd name="connsiteX19" fmla="*/ 503817 w 558286"/>
                    <a:gd name="connsiteY19" fmla="*/ 150637 h 359548"/>
                    <a:gd name="connsiteX20" fmla="*/ 510167 w 558286"/>
                    <a:gd name="connsiteY20" fmla="*/ 109362 h 359548"/>
                    <a:gd name="connsiteX21" fmla="*/ 411742 w 558286"/>
                    <a:gd name="connsiteY21" fmla="*/ 52212 h 359548"/>
                    <a:gd name="connsiteX22" fmla="*/ 322842 w 558286"/>
                    <a:gd name="connsiteY22" fmla="*/ 23637 h 359548"/>
                    <a:gd name="connsiteX23" fmla="*/ 243467 w 558286"/>
                    <a:gd name="connsiteY23" fmla="*/ 64912 h 359548"/>
                    <a:gd name="connsiteX24" fmla="*/ 205367 w 558286"/>
                    <a:gd name="connsiteY24" fmla="*/ 144287 h 359548"/>
                    <a:gd name="connsiteX25" fmla="*/ 249817 w 558286"/>
                    <a:gd name="connsiteY25" fmla="*/ 55387 h 359548"/>
                    <a:gd name="connsiteX26" fmla="*/ 214892 w 558286"/>
                    <a:gd name="connsiteY26" fmla="*/ 1412 h 359548"/>
                    <a:gd name="connsiteX27" fmla="*/ 97417 w 558286"/>
                    <a:gd name="connsiteY27" fmla="*/ 23637 h 359548"/>
                    <a:gd name="connsiteX28" fmla="*/ 27567 w 558286"/>
                    <a:gd name="connsiteY28" fmla="*/ 106187 h 359548"/>
                    <a:gd name="connsiteX29" fmla="*/ 2167 w 558286"/>
                    <a:gd name="connsiteY29" fmla="*/ 220487 h 359548"/>
                    <a:gd name="connsiteX30" fmla="*/ 78367 w 558286"/>
                    <a:gd name="connsiteY30" fmla="*/ 242712 h 359548"/>
                    <a:gd name="connsiteX31" fmla="*/ 68842 w 558286"/>
                    <a:gd name="connsiteY31" fmla="*/ 188737 h 359548"/>
                    <a:gd name="connsiteX32" fmla="*/ 81542 w 558286"/>
                    <a:gd name="connsiteY32" fmla="*/ 125237 h 359548"/>
                    <a:gd name="connsiteX0" fmla="*/ 81542 w 558286"/>
                    <a:gd name="connsiteY0" fmla="*/ 125237 h 359548"/>
                    <a:gd name="connsiteX1" fmla="*/ 116467 w 558286"/>
                    <a:gd name="connsiteY1" fmla="*/ 249062 h 359548"/>
                    <a:gd name="connsiteX2" fmla="*/ 427617 w 558286"/>
                    <a:gd name="connsiteY2" fmla="*/ 357012 h 359548"/>
                    <a:gd name="connsiteX3" fmla="*/ 459367 w 558286"/>
                    <a:gd name="connsiteY3" fmla="*/ 322087 h 359548"/>
                    <a:gd name="connsiteX4" fmla="*/ 335542 w 558286"/>
                    <a:gd name="connsiteY4" fmla="*/ 283987 h 359548"/>
                    <a:gd name="connsiteX5" fmla="*/ 294267 w 558286"/>
                    <a:gd name="connsiteY5" fmla="*/ 258587 h 359548"/>
                    <a:gd name="connsiteX6" fmla="*/ 313317 w 558286"/>
                    <a:gd name="connsiteY6" fmla="*/ 236362 h 359548"/>
                    <a:gd name="connsiteX7" fmla="*/ 453017 w 558286"/>
                    <a:gd name="connsiteY7" fmla="*/ 274462 h 359548"/>
                    <a:gd name="connsiteX8" fmla="*/ 497467 w 558286"/>
                    <a:gd name="connsiteY8" fmla="*/ 268112 h 359548"/>
                    <a:gd name="connsiteX9" fmla="*/ 484767 w 558286"/>
                    <a:gd name="connsiteY9" fmla="*/ 242712 h 359548"/>
                    <a:gd name="connsiteX10" fmla="*/ 402217 w 558286"/>
                    <a:gd name="connsiteY10" fmla="*/ 210962 h 359548"/>
                    <a:gd name="connsiteX11" fmla="*/ 316492 w 558286"/>
                    <a:gd name="connsiteY11" fmla="*/ 191912 h 359548"/>
                    <a:gd name="connsiteX12" fmla="*/ 386342 w 558286"/>
                    <a:gd name="connsiteY12" fmla="*/ 182387 h 359548"/>
                    <a:gd name="connsiteX13" fmla="*/ 519692 w 558286"/>
                    <a:gd name="connsiteY13" fmla="*/ 220487 h 359548"/>
                    <a:gd name="connsiteX14" fmla="*/ 557792 w 558286"/>
                    <a:gd name="connsiteY14" fmla="*/ 220487 h 359548"/>
                    <a:gd name="connsiteX15" fmla="*/ 529217 w 558286"/>
                    <a:gd name="connsiteY15" fmla="*/ 179212 h 359548"/>
                    <a:gd name="connsiteX16" fmla="*/ 379992 w 558286"/>
                    <a:gd name="connsiteY16" fmla="*/ 134762 h 359548"/>
                    <a:gd name="connsiteX17" fmla="*/ 335542 w 558286"/>
                    <a:gd name="connsiteY17" fmla="*/ 103012 h 359548"/>
                    <a:gd name="connsiteX18" fmla="*/ 427617 w 558286"/>
                    <a:gd name="connsiteY18" fmla="*/ 122062 h 359548"/>
                    <a:gd name="connsiteX19" fmla="*/ 503817 w 558286"/>
                    <a:gd name="connsiteY19" fmla="*/ 150637 h 359548"/>
                    <a:gd name="connsiteX20" fmla="*/ 510167 w 558286"/>
                    <a:gd name="connsiteY20" fmla="*/ 109362 h 359548"/>
                    <a:gd name="connsiteX21" fmla="*/ 411742 w 558286"/>
                    <a:gd name="connsiteY21" fmla="*/ 52212 h 359548"/>
                    <a:gd name="connsiteX22" fmla="*/ 322842 w 558286"/>
                    <a:gd name="connsiteY22" fmla="*/ 23637 h 359548"/>
                    <a:gd name="connsiteX23" fmla="*/ 243467 w 558286"/>
                    <a:gd name="connsiteY23" fmla="*/ 64912 h 359548"/>
                    <a:gd name="connsiteX24" fmla="*/ 205367 w 558286"/>
                    <a:gd name="connsiteY24" fmla="*/ 144287 h 359548"/>
                    <a:gd name="connsiteX25" fmla="*/ 249817 w 558286"/>
                    <a:gd name="connsiteY25" fmla="*/ 55387 h 359548"/>
                    <a:gd name="connsiteX26" fmla="*/ 214892 w 558286"/>
                    <a:gd name="connsiteY26" fmla="*/ 1412 h 359548"/>
                    <a:gd name="connsiteX27" fmla="*/ 97417 w 558286"/>
                    <a:gd name="connsiteY27" fmla="*/ 23637 h 359548"/>
                    <a:gd name="connsiteX28" fmla="*/ 27567 w 558286"/>
                    <a:gd name="connsiteY28" fmla="*/ 106187 h 359548"/>
                    <a:gd name="connsiteX29" fmla="*/ 2167 w 558286"/>
                    <a:gd name="connsiteY29" fmla="*/ 220487 h 359548"/>
                    <a:gd name="connsiteX30" fmla="*/ 78367 w 558286"/>
                    <a:gd name="connsiteY30" fmla="*/ 242712 h 359548"/>
                    <a:gd name="connsiteX31" fmla="*/ 68842 w 558286"/>
                    <a:gd name="connsiteY31" fmla="*/ 188737 h 359548"/>
                    <a:gd name="connsiteX32" fmla="*/ 81542 w 558286"/>
                    <a:gd name="connsiteY32" fmla="*/ 125237 h 359548"/>
                    <a:gd name="connsiteX0" fmla="*/ 81542 w 558286"/>
                    <a:gd name="connsiteY0" fmla="*/ 125237 h 358073"/>
                    <a:gd name="connsiteX1" fmla="*/ 116467 w 558286"/>
                    <a:gd name="connsiteY1" fmla="*/ 249062 h 358073"/>
                    <a:gd name="connsiteX2" fmla="*/ 427617 w 558286"/>
                    <a:gd name="connsiteY2" fmla="*/ 357012 h 358073"/>
                    <a:gd name="connsiteX3" fmla="*/ 421267 w 558286"/>
                    <a:gd name="connsiteY3" fmla="*/ 303037 h 358073"/>
                    <a:gd name="connsiteX4" fmla="*/ 335542 w 558286"/>
                    <a:gd name="connsiteY4" fmla="*/ 283987 h 358073"/>
                    <a:gd name="connsiteX5" fmla="*/ 294267 w 558286"/>
                    <a:gd name="connsiteY5" fmla="*/ 258587 h 358073"/>
                    <a:gd name="connsiteX6" fmla="*/ 313317 w 558286"/>
                    <a:gd name="connsiteY6" fmla="*/ 236362 h 358073"/>
                    <a:gd name="connsiteX7" fmla="*/ 453017 w 558286"/>
                    <a:gd name="connsiteY7" fmla="*/ 274462 h 358073"/>
                    <a:gd name="connsiteX8" fmla="*/ 497467 w 558286"/>
                    <a:gd name="connsiteY8" fmla="*/ 268112 h 358073"/>
                    <a:gd name="connsiteX9" fmla="*/ 484767 w 558286"/>
                    <a:gd name="connsiteY9" fmla="*/ 242712 h 358073"/>
                    <a:gd name="connsiteX10" fmla="*/ 402217 w 558286"/>
                    <a:gd name="connsiteY10" fmla="*/ 210962 h 358073"/>
                    <a:gd name="connsiteX11" fmla="*/ 316492 w 558286"/>
                    <a:gd name="connsiteY11" fmla="*/ 191912 h 358073"/>
                    <a:gd name="connsiteX12" fmla="*/ 386342 w 558286"/>
                    <a:gd name="connsiteY12" fmla="*/ 182387 h 358073"/>
                    <a:gd name="connsiteX13" fmla="*/ 519692 w 558286"/>
                    <a:gd name="connsiteY13" fmla="*/ 220487 h 358073"/>
                    <a:gd name="connsiteX14" fmla="*/ 557792 w 558286"/>
                    <a:gd name="connsiteY14" fmla="*/ 220487 h 358073"/>
                    <a:gd name="connsiteX15" fmla="*/ 529217 w 558286"/>
                    <a:gd name="connsiteY15" fmla="*/ 179212 h 358073"/>
                    <a:gd name="connsiteX16" fmla="*/ 379992 w 558286"/>
                    <a:gd name="connsiteY16" fmla="*/ 134762 h 358073"/>
                    <a:gd name="connsiteX17" fmla="*/ 335542 w 558286"/>
                    <a:gd name="connsiteY17" fmla="*/ 103012 h 358073"/>
                    <a:gd name="connsiteX18" fmla="*/ 427617 w 558286"/>
                    <a:gd name="connsiteY18" fmla="*/ 122062 h 358073"/>
                    <a:gd name="connsiteX19" fmla="*/ 503817 w 558286"/>
                    <a:gd name="connsiteY19" fmla="*/ 150637 h 358073"/>
                    <a:gd name="connsiteX20" fmla="*/ 510167 w 558286"/>
                    <a:gd name="connsiteY20" fmla="*/ 109362 h 358073"/>
                    <a:gd name="connsiteX21" fmla="*/ 411742 w 558286"/>
                    <a:gd name="connsiteY21" fmla="*/ 52212 h 358073"/>
                    <a:gd name="connsiteX22" fmla="*/ 322842 w 558286"/>
                    <a:gd name="connsiteY22" fmla="*/ 23637 h 358073"/>
                    <a:gd name="connsiteX23" fmla="*/ 243467 w 558286"/>
                    <a:gd name="connsiteY23" fmla="*/ 64912 h 358073"/>
                    <a:gd name="connsiteX24" fmla="*/ 205367 w 558286"/>
                    <a:gd name="connsiteY24" fmla="*/ 144287 h 358073"/>
                    <a:gd name="connsiteX25" fmla="*/ 249817 w 558286"/>
                    <a:gd name="connsiteY25" fmla="*/ 55387 h 358073"/>
                    <a:gd name="connsiteX26" fmla="*/ 214892 w 558286"/>
                    <a:gd name="connsiteY26" fmla="*/ 1412 h 358073"/>
                    <a:gd name="connsiteX27" fmla="*/ 97417 w 558286"/>
                    <a:gd name="connsiteY27" fmla="*/ 23637 h 358073"/>
                    <a:gd name="connsiteX28" fmla="*/ 27567 w 558286"/>
                    <a:gd name="connsiteY28" fmla="*/ 106187 h 358073"/>
                    <a:gd name="connsiteX29" fmla="*/ 2167 w 558286"/>
                    <a:gd name="connsiteY29" fmla="*/ 220487 h 358073"/>
                    <a:gd name="connsiteX30" fmla="*/ 78367 w 558286"/>
                    <a:gd name="connsiteY30" fmla="*/ 242712 h 358073"/>
                    <a:gd name="connsiteX31" fmla="*/ 68842 w 558286"/>
                    <a:gd name="connsiteY31" fmla="*/ 188737 h 358073"/>
                    <a:gd name="connsiteX32" fmla="*/ 81542 w 558286"/>
                    <a:gd name="connsiteY32" fmla="*/ 125237 h 358073"/>
                    <a:gd name="connsiteX0" fmla="*/ 81542 w 558286"/>
                    <a:gd name="connsiteY0" fmla="*/ 125237 h 333294"/>
                    <a:gd name="connsiteX1" fmla="*/ 116467 w 558286"/>
                    <a:gd name="connsiteY1" fmla="*/ 249062 h 333294"/>
                    <a:gd name="connsiteX2" fmla="*/ 395867 w 558286"/>
                    <a:gd name="connsiteY2" fmla="*/ 331612 h 333294"/>
                    <a:gd name="connsiteX3" fmla="*/ 421267 w 558286"/>
                    <a:gd name="connsiteY3" fmla="*/ 303037 h 333294"/>
                    <a:gd name="connsiteX4" fmla="*/ 335542 w 558286"/>
                    <a:gd name="connsiteY4" fmla="*/ 283987 h 333294"/>
                    <a:gd name="connsiteX5" fmla="*/ 294267 w 558286"/>
                    <a:gd name="connsiteY5" fmla="*/ 258587 h 333294"/>
                    <a:gd name="connsiteX6" fmla="*/ 313317 w 558286"/>
                    <a:gd name="connsiteY6" fmla="*/ 236362 h 333294"/>
                    <a:gd name="connsiteX7" fmla="*/ 453017 w 558286"/>
                    <a:gd name="connsiteY7" fmla="*/ 274462 h 333294"/>
                    <a:gd name="connsiteX8" fmla="*/ 497467 w 558286"/>
                    <a:gd name="connsiteY8" fmla="*/ 268112 h 333294"/>
                    <a:gd name="connsiteX9" fmla="*/ 484767 w 558286"/>
                    <a:gd name="connsiteY9" fmla="*/ 242712 h 333294"/>
                    <a:gd name="connsiteX10" fmla="*/ 402217 w 558286"/>
                    <a:gd name="connsiteY10" fmla="*/ 210962 h 333294"/>
                    <a:gd name="connsiteX11" fmla="*/ 316492 w 558286"/>
                    <a:gd name="connsiteY11" fmla="*/ 191912 h 333294"/>
                    <a:gd name="connsiteX12" fmla="*/ 386342 w 558286"/>
                    <a:gd name="connsiteY12" fmla="*/ 182387 h 333294"/>
                    <a:gd name="connsiteX13" fmla="*/ 519692 w 558286"/>
                    <a:gd name="connsiteY13" fmla="*/ 220487 h 333294"/>
                    <a:gd name="connsiteX14" fmla="*/ 557792 w 558286"/>
                    <a:gd name="connsiteY14" fmla="*/ 220487 h 333294"/>
                    <a:gd name="connsiteX15" fmla="*/ 529217 w 558286"/>
                    <a:gd name="connsiteY15" fmla="*/ 179212 h 333294"/>
                    <a:gd name="connsiteX16" fmla="*/ 379992 w 558286"/>
                    <a:gd name="connsiteY16" fmla="*/ 134762 h 333294"/>
                    <a:gd name="connsiteX17" fmla="*/ 335542 w 558286"/>
                    <a:gd name="connsiteY17" fmla="*/ 103012 h 333294"/>
                    <a:gd name="connsiteX18" fmla="*/ 427617 w 558286"/>
                    <a:gd name="connsiteY18" fmla="*/ 122062 h 333294"/>
                    <a:gd name="connsiteX19" fmla="*/ 503817 w 558286"/>
                    <a:gd name="connsiteY19" fmla="*/ 150637 h 333294"/>
                    <a:gd name="connsiteX20" fmla="*/ 510167 w 558286"/>
                    <a:gd name="connsiteY20" fmla="*/ 109362 h 333294"/>
                    <a:gd name="connsiteX21" fmla="*/ 411742 w 558286"/>
                    <a:gd name="connsiteY21" fmla="*/ 52212 h 333294"/>
                    <a:gd name="connsiteX22" fmla="*/ 322842 w 558286"/>
                    <a:gd name="connsiteY22" fmla="*/ 23637 h 333294"/>
                    <a:gd name="connsiteX23" fmla="*/ 243467 w 558286"/>
                    <a:gd name="connsiteY23" fmla="*/ 64912 h 333294"/>
                    <a:gd name="connsiteX24" fmla="*/ 205367 w 558286"/>
                    <a:gd name="connsiteY24" fmla="*/ 144287 h 333294"/>
                    <a:gd name="connsiteX25" fmla="*/ 249817 w 558286"/>
                    <a:gd name="connsiteY25" fmla="*/ 55387 h 333294"/>
                    <a:gd name="connsiteX26" fmla="*/ 214892 w 558286"/>
                    <a:gd name="connsiteY26" fmla="*/ 1412 h 333294"/>
                    <a:gd name="connsiteX27" fmla="*/ 97417 w 558286"/>
                    <a:gd name="connsiteY27" fmla="*/ 23637 h 333294"/>
                    <a:gd name="connsiteX28" fmla="*/ 27567 w 558286"/>
                    <a:gd name="connsiteY28" fmla="*/ 106187 h 333294"/>
                    <a:gd name="connsiteX29" fmla="*/ 2167 w 558286"/>
                    <a:gd name="connsiteY29" fmla="*/ 220487 h 333294"/>
                    <a:gd name="connsiteX30" fmla="*/ 78367 w 558286"/>
                    <a:gd name="connsiteY30" fmla="*/ 242712 h 333294"/>
                    <a:gd name="connsiteX31" fmla="*/ 68842 w 558286"/>
                    <a:gd name="connsiteY31" fmla="*/ 188737 h 333294"/>
                    <a:gd name="connsiteX32" fmla="*/ 81542 w 558286"/>
                    <a:gd name="connsiteY32" fmla="*/ 125237 h 333294"/>
                    <a:gd name="connsiteX0" fmla="*/ 81542 w 558286"/>
                    <a:gd name="connsiteY0" fmla="*/ 125237 h 333472"/>
                    <a:gd name="connsiteX1" fmla="*/ 116467 w 558286"/>
                    <a:gd name="connsiteY1" fmla="*/ 249062 h 333472"/>
                    <a:gd name="connsiteX2" fmla="*/ 395867 w 558286"/>
                    <a:gd name="connsiteY2" fmla="*/ 331612 h 333472"/>
                    <a:gd name="connsiteX3" fmla="*/ 421267 w 558286"/>
                    <a:gd name="connsiteY3" fmla="*/ 303037 h 333472"/>
                    <a:gd name="connsiteX4" fmla="*/ 348242 w 558286"/>
                    <a:gd name="connsiteY4" fmla="*/ 261762 h 333472"/>
                    <a:gd name="connsiteX5" fmla="*/ 294267 w 558286"/>
                    <a:gd name="connsiteY5" fmla="*/ 258587 h 333472"/>
                    <a:gd name="connsiteX6" fmla="*/ 313317 w 558286"/>
                    <a:gd name="connsiteY6" fmla="*/ 236362 h 333472"/>
                    <a:gd name="connsiteX7" fmla="*/ 453017 w 558286"/>
                    <a:gd name="connsiteY7" fmla="*/ 274462 h 333472"/>
                    <a:gd name="connsiteX8" fmla="*/ 497467 w 558286"/>
                    <a:gd name="connsiteY8" fmla="*/ 268112 h 333472"/>
                    <a:gd name="connsiteX9" fmla="*/ 484767 w 558286"/>
                    <a:gd name="connsiteY9" fmla="*/ 242712 h 333472"/>
                    <a:gd name="connsiteX10" fmla="*/ 402217 w 558286"/>
                    <a:gd name="connsiteY10" fmla="*/ 210962 h 333472"/>
                    <a:gd name="connsiteX11" fmla="*/ 316492 w 558286"/>
                    <a:gd name="connsiteY11" fmla="*/ 191912 h 333472"/>
                    <a:gd name="connsiteX12" fmla="*/ 386342 w 558286"/>
                    <a:gd name="connsiteY12" fmla="*/ 182387 h 333472"/>
                    <a:gd name="connsiteX13" fmla="*/ 519692 w 558286"/>
                    <a:gd name="connsiteY13" fmla="*/ 220487 h 333472"/>
                    <a:gd name="connsiteX14" fmla="*/ 557792 w 558286"/>
                    <a:gd name="connsiteY14" fmla="*/ 220487 h 333472"/>
                    <a:gd name="connsiteX15" fmla="*/ 529217 w 558286"/>
                    <a:gd name="connsiteY15" fmla="*/ 179212 h 333472"/>
                    <a:gd name="connsiteX16" fmla="*/ 379992 w 558286"/>
                    <a:gd name="connsiteY16" fmla="*/ 134762 h 333472"/>
                    <a:gd name="connsiteX17" fmla="*/ 335542 w 558286"/>
                    <a:gd name="connsiteY17" fmla="*/ 103012 h 333472"/>
                    <a:gd name="connsiteX18" fmla="*/ 427617 w 558286"/>
                    <a:gd name="connsiteY18" fmla="*/ 122062 h 333472"/>
                    <a:gd name="connsiteX19" fmla="*/ 503817 w 558286"/>
                    <a:gd name="connsiteY19" fmla="*/ 150637 h 333472"/>
                    <a:gd name="connsiteX20" fmla="*/ 510167 w 558286"/>
                    <a:gd name="connsiteY20" fmla="*/ 109362 h 333472"/>
                    <a:gd name="connsiteX21" fmla="*/ 411742 w 558286"/>
                    <a:gd name="connsiteY21" fmla="*/ 52212 h 333472"/>
                    <a:gd name="connsiteX22" fmla="*/ 322842 w 558286"/>
                    <a:gd name="connsiteY22" fmla="*/ 23637 h 333472"/>
                    <a:gd name="connsiteX23" fmla="*/ 243467 w 558286"/>
                    <a:gd name="connsiteY23" fmla="*/ 64912 h 333472"/>
                    <a:gd name="connsiteX24" fmla="*/ 205367 w 558286"/>
                    <a:gd name="connsiteY24" fmla="*/ 144287 h 333472"/>
                    <a:gd name="connsiteX25" fmla="*/ 249817 w 558286"/>
                    <a:gd name="connsiteY25" fmla="*/ 55387 h 333472"/>
                    <a:gd name="connsiteX26" fmla="*/ 214892 w 558286"/>
                    <a:gd name="connsiteY26" fmla="*/ 1412 h 333472"/>
                    <a:gd name="connsiteX27" fmla="*/ 97417 w 558286"/>
                    <a:gd name="connsiteY27" fmla="*/ 23637 h 333472"/>
                    <a:gd name="connsiteX28" fmla="*/ 27567 w 558286"/>
                    <a:gd name="connsiteY28" fmla="*/ 106187 h 333472"/>
                    <a:gd name="connsiteX29" fmla="*/ 2167 w 558286"/>
                    <a:gd name="connsiteY29" fmla="*/ 220487 h 333472"/>
                    <a:gd name="connsiteX30" fmla="*/ 78367 w 558286"/>
                    <a:gd name="connsiteY30" fmla="*/ 242712 h 333472"/>
                    <a:gd name="connsiteX31" fmla="*/ 68842 w 558286"/>
                    <a:gd name="connsiteY31" fmla="*/ 188737 h 333472"/>
                    <a:gd name="connsiteX32" fmla="*/ 81542 w 558286"/>
                    <a:gd name="connsiteY32" fmla="*/ 125237 h 33347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</a:cxnLst>
                  <a:rect l="l" t="t" r="r" b="b"/>
                  <a:pathLst>
                    <a:path w="558286" h="333472">
                      <a:moveTo>
                        <a:pt x="81542" y="125237"/>
                      </a:moveTo>
                      <a:cubicBezTo>
                        <a:pt x="89479" y="135291"/>
                        <a:pt x="64080" y="214666"/>
                        <a:pt x="116467" y="249062"/>
                      </a:cubicBezTo>
                      <a:cubicBezTo>
                        <a:pt x="168854" y="283458"/>
                        <a:pt x="345067" y="322616"/>
                        <a:pt x="395867" y="331612"/>
                      </a:cubicBezTo>
                      <a:cubicBezTo>
                        <a:pt x="446667" y="340608"/>
                        <a:pt x="429205" y="314679"/>
                        <a:pt x="421267" y="303037"/>
                      </a:cubicBezTo>
                      <a:cubicBezTo>
                        <a:pt x="413330" y="291395"/>
                        <a:pt x="369409" y="269170"/>
                        <a:pt x="348242" y="261762"/>
                      </a:cubicBezTo>
                      <a:cubicBezTo>
                        <a:pt x="327075" y="254354"/>
                        <a:pt x="300088" y="262820"/>
                        <a:pt x="294267" y="258587"/>
                      </a:cubicBezTo>
                      <a:cubicBezTo>
                        <a:pt x="288446" y="254354"/>
                        <a:pt x="286859" y="233716"/>
                        <a:pt x="313317" y="236362"/>
                      </a:cubicBezTo>
                      <a:cubicBezTo>
                        <a:pt x="339775" y="239008"/>
                        <a:pt x="422325" y="269170"/>
                        <a:pt x="453017" y="274462"/>
                      </a:cubicBezTo>
                      <a:cubicBezTo>
                        <a:pt x="483709" y="279754"/>
                        <a:pt x="492175" y="273404"/>
                        <a:pt x="497467" y="268112"/>
                      </a:cubicBezTo>
                      <a:cubicBezTo>
                        <a:pt x="502759" y="262820"/>
                        <a:pt x="500642" y="252237"/>
                        <a:pt x="484767" y="242712"/>
                      </a:cubicBezTo>
                      <a:cubicBezTo>
                        <a:pt x="468892" y="233187"/>
                        <a:pt x="430263" y="219429"/>
                        <a:pt x="402217" y="210962"/>
                      </a:cubicBezTo>
                      <a:cubicBezTo>
                        <a:pt x="374171" y="202495"/>
                        <a:pt x="319138" y="196674"/>
                        <a:pt x="316492" y="191912"/>
                      </a:cubicBezTo>
                      <a:cubicBezTo>
                        <a:pt x="313846" y="187150"/>
                        <a:pt x="352475" y="177625"/>
                        <a:pt x="386342" y="182387"/>
                      </a:cubicBezTo>
                      <a:cubicBezTo>
                        <a:pt x="420209" y="187149"/>
                        <a:pt x="491117" y="214137"/>
                        <a:pt x="519692" y="220487"/>
                      </a:cubicBezTo>
                      <a:cubicBezTo>
                        <a:pt x="548267" y="226837"/>
                        <a:pt x="556205" y="227366"/>
                        <a:pt x="557792" y="220487"/>
                      </a:cubicBezTo>
                      <a:cubicBezTo>
                        <a:pt x="559379" y="213608"/>
                        <a:pt x="558850" y="193500"/>
                        <a:pt x="529217" y="179212"/>
                      </a:cubicBezTo>
                      <a:cubicBezTo>
                        <a:pt x="499584" y="164924"/>
                        <a:pt x="412271" y="147462"/>
                        <a:pt x="379992" y="134762"/>
                      </a:cubicBezTo>
                      <a:cubicBezTo>
                        <a:pt x="347713" y="122062"/>
                        <a:pt x="327605" y="105129"/>
                        <a:pt x="335542" y="103012"/>
                      </a:cubicBezTo>
                      <a:cubicBezTo>
                        <a:pt x="343479" y="100895"/>
                        <a:pt x="399571" y="114124"/>
                        <a:pt x="427617" y="122062"/>
                      </a:cubicBezTo>
                      <a:cubicBezTo>
                        <a:pt x="455663" y="130000"/>
                        <a:pt x="490059" y="152754"/>
                        <a:pt x="503817" y="150637"/>
                      </a:cubicBezTo>
                      <a:cubicBezTo>
                        <a:pt x="517575" y="148520"/>
                        <a:pt x="525513" y="125766"/>
                        <a:pt x="510167" y="109362"/>
                      </a:cubicBezTo>
                      <a:cubicBezTo>
                        <a:pt x="494821" y="92958"/>
                        <a:pt x="442963" y="66499"/>
                        <a:pt x="411742" y="52212"/>
                      </a:cubicBezTo>
                      <a:cubicBezTo>
                        <a:pt x="380521" y="37924"/>
                        <a:pt x="350888" y="21520"/>
                        <a:pt x="322842" y="23637"/>
                      </a:cubicBezTo>
                      <a:cubicBezTo>
                        <a:pt x="294796" y="25754"/>
                        <a:pt x="263046" y="44804"/>
                        <a:pt x="243467" y="64912"/>
                      </a:cubicBezTo>
                      <a:cubicBezTo>
                        <a:pt x="223888" y="85020"/>
                        <a:pt x="204309" y="145875"/>
                        <a:pt x="205367" y="144287"/>
                      </a:cubicBezTo>
                      <a:cubicBezTo>
                        <a:pt x="206425" y="142699"/>
                        <a:pt x="248229" y="79200"/>
                        <a:pt x="249817" y="55387"/>
                      </a:cubicBezTo>
                      <a:cubicBezTo>
                        <a:pt x="251405" y="31574"/>
                        <a:pt x="240292" y="6704"/>
                        <a:pt x="214892" y="1412"/>
                      </a:cubicBezTo>
                      <a:cubicBezTo>
                        <a:pt x="189492" y="-3880"/>
                        <a:pt x="128638" y="6175"/>
                        <a:pt x="97417" y="23637"/>
                      </a:cubicBezTo>
                      <a:cubicBezTo>
                        <a:pt x="66196" y="41099"/>
                        <a:pt x="43442" y="73379"/>
                        <a:pt x="27567" y="106187"/>
                      </a:cubicBezTo>
                      <a:cubicBezTo>
                        <a:pt x="11692" y="138995"/>
                        <a:pt x="-6300" y="197733"/>
                        <a:pt x="2167" y="220487"/>
                      </a:cubicBezTo>
                      <a:cubicBezTo>
                        <a:pt x="10634" y="243241"/>
                        <a:pt x="67254" y="248004"/>
                        <a:pt x="78367" y="242712"/>
                      </a:cubicBezTo>
                      <a:cubicBezTo>
                        <a:pt x="89480" y="237420"/>
                        <a:pt x="69900" y="205141"/>
                        <a:pt x="68842" y="188737"/>
                      </a:cubicBezTo>
                      <a:cubicBezTo>
                        <a:pt x="67784" y="172333"/>
                        <a:pt x="73605" y="115183"/>
                        <a:pt x="81542" y="125237"/>
                      </a:cubicBezTo>
                      <a:close/>
                    </a:path>
                  </a:pathLst>
                </a:custGeom>
                <a:solidFill>
                  <a:schemeClr val="bg1">
                    <a:lumMod val="8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NL" sz="700"/>
                </a:p>
              </p:txBody>
            </p:sp>
          </p:grp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B6DF6E3F-6604-4F6E-9F96-6663CC6823B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411527" y="1964737"/>
                <a:ext cx="78606" cy="336243"/>
              </a:xfrm>
              <a:prstGeom prst="line">
                <a:avLst/>
              </a:prstGeom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172C7B81-7C30-CF5D-8DA9-325A52C268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90133" y="1967170"/>
                <a:ext cx="98508" cy="2885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F5AD898D-E61E-0213-DFAC-BB81F33481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81129" y="2017807"/>
                <a:ext cx="98508" cy="2885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" name="Rounded Rectangle 100">
              <a:extLst>
                <a:ext uri="{FF2B5EF4-FFF2-40B4-BE49-F238E27FC236}">
                  <a16:creationId xmlns:a16="http://schemas.microsoft.com/office/drawing/2014/main" id="{C9AE1BFC-3491-BE8B-130E-69558229D9BC}"/>
                </a:ext>
              </a:extLst>
            </p:cNvPr>
            <p:cNvSpPr/>
            <p:nvPr/>
          </p:nvSpPr>
          <p:spPr>
            <a:xfrm rot="17303525">
              <a:off x="2329520" y="2640530"/>
              <a:ext cx="117475" cy="45719"/>
            </a:xfrm>
            <a:prstGeom prst="round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L"/>
            </a:p>
          </p:txBody>
        </p:sp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8407AFC7-E158-0367-3F2F-013AC6639149}"/>
              </a:ext>
            </a:extLst>
          </p:cNvPr>
          <p:cNvGrpSpPr/>
          <p:nvPr/>
        </p:nvGrpSpPr>
        <p:grpSpPr>
          <a:xfrm>
            <a:off x="4997072" y="2173527"/>
            <a:ext cx="2197856" cy="2250447"/>
            <a:chOff x="12486381" y="2067734"/>
            <a:chExt cx="2660422" cy="2724081"/>
          </a:xfrm>
        </p:grpSpPr>
        <p:sp>
          <p:nvSpPr>
            <p:cNvPr id="61" name="Rounded Rectangle 7">
              <a:extLst>
                <a:ext uri="{FF2B5EF4-FFF2-40B4-BE49-F238E27FC236}">
                  <a16:creationId xmlns:a16="http://schemas.microsoft.com/office/drawing/2014/main" id="{CBCFA986-6A19-F1D4-36A3-45A6D1A33C0B}"/>
                </a:ext>
              </a:extLst>
            </p:cNvPr>
            <p:cNvSpPr/>
            <p:nvPr/>
          </p:nvSpPr>
          <p:spPr>
            <a:xfrm>
              <a:off x="12486381" y="2067734"/>
              <a:ext cx="2660422" cy="2720112"/>
            </a:xfrm>
            <a:prstGeom prst="round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L"/>
            </a:p>
          </p:txBody>
        </p:sp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FB53BE8F-52EB-0FD3-5BBA-AECB24ABA47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486381" y="2071703"/>
              <a:ext cx="2660422" cy="2720112"/>
            </a:xfrm>
            <a:prstGeom prst="rect">
              <a:avLst/>
            </a:prstGeom>
            <a:effectLst>
              <a:softEdge rad="276284"/>
            </a:effectLst>
          </p:spPr>
        </p:pic>
      </p:grpSp>
      <p:pic>
        <p:nvPicPr>
          <p:cNvPr id="63" name="Picture 62">
            <a:extLst>
              <a:ext uri="{FF2B5EF4-FFF2-40B4-BE49-F238E27FC236}">
                <a16:creationId xmlns:a16="http://schemas.microsoft.com/office/drawing/2014/main" id="{5A11D6CE-92E4-A79F-4C1E-373E63A5C2F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48952" y="2168460"/>
            <a:ext cx="2255987" cy="22346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1556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</TotalTime>
  <Words>91</Words>
  <Application>Microsoft Office PowerPoint</Application>
  <PresentationFormat>Widescreen</PresentationFormat>
  <Paragraphs>4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3D Immersive Virtual Reality-Based Clip Sizing for Thoracoscopic Left Atrial Appendage Closur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t Kiesel</dc:creator>
  <cp:lastModifiedBy>Sari D. Holmes, PhD</cp:lastModifiedBy>
  <cp:revision>16</cp:revision>
  <dcterms:created xsi:type="dcterms:W3CDTF">2019-04-26T22:59:25Z</dcterms:created>
  <dcterms:modified xsi:type="dcterms:W3CDTF">2022-07-01T20:27:57Z</dcterms:modified>
</cp:coreProperties>
</file>